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  <p:sldId id="260" r:id="rId3"/>
    <p:sldId id="257" r:id="rId4"/>
    <p:sldId id="259" r:id="rId5"/>
    <p:sldId id="258" r:id="rId6"/>
    <p:sldId id="266" r:id="rId7"/>
    <p:sldId id="256" r:id="rId8"/>
    <p:sldId id="262" r:id="rId9"/>
    <p:sldId id="261" r:id="rId10"/>
    <p:sldId id="265" r:id="rId11"/>
    <p:sldId id="263" r:id="rId12"/>
    <p:sldId id="269" r:id="rId13"/>
    <p:sldId id="271" r:id="rId14"/>
    <p:sldId id="268" r:id="rId15"/>
    <p:sldId id="274" r:id="rId16"/>
    <p:sldId id="272" r:id="rId17"/>
    <p:sldId id="273" r:id="rId18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26EEE"/>
    <a:srgbClr val="EE957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359"/>
    <p:restoredTop sz="95903"/>
  </p:normalViewPr>
  <p:slideViewPr>
    <p:cSldViewPr snapToGrid="0">
      <p:cViewPr varScale="1">
        <p:scale>
          <a:sx n="76" d="100"/>
          <a:sy n="76" d="100"/>
        </p:scale>
        <p:origin x="200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946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648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322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137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5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298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163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523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010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668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476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8CA7D-5735-DD42-9A11-A3C2146BCFF5}" type="datetimeFigureOut">
              <a:rPr lang="en-US" smtClean="0"/>
              <a:t>6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6A95D-3DF0-9C47-8197-8909E5FB9E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449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jpeg"/><Relationship Id="rId3" Type="http://schemas.openxmlformats.org/officeDocument/2006/relationships/image" Target="../media/image60.emf"/><Relationship Id="rId7" Type="http://schemas.openxmlformats.org/officeDocument/2006/relationships/image" Target="../media/image64.jpeg"/><Relationship Id="rId2" Type="http://schemas.openxmlformats.org/officeDocument/2006/relationships/image" Target="../media/image5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3.jpeg"/><Relationship Id="rId5" Type="http://schemas.openxmlformats.org/officeDocument/2006/relationships/image" Target="../media/image62.jpeg"/><Relationship Id="rId4" Type="http://schemas.openxmlformats.org/officeDocument/2006/relationships/image" Target="../media/image61.em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2.jpeg"/><Relationship Id="rId3" Type="http://schemas.openxmlformats.org/officeDocument/2006/relationships/image" Target="../media/image67.emf"/><Relationship Id="rId7" Type="http://schemas.openxmlformats.org/officeDocument/2006/relationships/image" Target="../media/image71.jpeg"/><Relationship Id="rId2" Type="http://schemas.openxmlformats.org/officeDocument/2006/relationships/image" Target="../media/image6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0.jpeg"/><Relationship Id="rId11" Type="http://schemas.openxmlformats.org/officeDocument/2006/relationships/image" Target="../media/image75.jpeg"/><Relationship Id="rId5" Type="http://schemas.openxmlformats.org/officeDocument/2006/relationships/image" Target="../media/image69.jpeg"/><Relationship Id="rId10" Type="http://schemas.openxmlformats.org/officeDocument/2006/relationships/image" Target="../media/image74.jpeg"/><Relationship Id="rId4" Type="http://schemas.openxmlformats.org/officeDocument/2006/relationships/image" Target="../media/image68.jpeg"/><Relationship Id="rId9" Type="http://schemas.openxmlformats.org/officeDocument/2006/relationships/image" Target="../media/image73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emf"/><Relationship Id="rId2" Type="http://schemas.openxmlformats.org/officeDocument/2006/relationships/image" Target="../media/image7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9.emf"/><Relationship Id="rId4" Type="http://schemas.openxmlformats.org/officeDocument/2006/relationships/image" Target="../media/image78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emf"/><Relationship Id="rId2" Type="http://schemas.openxmlformats.org/officeDocument/2006/relationships/image" Target="../media/image80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3.jpeg"/><Relationship Id="rId4" Type="http://schemas.openxmlformats.org/officeDocument/2006/relationships/image" Target="../media/image82.jpe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emf"/><Relationship Id="rId2" Type="http://schemas.openxmlformats.org/officeDocument/2006/relationships/image" Target="../media/image84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12" Type="http://schemas.openxmlformats.org/officeDocument/2006/relationships/image" Target="../media/image13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11" Type="http://schemas.openxmlformats.org/officeDocument/2006/relationships/image" Target="../media/image12.emf"/><Relationship Id="rId5" Type="http://schemas.openxmlformats.org/officeDocument/2006/relationships/image" Target="../media/image6.emf"/><Relationship Id="rId10" Type="http://schemas.openxmlformats.org/officeDocument/2006/relationships/image" Target="../media/image11.emf"/><Relationship Id="rId4" Type="http://schemas.openxmlformats.org/officeDocument/2006/relationships/image" Target="../media/image5.emf"/><Relationship Id="rId9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emf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12" Type="http://schemas.openxmlformats.org/officeDocument/2006/relationships/image" Target="../media/image30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emf"/><Relationship Id="rId11" Type="http://schemas.openxmlformats.org/officeDocument/2006/relationships/image" Target="../media/image29.emf"/><Relationship Id="rId5" Type="http://schemas.openxmlformats.org/officeDocument/2006/relationships/image" Target="../media/image23.emf"/><Relationship Id="rId10" Type="http://schemas.openxmlformats.org/officeDocument/2006/relationships/image" Target="../media/image28.emf"/><Relationship Id="rId4" Type="http://schemas.openxmlformats.org/officeDocument/2006/relationships/image" Target="../media/image22.emf"/><Relationship Id="rId9" Type="http://schemas.openxmlformats.org/officeDocument/2006/relationships/image" Target="../media/image2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emf"/><Relationship Id="rId3" Type="http://schemas.openxmlformats.org/officeDocument/2006/relationships/image" Target="../media/image32.emf"/><Relationship Id="rId7" Type="http://schemas.openxmlformats.org/officeDocument/2006/relationships/image" Target="../media/image36.emf"/><Relationship Id="rId12" Type="http://schemas.openxmlformats.org/officeDocument/2006/relationships/image" Target="../media/image41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emf"/><Relationship Id="rId11" Type="http://schemas.openxmlformats.org/officeDocument/2006/relationships/image" Target="../media/image40.emf"/><Relationship Id="rId5" Type="http://schemas.openxmlformats.org/officeDocument/2006/relationships/image" Target="../media/image34.emf"/><Relationship Id="rId10" Type="http://schemas.openxmlformats.org/officeDocument/2006/relationships/image" Target="../media/image39.emf"/><Relationship Id="rId4" Type="http://schemas.openxmlformats.org/officeDocument/2006/relationships/image" Target="../media/image33.emf"/><Relationship Id="rId9" Type="http://schemas.openxmlformats.org/officeDocument/2006/relationships/image" Target="../media/image38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emf"/><Relationship Id="rId7" Type="http://schemas.openxmlformats.org/officeDocument/2006/relationships/image" Target="../media/image47.emf"/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emf"/><Relationship Id="rId5" Type="http://schemas.openxmlformats.org/officeDocument/2006/relationships/image" Target="../media/image45.emf"/><Relationship Id="rId4" Type="http://schemas.openxmlformats.org/officeDocument/2006/relationships/image" Target="../media/image44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emf"/><Relationship Id="rId3" Type="http://schemas.openxmlformats.org/officeDocument/2006/relationships/image" Target="../media/image49.emf"/><Relationship Id="rId7" Type="http://schemas.openxmlformats.org/officeDocument/2006/relationships/image" Target="../media/image53.emf"/><Relationship Id="rId12" Type="http://schemas.openxmlformats.org/officeDocument/2006/relationships/image" Target="../media/image58.emf"/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emf"/><Relationship Id="rId11" Type="http://schemas.openxmlformats.org/officeDocument/2006/relationships/image" Target="../media/image57.emf"/><Relationship Id="rId5" Type="http://schemas.openxmlformats.org/officeDocument/2006/relationships/image" Target="../media/image51.emf"/><Relationship Id="rId10" Type="http://schemas.openxmlformats.org/officeDocument/2006/relationships/image" Target="../media/image56.emf"/><Relationship Id="rId4" Type="http://schemas.openxmlformats.org/officeDocument/2006/relationships/image" Target="../media/image50.emf"/><Relationship Id="rId9" Type="http://schemas.openxmlformats.org/officeDocument/2006/relationships/image" Target="../media/image5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7DF7C8A4-E38B-4F8F-F685-169D9B25E978}"/>
              </a:ext>
            </a:extLst>
          </p:cNvPr>
          <p:cNvSpPr txBox="1"/>
          <p:nvPr/>
        </p:nvSpPr>
        <p:spPr>
          <a:xfrm>
            <a:off x="302079" y="9535178"/>
            <a:ext cx="716824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et up of the field experiment with 220 Indica and Japonica rice accessions and their source environments.</a:t>
            </a:r>
          </a:p>
        </p:txBody>
      </p:sp>
      <p:pic>
        <p:nvPicPr>
          <p:cNvPr id="3" name="Picture 2" descr="A map of the world&#10;&#10;Description automatically generated">
            <a:extLst>
              <a:ext uri="{FF2B5EF4-FFF2-40B4-BE49-F238E27FC236}">
                <a16:creationId xmlns:a16="http://schemas.microsoft.com/office/drawing/2014/main" id="{28D508BF-1BB8-B0BF-9197-298FAF1472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6469" y="5679472"/>
            <a:ext cx="5046402" cy="3834733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13E181C4-42ED-915A-C239-D54389AF4907}"/>
              </a:ext>
            </a:extLst>
          </p:cNvPr>
          <p:cNvGrpSpPr/>
          <p:nvPr/>
        </p:nvGrpSpPr>
        <p:grpSpPr>
          <a:xfrm>
            <a:off x="302079" y="3792125"/>
            <a:ext cx="7168241" cy="717898"/>
            <a:chOff x="-6485" y="2639679"/>
            <a:chExt cx="9022870" cy="909155"/>
          </a:xfrm>
        </p:grpSpPr>
        <p:sp>
          <p:nvSpPr>
            <p:cNvPr id="4" name="Oval 3">
              <a:extLst>
                <a:ext uri="{FF2B5EF4-FFF2-40B4-BE49-F238E27FC236}">
                  <a16:creationId xmlns:a16="http://schemas.microsoft.com/office/drawing/2014/main" id="{42661B24-9375-A09C-B931-178CAA4B19F4}"/>
                </a:ext>
              </a:extLst>
            </p:cNvPr>
            <p:cNvSpPr/>
            <p:nvPr/>
          </p:nvSpPr>
          <p:spPr>
            <a:xfrm>
              <a:off x="-6485" y="2639679"/>
              <a:ext cx="902287" cy="902423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Oval 4">
              <a:extLst>
                <a:ext uri="{FF2B5EF4-FFF2-40B4-BE49-F238E27FC236}">
                  <a16:creationId xmlns:a16="http://schemas.microsoft.com/office/drawing/2014/main" id="{6CB5C379-3816-A64B-16A0-7FFD24F83376}"/>
                </a:ext>
              </a:extLst>
            </p:cNvPr>
            <p:cNvSpPr/>
            <p:nvPr/>
          </p:nvSpPr>
          <p:spPr>
            <a:xfrm>
              <a:off x="895802" y="2639679"/>
              <a:ext cx="902287" cy="902423"/>
            </a:xfrm>
            <a:prstGeom prst="ellipse">
              <a:avLst/>
            </a:prstGeom>
            <a:solidFill>
              <a:srgbClr val="EE9572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" name="Oval 5">
              <a:extLst>
                <a:ext uri="{FF2B5EF4-FFF2-40B4-BE49-F238E27FC236}">
                  <a16:creationId xmlns:a16="http://schemas.microsoft.com/office/drawing/2014/main" id="{E632F0FD-CB45-02B1-E1FB-3D076AC306FD}"/>
                </a:ext>
              </a:extLst>
            </p:cNvPr>
            <p:cNvSpPr/>
            <p:nvPr/>
          </p:nvSpPr>
          <p:spPr>
            <a:xfrm>
              <a:off x="1798089" y="2646411"/>
              <a:ext cx="902287" cy="902423"/>
            </a:xfrm>
            <a:prstGeom prst="ellipse">
              <a:avLst/>
            </a:prstGeom>
            <a:solidFill>
              <a:srgbClr val="000000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464F6D54-716E-B2B0-6E87-0F53C74499CE}"/>
                </a:ext>
              </a:extLst>
            </p:cNvPr>
            <p:cNvSpPr/>
            <p:nvPr/>
          </p:nvSpPr>
          <p:spPr>
            <a:xfrm>
              <a:off x="3602662" y="2639679"/>
              <a:ext cx="902287" cy="902423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671C8E94-DB14-91DF-4EB6-AC31856E07D3}"/>
                </a:ext>
              </a:extLst>
            </p:cNvPr>
            <p:cNvSpPr/>
            <p:nvPr/>
          </p:nvSpPr>
          <p:spPr>
            <a:xfrm>
              <a:off x="2700376" y="2639679"/>
              <a:ext cx="902287" cy="902423"/>
            </a:xfrm>
            <a:prstGeom prst="ellipse">
              <a:avLst/>
            </a:prstGeom>
            <a:solidFill>
              <a:srgbClr val="426EEE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4F81BD"/>
                </a:solidFill>
              </a:endParaRPr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AD6CC71B-D603-5BF5-D42F-DA4A6F9C3B41}"/>
                </a:ext>
              </a:extLst>
            </p:cNvPr>
            <p:cNvSpPr/>
            <p:nvPr/>
          </p:nvSpPr>
          <p:spPr>
            <a:xfrm>
              <a:off x="4504950" y="2639679"/>
              <a:ext cx="902287" cy="902423"/>
            </a:xfrm>
            <a:prstGeom prst="ellipse">
              <a:avLst/>
            </a:prstGeom>
            <a:solidFill>
              <a:srgbClr val="426EEE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4272139F-BC9C-60BC-3116-38C8E50628DF}"/>
                </a:ext>
              </a:extLst>
            </p:cNvPr>
            <p:cNvSpPr/>
            <p:nvPr/>
          </p:nvSpPr>
          <p:spPr>
            <a:xfrm>
              <a:off x="5407237" y="2639679"/>
              <a:ext cx="902287" cy="902423"/>
            </a:xfrm>
            <a:prstGeom prst="ellipse">
              <a:avLst/>
            </a:prstGeom>
            <a:solidFill>
              <a:srgbClr val="426EEE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4786B9E5-99BE-C4C3-1EC1-B3AAB1399AB0}"/>
                </a:ext>
              </a:extLst>
            </p:cNvPr>
            <p:cNvSpPr/>
            <p:nvPr/>
          </p:nvSpPr>
          <p:spPr>
            <a:xfrm>
              <a:off x="6309524" y="2639679"/>
              <a:ext cx="902287" cy="902423"/>
            </a:xfrm>
            <a:prstGeom prst="ellipse">
              <a:avLst/>
            </a:prstGeom>
            <a:solidFill>
              <a:srgbClr val="426EEE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4D2F01CF-4B74-4C85-884F-1094F29BE8D7}"/>
                </a:ext>
              </a:extLst>
            </p:cNvPr>
            <p:cNvSpPr/>
            <p:nvPr/>
          </p:nvSpPr>
          <p:spPr>
            <a:xfrm>
              <a:off x="7211811" y="2639679"/>
              <a:ext cx="902287" cy="902423"/>
            </a:xfrm>
            <a:prstGeom prst="ellipse">
              <a:avLst/>
            </a:prstGeom>
            <a:solidFill>
              <a:srgbClr val="426EEE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0DD5A01D-81F3-97F5-17CC-190FDFF6CDF1}"/>
                </a:ext>
              </a:extLst>
            </p:cNvPr>
            <p:cNvSpPr/>
            <p:nvPr/>
          </p:nvSpPr>
          <p:spPr>
            <a:xfrm>
              <a:off x="8114098" y="2640423"/>
              <a:ext cx="902287" cy="902423"/>
            </a:xfrm>
            <a:prstGeom prst="ellipse">
              <a:avLst/>
            </a:prstGeom>
            <a:solidFill>
              <a:srgbClr val="000000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" name="Oval 13">
            <a:extLst>
              <a:ext uri="{FF2B5EF4-FFF2-40B4-BE49-F238E27FC236}">
                <a16:creationId xmlns:a16="http://schemas.microsoft.com/office/drawing/2014/main" id="{A45DA6E9-0644-02B3-B3C2-841D3C1FA016}"/>
              </a:ext>
            </a:extLst>
          </p:cNvPr>
          <p:cNvSpPr/>
          <p:nvPr/>
        </p:nvSpPr>
        <p:spPr>
          <a:xfrm>
            <a:off x="435188" y="4623863"/>
            <a:ext cx="461369" cy="452462"/>
          </a:xfrm>
          <a:prstGeom prst="ellipse">
            <a:avLst/>
          </a:prstGeom>
          <a:solidFill>
            <a:srgbClr val="EE9572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2FB5F3C8-5F0A-FF2D-ABD8-D04DB433642F}"/>
              </a:ext>
            </a:extLst>
          </p:cNvPr>
          <p:cNvSpPr/>
          <p:nvPr/>
        </p:nvSpPr>
        <p:spPr>
          <a:xfrm>
            <a:off x="435188" y="5140592"/>
            <a:ext cx="461369" cy="452462"/>
          </a:xfrm>
          <a:prstGeom prst="ellipse">
            <a:avLst/>
          </a:prstGeom>
          <a:solidFill>
            <a:srgbClr val="426EEE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256BC618-482D-27CA-4B9F-2741AF30B56A}"/>
              </a:ext>
            </a:extLst>
          </p:cNvPr>
          <p:cNvSpPr/>
          <p:nvPr/>
        </p:nvSpPr>
        <p:spPr>
          <a:xfrm>
            <a:off x="4381836" y="5142581"/>
            <a:ext cx="461369" cy="45246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7B0915C0-B446-04EA-96A6-8AE139579406}"/>
              </a:ext>
            </a:extLst>
          </p:cNvPr>
          <p:cNvSpPr/>
          <p:nvPr/>
        </p:nvSpPr>
        <p:spPr>
          <a:xfrm>
            <a:off x="4381836" y="4623863"/>
            <a:ext cx="461369" cy="452462"/>
          </a:xfrm>
          <a:prstGeom prst="ellipse">
            <a:avLst/>
          </a:prstGeom>
          <a:solidFill>
            <a:srgbClr val="426EEE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6FD7CF1-6029-24DA-F41F-A25D4201D112}"/>
              </a:ext>
            </a:extLst>
          </p:cNvPr>
          <p:cNvSpPr txBox="1"/>
          <p:nvPr/>
        </p:nvSpPr>
        <p:spPr>
          <a:xfrm>
            <a:off x="1061170" y="4712133"/>
            <a:ext cx="21932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Unrelated measurement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C787B16-F0EA-6598-8CAF-482B509B6058}"/>
              </a:ext>
            </a:extLst>
          </p:cNvPr>
          <p:cNvSpPr txBox="1"/>
          <p:nvPr/>
        </p:nvSpPr>
        <p:spPr>
          <a:xfrm>
            <a:off x="1061785" y="5177993"/>
            <a:ext cx="2781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/>
                <a:cs typeface="Arial"/>
              </a:rPr>
              <a:t>RNAseq</a:t>
            </a:r>
            <a:r>
              <a:rPr lang="en-US" sz="1400" dirty="0">
                <a:latin typeface="Arial"/>
                <a:cs typeface="Arial"/>
              </a:rPr>
              <a:t> and trait measurement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AF3C7FC-68E9-E512-ECA3-4968AA02724E}"/>
              </a:ext>
            </a:extLst>
          </p:cNvPr>
          <p:cNvSpPr txBox="1"/>
          <p:nvPr/>
        </p:nvSpPr>
        <p:spPr>
          <a:xfrm>
            <a:off x="4985320" y="4709054"/>
            <a:ext cx="17681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Trait measurement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0601ED9-782E-5970-23C6-C22D8CA04717}"/>
              </a:ext>
            </a:extLst>
          </p:cNvPr>
          <p:cNvSpPr txBox="1"/>
          <p:nvPr/>
        </p:nvSpPr>
        <p:spPr>
          <a:xfrm>
            <a:off x="4989587" y="5212934"/>
            <a:ext cx="1159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Border plan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E5C38F6-6DEF-60D4-6D85-58225DFC1EE0}"/>
              </a:ext>
            </a:extLst>
          </p:cNvPr>
          <p:cNvSpPr txBox="1"/>
          <p:nvPr/>
        </p:nvSpPr>
        <p:spPr>
          <a:xfrm>
            <a:off x="2594298" y="3817599"/>
            <a:ext cx="36080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400" b="1" dirty="0">
                <a:latin typeface="Arial"/>
                <a:cs typeface="Arial"/>
              </a:rPr>
              <a:t>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43CD620-09AC-D5B3-C4F5-5CAD2AB3E035}"/>
              </a:ext>
            </a:extLst>
          </p:cNvPr>
          <p:cNvSpPr txBox="1"/>
          <p:nvPr/>
        </p:nvSpPr>
        <p:spPr>
          <a:xfrm>
            <a:off x="504772" y="5145416"/>
            <a:ext cx="344365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/>
                <a:cs typeface="Arial"/>
              </a:rPr>
              <a:t>*</a:t>
            </a:r>
          </a:p>
        </p:txBody>
      </p:sp>
      <p:pic>
        <p:nvPicPr>
          <p:cNvPr id="24" name="Content Placeholder 5" descr="IRRI Exp Google Earth.png">
            <a:extLst>
              <a:ext uri="{FF2B5EF4-FFF2-40B4-BE49-F238E27FC236}">
                <a16:creationId xmlns:a16="http://schemas.microsoft.com/office/drawing/2014/main" id="{FC770CCD-5CB6-4184-2F08-61D8C43F3FA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" r="234"/>
          <a:stretch/>
        </p:blipFill>
        <p:spPr>
          <a:xfrm>
            <a:off x="1563525" y="76748"/>
            <a:ext cx="5009346" cy="3514184"/>
          </a:xfrm>
          <a:prstGeom prst="rect">
            <a:avLst/>
          </a:prstGeom>
        </p:spPr>
      </p:pic>
      <p:sp>
        <p:nvSpPr>
          <p:cNvPr id="26" name="Left Brace 25">
            <a:extLst>
              <a:ext uri="{FF2B5EF4-FFF2-40B4-BE49-F238E27FC236}">
                <a16:creationId xmlns:a16="http://schemas.microsoft.com/office/drawing/2014/main" id="{9536C523-9ECE-1AFE-7038-C1B334F818A1}"/>
              </a:ext>
            </a:extLst>
          </p:cNvPr>
          <p:cNvSpPr/>
          <p:nvPr/>
        </p:nvSpPr>
        <p:spPr>
          <a:xfrm rot="5400000">
            <a:off x="3767116" y="139723"/>
            <a:ext cx="238164" cy="7168243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0C1D1ACF-6166-3421-2D42-3B4F4B078672}"/>
              </a:ext>
            </a:extLst>
          </p:cNvPr>
          <p:cNvCxnSpPr>
            <a:cxnSpLocks/>
            <a:stCxn id="26" idx="1"/>
          </p:cNvCxnSpPr>
          <p:nvPr/>
        </p:nvCxnSpPr>
        <p:spPr>
          <a:xfrm flipH="1" flipV="1">
            <a:off x="3527787" y="1586843"/>
            <a:ext cx="358411" cy="201792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6041C2C6-3895-0D75-7301-E3080F4A3CC1}"/>
              </a:ext>
            </a:extLst>
          </p:cNvPr>
          <p:cNvCxnSpPr>
            <a:cxnSpLocks/>
          </p:cNvCxnSpPr>
          <p:nvPr/>
        </p:nvCxnSpPr>
        <p:spPr>
          <a:xfrm flipV="1">
            <a:off x="3886199" y="2821008"/>
            <a:ext cx="1683034" cy="78375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5C707381-7398-24C8-ACDA-CD0A7A53FBF9}"/>
              </a:ext>
            </a:extLst>
          </p:cNvPr>
          <p:cNvSpPr txBox="1"/>
          <p:nvPr/>
        </p:nvSpPr>
        <p:spPr>
          <a:xfrm>
            <a:off x="2048924" y="938234"/>
            <a:ext cx="87870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Wet field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114D2B7-7F28-B5AC-367C-5B804A84F44C}"/>
              </a:ext>
            </a:extLst>
          </p:cNvPr>
          <p:cNvSpPr txBox="1"/>
          <p:nvPr/>
        </p:nvSpPr>
        <p:spPr>
          <a:xfrm>
            <a:off x="5421257" y="2110008"/>
            <a:ext cx="84189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Dry field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85FACFF-6D26-07EB-6C3B-9E78DE9E6D32}"/>
              </a:ext>
            </a:extLst>
          </p:cNvPr>
          <p:cNvSpPr txBox="1"/>
          <p:nvPr/>
        </p:nvSpPr>
        <p:spPr>
          <a:xfrm>
            <a:off x="0" y="7674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6BF3026-8642-9AF4-443F-10632325FB3E}"/>
              </a:ext>
            </a:extLst>
          </p:cNvPr>
          <p:cNvSpPr txBox="1"/>
          <p:nvPr/>
        </p:nvSpPr>
        <p:spPr>
          <a:xfrm>
            <a:off x="0" y="567947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12D4FE5-876C-DC4C-E6AA-30D30CB8B720}"/>
              </a:ext>
            </a:extLst>
          </p:cNvPr>
          <p:cNvSpPr txBox="1"/>
          <p:nvPr/>
        </p:nvSpPr>
        <p:spPr>
          <a:xfrm>
            <a:off x="407480" y="3291669"/>
            <a:ext cx="97815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Field plot</a:t>
            </a:r>
          </a:p>
        </p:txBody>
      </p:sp>
    </p:spTree>
    <p:extLst>
      <p:ext uri="{BB962C8B-B14F-4D97-AF65-F5344CB8AC3E}">
        <p14:creationId xmlns:p14="http://schemas.microsoft.com/office/powerpoint/2010/main" val="13082222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A3632A7-C72C-8E31-C421-278A0920F266}"/>
              </a:ext>
            </a:extLst>
          </p:cNvPr>
          <p:cNvSpPr txBox="1"/>
          <p:nvPr/>
        </p:nvSpPr>
        <p:spPr>
          <a:xfrm>
            <a:off x="293912" y="861688"/>
            <a:ext cx="716824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3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election gradients (𝛽) for trait means and canalization in the Indica population.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7E72810-B0FE-965F-138A-1A651C719F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2974548"/>
              </p:ext>
            </p:extLst>
          </p:nvPr>
        </p:nvGraphicFramePr>
        <p:xfrm>
          <a:off x="410365" y="1680458"/>
          <a:ext cx="6935333" cy="579949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41357">
                  <a:extLst>
                    <a:ext uri="{9D8B030D-6E8A-4147-A177-3AD203B41FA5}">
                      <a16:colId xmlns:a16="http://schemas.microsoft.com/office/drawing/2014/main" val="1013442135"/>
                    </a:ext>
                  </a:extLst>
                </a:gridCol>
                <a:gridCol w="591995">
                  <a:extLst>
                    <a:ext uri="{9D8B030D-6E8A-4147-A177-3AD203B41FA5}">
                      <a16:colId xmlns:a16="http://schemas.microsoft.com/office/drawing/2014/main" val="1553854499"/>
                    </a:ext>
                  </a:extLst>
                </a:gridCol>
                <a:gridCol w="766676">
                  <a:extLst>
                    <a:ext uri="{9D8B030D-6E8A-4147-A177-3AD203B41FA5}">
                      <a16:colId xmlns:a16="http://schemas.microsoft.com/office/drawing/2014/main" val="255012030"/>
                    </a:ext>
                  </a:extLst>
                </a:gridCol>
                <a:gridCol w="766676">
                  <a:extLst>
                    <a:ext uri="{9D8B030D-6E8A-4147-A177-3AD203B41FA5}">
                      <a16:colId xmlns:a16="http://schemas.microsoft.com/office/drawing/2014/main" val="1001497600"/>
                    </a:ext>
                  </a:extLst>
                </a:gridCol>
                <a:gridCol w="895267">
                  <a:extLst>
                    <a:ext uri="{9D8B030D-6E8A-4147-A177-3AD203B41FA5}">
                      <a16:colId xmlns:a16="http://schemas.microsoft.com/office/drawing/2014/main" val="1622581737"/>
                    </a:ext>
                  </a:extLst>
                </a:gridCol>
                <a:gridCol w="673334">
                  <a:extLst>
                    <a:ext uri="{9D8B030D-6E8A-4147-A177-3AD203B41FA5}">
                      <a16:colId xmlns:a16="http://schemas.microsoft.com/office/drawing/2014/main" val="136096135"/>
                    </a:ext>
                  </a:extLst>
                </a:gridCol>
                <a:gridCol w="766676">
                  <a:extLst>
                    <a:ext uri="{9D8B030D-6E8A-4147-A177-3AD203B41FA5}">
                      <a16:colId xmlns:a16="http://schemas.microsoft.com/office/drawing/2014/main" val="2357930538"/>
                    </a:ext>
                  </a:extLst>
                </a:gridCol>
                <a:gridCol w="766676">
                  <a:extLst>
                    <a:ext uri="{9D8B030D-6E8A-4147-A177-3AD203B41FA5}">
                      <a16:colId xmlns:a16="http://schemas.microsoft.com/office/drawing/2014/main" val="3639384423"/>
                    </a:ext>
                  </a:extLst>
                </a:gridCol>
                <a:gridCol w="766676">
                  <a:extLst>
                    <a:ext uri="{9D8B030D-6E8A-4147-A177-3AD203B41FA5}">
                      <a16:colId xmlns:a16="http://schemas.microsoft.com/office/drawing/2014/main" val="836171289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 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ctr"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solidFill>
                            <a:srgbClr val="426EEE"/>
                          </a:solidFill>
                          <a:effectLst/>
                        </a:rPr>
                        <a:t>Wet</a:t>
                      </a:r>
                      <a:endParaRPr lang="en-US" sz="1400" b="1" i="0" u="none" strike="noStrike" dirty="0">
                        <a:solidFill>
                          <a:srgbClr val="426EEE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ctr"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solidFill>
                            <a:srgbClr val="EE9572"/>
                          </a:solidFill>
                          <a:effectLst/>
                        </a:rPr>
                        <a:t>Dry</a:t>
                      </a:r>
                      <a:endParaRPr lang="en-US" sz="1400" b="1" i="0" u="none" strike="noStrike" dirty="0">
                        <a:solidFill>
                          <a:srgbClr val="EE9572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ctr"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3267616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Estimate</a:t>
                      </a:r>
                      <a:endParaRPr lang="en-US" sz="1100" b="0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Std Error</a:t>
                      </a:r>
                      <a:endParaRPr lang="en-US" sz="1100" b="0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t value</a:t>
                      </a:r>
                      <a:endParaRPr lang="en-US" sz="1100" b="0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 value</a:t>
                      </a:r>
                      <a:endParaRPr lang="en-US" sz="1100" b="0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Estimate</a:t>
                      </a:r>
                      <a:endParaRPr lang="en-US" sz="1100" b="0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Std Error</a:t>
                      </a:r>
                      <a:endParaRPr lang="en-US" sz="1100" b="0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t value</a:t>
                      </a:r>
                      <a:endParaRPr lang="en-US" sz="1100" b="0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 value</a:t>
                      </a:r>
                      <a:endParaRPr lang="en-US" sz="1100" b="0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71407615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alization</a:t>
                      </a: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1649109268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HG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05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5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878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-0.444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06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-7.356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1.00E-1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3069314804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B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2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56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4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2.13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35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1929781741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B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77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8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3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82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07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632848607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N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3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3.61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049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22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3.01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33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1987023183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DP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26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63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2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66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50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3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241373524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N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0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1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05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6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994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2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4279693276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HG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4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1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7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7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21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26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3728224994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RD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6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2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2.36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20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3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78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409516409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D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9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2.88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49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25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667820179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P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30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47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4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2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730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427703098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TN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6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9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18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3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1548847819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it Means</a:t>
                      </a: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492521025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HG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37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3.60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0518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70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694499230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B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5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27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205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27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3.91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017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631366750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B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167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328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32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4.4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0026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4055181680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N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5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47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4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2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636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3317818298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DP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5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21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2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62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4.17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2.22E-1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3669783827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N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39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.38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2.22E-1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43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.76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</a:rPr>
                        <a:t>1.30E-09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3399617240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HG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71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035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7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8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433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253657219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RD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8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2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.93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2.22E-1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8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51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</a:rPr>
                        <a:t>0.0135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165419895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D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7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034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065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00021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376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5.49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3.63E-0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303498239"/>
                  </a:ext>
                </a:extLst>
              </a:tr>
              <a:tr h="2343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P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324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5.49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2.22E-1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6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667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041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1041565982"/>
                  </a:ext>
                </a:extLst>
              </a:tr>
              <a:tr h="21663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TN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2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.966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5.00E-1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-0.004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9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5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954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6337875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3256AC8-282A-B974-C05F-7116656B1D74}"/>
              </a:ext>
            </a:extLst>
          </p:cNvPr>
          <p:cNvSpPr txBox="1"/>
          <p:nvPr/>
        </p:nvSpPr>
        <p:spPr>
          <a:xfrm>
            <a:off x="410365" y="7608578"/>
            <a:ext cx="5643062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</a:rPr>
              <a:t>Canalization as estimated through calculating </a:t>
            </a:r>
            <a:r>
              <a:rPr lang="en-US" sz="1400" dirty="0" err="1">
                <a:solidFill>
                  <a:srgbClr val="000000"/>
                </a:solidFill>
              </a:rPr>
              <a:t>Levene’s</a:t>
            </a:r>
            <a:r>
              <a:rPr lang="en-US" sz="1400" dirty="0">
                <a:solidFill>
                  <a:srgbClr val="000000"/>
                </a:solidFill>
              </a:rPr>
              <a:t> Statistic (LS). The p-values of s</a:t>
            </a:r>
            <a:r>
              <a:rPr lang="en-US" sz="1400" u="none" strike="noStrike" dirty="0">
                <a:solidFill>
                  <a:srgbClr val="000000"/>
                </a:solidFill>
                <a:effectLst/>
              </a:rPr>
              <a:t>ignificant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𝛽</a:t>
            </a:r>
            <a:r>
              <a:rPr lang="en-US" sz="1400" u="none" strike="noStrike" dirty="0">
                <a:solidFill>
                  <a:srgbClr val="000000"/>
                </a:solidFill>
                <a:effectLst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ues are</a:t>
            </a:r>
            <a:r>
              <a:rPr lang="en-US" sz="1400" dirty="0">
                <a:solidFill>
                  <a:srgbClr val="000000"/>
                </a:solidFill>
              </a:rPr>
              <a:t> bolded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8882598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66AB1D7-8E94-3988-8225-EF54E3580A22}"/>
              </a:ext>
            </a:extLst>
          </p:cNvPr>
          <p:cNvSpPr txBox="1"/>
          <p:nvPr/>
        </p:nvSpPr>
        <p:spPr>
          <a:xfrm>
            <a:off x="293912" y="861688"/>
            <a:ext cx="716824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4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election gradients (𝛽) for trait means and canalization in the Japonica population.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A72CACA-EFE5-C337-1EBD-B925EAC367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4960813"/>
              </p:ext>
            </p:extLst>
          </p:nvPr>
        </p:nvGraphicFramePr>
        <p:xfrm>
          <a:off x="526820" y="1565386"/>
          <a:ext cx="6576715" cy="477050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877910">
                  <a:extLst>
                    <a:ext uri="{9D8B030D-6E8A-4147-A177-3AD203B41FA5}">
                      <a16:colId xmlns:a16="http://schemas.microsoft.com/office/drawing/2014/main" val="2645147187"/>
                    </a:ext>
                  </a:extLst>
                </a:gridCol>
                <a:gridCol w="576154">
                  <a:extLst>
                    <a:ext uri="{9D8B030D-6E8A-4147-A177-3AD203B41FA5}">
                      <a16:colId xmlns:a16="http://schemas.microsoft.com/office/drawing/2014/main" val="297367587"/>
                    </a:ext>
                  </a:extLst>
                </a:gridCol>
                <a:gridCol w="727032">
                  <a:extLst>
                    <a:ext uri="{9D8B030D-6E8A-4147-A177-3AD203B41FA5}">
                      <a16:colId xmlns:a16="http://schemas.microsoft.com/office/drawing/2014/main" val="1834334043"/>
                    </a:ext>
                  </a:extLst>
                </a:gridCol>
                <a:gridCol w="727032">
                  <a:extLst>
                    <a:ext uri="{9D8B030D-6E8A-4147-A177-3AD203B41FA5}">
                      <a16:colId xmlns:a16="http://schemas.microsoft.com/office/drawing/2014/main" val="417212980"/>
                    </a:ext>
                  </a:extLst>
                </a:gridCol>
                <a:gridCol w="760459">
                  <a:extLst>
                    <a:ext uri="{9D8B030D-6E8A-4147-A177-3AD203B41FA5}">
                      <a16:colId xmlns:a16="http://schemas.microsoft.com/office/drawing/2014/main" val="1772048415"/>
                    </a:ext>
                  </a:extLst>
                </a:gridCol>
                <a:gridCol w="727032">
                  <a:extLst>
                    <a:ext uri="{9D8B030D-6E8A-4147-A177-3AD203B41FA5}">
                      <a16:colId xmlns:a16="http://schemas.microsoft.com/office/drawing/2014/main" val="2114259859"/>
                    </a:ext>
                  </a:extLst>
                </a:gridCol>
                <a:gridCol w="727032">
                  <a:extLst>
                    <a:ext uri="{9D8B030D-6E8A-4147-A177-3AD203B41FA5}">
                      <a16:colId xmlns:a16="http://schemas.microsoft.com/office/drawing/2014/main" val="3021526330"/>
                    </a:ext>
                  </a:extLst>
                </a:gridCol>
                <a:gridCol w="727032">
                  <a:extLst>
                    <a:ext uri="{9D8B030D-6E8A-4147-A177-3AD203B41FA5}">
                      <a16:colId xmlns:a16="http://schemas.microsoft.com/office/drawing/2014/main" val="1863142796"/>
                    </a:ext>
                  </a:extLst>
                </a:gridCol>
                <a:gridCol w="727032">
                  <a:extLst>
                    <a:ext uri="{9D8B030D-6E8A-4147-A177-3AD203B41FA5}">
                      <a16:colId xmlns:a16="http://schemas.microsoft.com/office/drawing/2014/main" val="2614855651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ctr"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rgbClr val="426EEE"/>
                          </a:solidFill>
                          <a:effectLst/>
                        </a:rPr>
                        <a:t>Wet</a:t>
                      </a:r>
                      <a:endParaRPr lang="en-US" sz="1200" b="1" i="0" u="none" strike="noStrike" dirty="0">
                        <a:solidFill>
                          <a:srgbClr val="426EEE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ctr"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rgbClr val="EE9572"/>
                          </a:solidFill>
                          <a:effectLst/>
                        </a:rPr>
                        <a:t>Dry</a:t>
                      </a:r>
                      <a:endParaRPr lang="en-US" sz="1200" b="1" i="0" u="none" strike="noStrike" dirty="0">
                        <a:solidFill>
                          <a:srgbClr val="EE9572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ctr"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063766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Estimate</a:t>
                      </a:r>
                      <a:endParaRPr lang="en-US" sz="1100" b="1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Std Error</a:t>
                      </a:r>
                      <a:endParaRPr lang="en-US" sz="1100" b="1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t value</a:t>
                      </a:r>
                      <a:endParaRPr lang="en-US" sz="1100" b="1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 value</a:t>
                      </a:r>
                      <a:endParaRPr lang="en-US" sz="1100" b="1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Estimate</a:t>
                      </a:r>
                      <a:endParaRPr lang="en-US" sz="1100" b="1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sng" strike="noStrike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Std Error</a:t>
                      </a:r>
                      <a:endParaRPr lang="en-US" sz="1100" b="1" i="0" u="sng" strike="noStrike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t value</a:t>
                      </a:r>
                      <a:endParaRPr lang="en-US" sz="1100" b="1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sng" strike="noStrike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effectLst/>
                        </a:rPr>
                        <a:t>p value</a:t>
                      </a:r>
                      <a:endParaRPr lang="en-US" sz="1100" b="1" i="0" u="sng" strike="noStrike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962672281"/>
                  </a:ext>
                </a:extLst>
              </a:tr>
              <a:tr h="149358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alizati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3896091013"/>
                  </a:ext>
                </a:extLst>
              </a:tr>
              <a:tr h="1493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HG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7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0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-0.99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26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-0.341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09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-3.543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00090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1218180523"/>
                  </a:ext>
                </a:extLst>
              </a:tr>
              <a:tr h="1493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B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8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07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287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4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-1.419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162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166856730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B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6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79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43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21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2.15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36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430209306"/>
                  </a:ext>
                </a:extLst>
              </a:tr>
              <a:tr h="1493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N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-0.135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54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2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5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52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9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763860692"/>
                  </a:ext>
                </a:extLst>
              </a:tr>
              <a:tr h="1493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DP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9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88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7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17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6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7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921083034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N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1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4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6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9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45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47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674306713"/>
                  </a:ext>
                </a:extLst>
              </a:tr>
              <a:tr h="1493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HG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1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4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8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053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1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45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5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3915726394"/>
                  </a:ext>
                </a:extLst>
              </a:tr>
              <a:tr h="1493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RD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8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5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54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29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984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3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426253899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D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0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66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3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0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1442176595"/>
                  </a:ext>
                </a:extLst>
              </a:tr>
              <a:tr h="1493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P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5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2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-2.024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48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057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45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3350294995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TN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4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53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9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5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9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1007552784"/>
                  </a:ext>
                </a:extLst>
              </a:tr>
              <a:tr h="1493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it Means</a:t>
                      </a: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326571052"/>
                  </a:ext>
                </a:extLst>
              </a:tr>
              <a:tr h="14935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HG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42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0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5.94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3.25E-0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6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26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1607684060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B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9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61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07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8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817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283243703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B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8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41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13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8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05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738606590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N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3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70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9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3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-0.277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8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462171584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DPM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5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49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4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37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-3.618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072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1174380895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N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6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7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5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0033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7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9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7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9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12093639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HG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7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4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27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</a:rPr>
                        <a:t>0.00197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0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1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87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8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1385393775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RD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0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5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19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2.22E-1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66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6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99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3474986509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DW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47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.79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5.00E-1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7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63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0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698455020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P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0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2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3.52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2.22E-1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8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9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89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/>
                </a:tc>
                <a:extLst>
                  <a:ext uri="{0D108BD9-81ED-4DB2-BD59-A6C34878D82A}">
                    <a16:rowId xmlns:a16="http://schemas.microsoft.com/office/drawing/2014/main" val="2465627087"/>
                  </a:ext>
                </a:extLst>
              </a:tr>
              <a:tr h="130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TN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59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0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4.489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</a:rPr>
                        <a:t>0.000046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R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085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L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10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81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418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01" marR="7001" marT="7001" marB="0" anchor="b"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2066206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5AB4D88-50B1-7711-1D51-3FDF1DB68505}"/>
              </a:ext>
            </a:extLst>
          </p:cNvPr>
          <p:cNvSpPr txBox="1"/>
          <p:nvPr/>
        </p:nvSpPr>
        <p:spPr>
          <a:xfrm>
            <a:off x="526820" y="6398512"/>
            <a:ext cx="566956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</a:rPr>
              <a:t>Canalization as estimated through calculating </a:t>
            </a:r>
            <a:r>
              <a:rPr lang="en-US" sz="1400" dirty="0" err="1">
                <a:solidFill>
                  <a:srgbClr val="000000"/>
                </a:solidFill>
              </a:rPr>
              <a:t>Levene’s</a:t>
            </a:r>
            <a:r>
              <a:rPr lang="en-US" sz="1400" dirty="0">
                <a:solidFill>
                  <a:srgbClr val="000000"/>
                </a:solidFill>
              </a:rPr>
              <a:t> Statistic (LS). The p-values of s</a:t>
            </a:r>
            <a:r>
              <a:rPr lang="en-US" sz="1400" u="none" strike="noStrike" dirty="0">
                <a:solidFill>
                  <a:srgbClr val="000000"/>
                </a:solidFill>
                <a:effectLst/>
              </a:rPr>
              <a:t>ignificant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𝛽</a:t>
            </a:r>
            <a:r>
              <a:rPr lang="en-US" sz="1400" u="none" strike="noStrike" dirty="0">
                <a:solidFill>
                  <a:srgbClr val="000000"/>
                </a:solidFill>
                <a:effectLst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ues are</a:t>
            </a:r>
            <a:r>
              <a:rPr lang="en-US" sz="1400" dirty="0">
                <a:solidFill>
                  <a:srgbClr val="000000"/>
                </a:solidFill>
              </a:rPr>
              <a:t> bolded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73480470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6C44FE99-B53D-C5D5-D5D5-AE98CF65134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4207"/>
          <a:stretch/>
        </p:blipFill>
        <p:spPr>
          <a:xfrm>
            <a:off x="606541" y="1117527"/>
            <a:ext cx="2135865" cy="245520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212924D-1C1B-1F5C-0327-E6ABB9B523D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4445"/>
          <a:stretch/>
        </p:blipFill>
        <p:spPr>
          <a:xfrm>
            <a:off x="5102335" y="1114337"/>
            <a:ext cx="2141179" cy="245520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2934B07-5A93-DD82-A344-43A4FEE4470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4207"/>
          <a:stretch/>
        </p:blipFill>
        <p:spPr>
          <a:xfrm>
            <a:off x="2864377" y="1117527"/>
            <a:ext cx="2135866" cy="2455206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3243D48D-67DD-A6B3-C3E8-295781767BC1}"/>
              </a:ext>
            </a:extLst>
          </p:cNvPr>
          <p:cNvSpPr txBox="1"/>
          <p:nvPr/>
        </p:nvSpPr>
        <p:spPr>
          <a:xfrm>
            <a:off x="701875" y="7486943"/>
            <a:ext cx="640403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8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productive-stage traits quantified for wild-typ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ipponbar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ga5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mutant plants exposed to a 3-month period of intermittent drought or a well-watered control environment.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CD5CF2E8-0095-32CC-7B4E-7D8BA636E232}"/>
              </a:ext>
            </a:extLst>
          </p:cNvPr>
          <p:cNvGrpSpPr/>
          <p:nvPr/>
        </p:nvGrpSpPr>
        <p:grpSpPr>
          <a:xfrm>
            <a:off x="369733" y="810068"/>
            <a:ext cx="6611948" cy="6654288"/>
            <a:chOff x="369733" y="810068"/>
            <a:chExt cx="6611948" cy="6654288"/>
          </a:xfrm>
        </p:grpSpPr>
        <p:pic>
          <p:nvPicPr>
            <p:cNvPr id="19" name="Picture 18" descr="A plant in a pot&#10;&#10;Description automatically generated">
              <a:extLst>
                <a:ext uri="{FF2B5EF4-FFF2-40B4-BE49-F238E27FC236}">
                  <a16:creationId xmlns:a16="http://schemas.microsoft.com/office/drawing/2014/main" id="{37B9F98C-ADDF-ECB6-76D6-5913FE183A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2007" t="3393" r="8097" b="-115"/>
            <a:stretch/>
          </p:blipFill>
          <p:spPr>
            <a:xfrm>
              <a:off x="2365138" y="4681542"/>
              <a:ext cx="1495544" cy="2414016"/>
            </a:xfrm>
            <a:prstGeom prst="rect">
              <a:avLst/>
            </a:prstGeom>
            <a:ln w="38100">
              <a:solidFill>
                <a:srgbClr val="EF9572"/>
              </a:solidFill>
            </a:ln>
          </p:spPr>
        </p:pic>
        <p:pic>
          <p:nvPicPr>
            <p:cNvPr id="21" name="Picture 20" descr="A plant in a pot&#10;&#10;Description automatically generated">
              <a:extLst>
                <a:ext uri="{FF2B5EF4-FFF2-40B4-BE49-F238E27FC236}">
                  <a16:creationId xmlns:a16="http://schemas.microsoft.com/office/drawing/2014/main" id="{2C6729EF-E99F-E471-99D2-E8B8124C4F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4961" t="3413" r="10991" b="3344"/>
            <a:stretch/>
          </p:blipFill>
          <p:spPr>
            <a:xfrm>
              <a:off x="725777" y="4687927"/>
              <a:ext cx="1437815" cy="2414016"/>
            </a:xfrm>
            <a:prstGeom prst="rect">
              <a:avLst/>
            </a:prstGeom>
            <a:ln w="38100">
              <a:solidFill>
                <a:srgbClr val="5178EE"/>
              </a:solidFill>
            </a:ln>
          </p:spPr>
        </p:pic>
        <p:pic>
          <p:nvPicPr>
            <p:cNvPr id="27" name="Picture 26" descr="A plant in a pot&#10;&#10;Description automatically generated">
              <a:extLst>
                <a:ext uri="{FF2B5EF4-FFF2-40B4-BE49-F238E27FC236}">
                  <a16:creationId xmlns:a16="http://schemas.microsoft.com/office/drawing/2014/main" id="{C32916AA-79D7-24F4-ABE3-2EE9E0D3D2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1386" r="6313" b="600"/>
            <a:stretch/>
          </p:blipFill>
          <p:spPr>
            <a:xfrm>
              <a:off x="4060301" y="4681542"/>
              <a:ext cx="1496028" cy="2409086"/>
            </a:xfrm>
            <a:prstGeom prst="rect">
              <a:avLst/>
            </a:prstGeom>
            <a:ln w="38100">
              <a:solidFill>
                <a:srgbClr val="5178EE"/>
              </a:solidFill>
            </a:ln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2864F69-51F5-D9BC-3F50-7882975A30F4}"/>
                </a:ext>
              </a:extLst>
            </p:cNvPr>
            <p:cNvSpPr txBox="1"/>
            <p:nvPr/>
          </p:nvSpPr>
          <p:spPr>
            <a:xfrm>
              <a:off x="369733" y="81006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1B7FBBA-65C7-CDE6-7D00-B4F7F9187D2B}"/>
                </a:ext>
              </a:extLst>
            </p:cNvPr>
            <p:cNvSpPr txBox="1"/>
            <p:nvPr/>
          </p:nvSpPr>
          <p:spPr>
            <a:xfrm>
              <a:off x="2647072" y="81006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B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2FC8E37-40A8-3284-C6EB-0B65D77DC021}"/>
                </a:ext>
              </a:extLst>
            </p:cNvPr>
            <p:cNvSpPr txBox="1"/>
            <p:nvPr/>
          </p:nvSpPr>
          <p:spPr>
            <a:xfrm>
              <a:off x="4842480" y="81006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C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5624F77-4212-45BD-A4FA-08B04717758E}"/>
                </a:ext>
              </a:extLst>
            </p:cNvPr>
            <p:cNvSpPr txBox="1"/>
            <p:nvPr/>
          </p:nvSpPr>
          <p:spPr>
            <a:xfrm>
              <a:off x="369733" y="4289609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D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7E566D8-8F66-FDAB-9EFD-AC62C999A915}"/>
                </a:ext>
              </a:extLst>
            </p:cNvPr>
            <p:cNvSpPr txBox="1"/>
            <p:nvPr/>
          </p:nvSpPr>
          <p:spPr>
            <a:xfrm>
              <a:off x="2063835" y="7156579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WT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0EF7B9F-0C62-2502-31C5-5120B1985817}"/>
                </a:ext>
              </a:extLst>
            </p:cNvPr>
            <p:cNvSpPr txBox="1"/>
            <p:nvPr/>
          </p:nvSpPr>
          <p:spPr>
            <a:xfrm>
              <a:off x="5309070" y="7134897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/>
                <a:t>tga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5B40D8F-1A54-C702-CF53-1270745D261B}"/>
                </a:ext>
              </a:extLst>
            </p:cNvPr>
            <p:cNvSpPr txBox="1"/>
            <p:nvPr/>
          </p:nvSpPr>
          <p:spPr>
            <a:xfrm>
              <a:off x="1203545" y="3530887"/>
              <a:ext cx="4042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WT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69A6C2E-E633-2346-27C9-E5AE1F746E17}"/>
                </a:ext>
              </a:extLst>
            </p:cNvPr>
            <p:cNvSpPr txBox="1"/>
            <p:nvPr/>
          </p:nvSpPr>
          <p:spPr>
            <a:xfrm>
              <a:off x="2002036" y="3530887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i="1" dirty="0"/>
                <a:t>tga5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B7064A2-B154-3D43-0F50-692D80A282AE}"/>
                </a:ext>
              </a:extLst>
            </p:cNvPr>
            <p:cNvSpPr txBox="1"/>
            <p:nvPr/>
          </p:nvSpPr>
          <p:spPr>
            <a:xfrm>
              <a:off x="3428450" y="3530887"/>
              <a:ext cx="4042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WT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C97C296E-1BF3-43C6-D487-80E0E41E8845}"/>
                </a:ext>
              </a:extLst>
            </p:cNvPr>
            <p:cNvSpPr txBox="1"/>
            <p:nvPr/>
          </p:nvSpPr>
          <p:spPr>
            <a:xfrm>
              <a:off x="4257509" y="3530887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i="1" dirty="0"/>
                <a:t>tga5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75DCD55-6382-7E5F-2AEE-AD062F265061}"/>
                </a:ext>
              </a:extLst>
            </p:cNvPr>
            <p:cNvSpPr txBox="1"/>
            <p:nvPr/>
          </p:nvSpPr>
          <p:spPr>
            <a:xfrm>
              <a:off x="5683334" y="3530887"/>
              <a:ext cx="4042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WT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133CD8A-A205-E62D-5BAC-C00C524CE6A0}"/>
                </a:ext>
              </a:extLst>
            </p:cNvPr>
            <p:cNvSpPr txBox="1"/>
            <p:nvPr/>
          </p:nvSpPr>
          <p:spPr>
            <a:xfrm>
              <a:off x="6522901" y="3529864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i="1" dirty="0"/>
                <a:t>tga5</a:t>
              </a: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F613F9F8-5CC8-8AAE-0E40-0C382D05F8DB}"/>
                </a:ext>
              </a:extLst>
            </p:cNvPr>
            <p:cNvSpPr/>
            <p:nvPr/>
          </p:nvSpPr>
          <p:spPr>
            <a:xfrm rot="16200000">
              <a:off x="-342069" y="2286970"/>
              <a:ext cx="1817225" cy="3806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solidFill>
                    <a:schemeClr val="tx1"/>
                  </a:solidFill>
                </a:rPr>
                <a:t>plant height (cm)</a:t>
              </a: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BCD6099D-8AC5-5222-D3A0-FAA245A265E9}"/>
                </a:ext>
              </a:extLst>
            </p:cNvPr>
            <p:cNvSpPr/>
            <p:nvPr/>
          </p:nvSpPr>
          <p:spPr>
            <a:xfrm rot="16200000">
              <a:off x="1924057" y="2286970"/>
              <a:ext cx="1817225" cy="3806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solidFill>
                    <a:schemeClr val="tx1"/>
                  </a:solidFill>
                </a:rPr>
                <a:t>tiller number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9941A71A-0CE1-CEEA-E583-D1A4ECC9B260}"/>
                </a:ext>
              </a:extLst>
            </p:cNvPr>
            <p:cNvSpPr/>
            <p:nvPr/>
          </p:nvSpPr>
          <p:spPr>
            <a:xfrm rot="16200000">
              <a:off x="4046382" y="2280947"/>
              <a:ext cx="2009816" cy="3806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solidFill>
                    <a:schemeClr val="tx1"/>
                  </a:solidFill>
                </a:rPr>
                <a:t>shoot dry weight (g)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6062330C-10DD-0331-7914-45BCBD0D05B3}"/>
                </a:ext>
              </a:extLst>
            </p:cNvPr>
            <p:cNvSpPr/>
            <p:nvPr/>
          </p:nvSpPr>
          <p:spPr>
            <a:xfrm>
              <a:off x="6418206" y="4388758"/>
              <a:ext cx="164592" cy="164892"/>
            </a:xfrm>
            <a:prstGeom prst="rect">
              <a:avLst/>
            </a:prstGeom>
            <a:solidFill>
              <a:srgbClr val="F3B59D"/>
            </a:solidFill>
            <a:ln>
              <a:solidFill>
                <a:srgbClr val="EF9D7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E9855C6B-D218-6EC2-5048-C2C09226A701}"/>
                </a:ext>
              </a:extLst>
            </p:cNvPr>
            <p:cNvSpPr/>
            <p:nvPr/>
          </p:nvSpPr>
          <p:spPr>
            <a:xfrm>
              <a:off x="5292530" y="4388759"/>
              <a:ext cx="164892" cy="164891"/>
            </a:xfrm>
            <a:prstGeom prst="rect">
              <a:avLst/>
            </a:prstGeom>
            <a:solidFill>
              <a:srgbClr val="7C9AF4"/>
            </a:solidFill>
            <a:ln>
              <a:solidFill>
                <a:srgbClr val="5178E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3199C9A-E7F1-5A15-3DBC-F3C261605ABF}"/>
                </a:ext>
              </a:extLst>
            </p:cNvPr>
            <p:cNvSpPr txBox="1"/>
            <p:nvPr/>
          </p:nvSpPr>
          <p:spPr>
            <a:xfrm>
              <a:off x="5443692" y="4340398"/>
              <a:ext cx="4042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wet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326A9A3-CA88-45CF-9DF2-F11D8B1C9B07}"/>
                </a:ext>
              </a:extLst>
            </p:cNvPr>
            <p:cNvSpPr txBox="1"/>
            <p:nvPr/>
          </p:nvSpPr>
          <p:spPr>
            <a:xfrm>
              <a:off x="6545203" y="4336833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ry</a:t>
              </a:r>
            </a:p>
          </p:txBody>
        </p:sp>
      </p:grpSp>
      <p:pic>
        <p:nvPicPr>
          <p:cNvPr id="17" name="Picture 16" descr="A plant in a pot&#10;&#10;Description automatically generated">
            <a:extLst>
              <a:ext uri="{FF2B5EF4-FFF2-40B4-BE49-F238E27FC236}">
                <a16:creationId xmlns:a16="http://schemas.microsoft.com/office/drawing/2014/main" id="{3E51B4C5-39C3-71D9-DBE6-A0C9C6B6089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9794" r="18249" b="8967"/>
          <a:stretch/>
        </p:blipFill>
        <p:spPr>
          <a:xfrm>
            <a:off x="5755948" y="4687927"/>
            <a:ext cx="1232257" cy="2414016"/>
          </a:xfrm>
          <a:prstGeom prst="rect">
            <a:avLst/>
          </a:prstGeom>
          <a:ln w="38100">
            <a:solidFill>
              <a:srgbClr val="EE9572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5971E968-E049-247B-8728-4E4E7E4E42AA}"/>
              </a:ext>
            </a:extLst>
          </p:cNvPr>
          <p:cNvSpPr txBox="1"/>
          <p:nvPr/>
        </p:nvSpPr>
        <p:spPr>
          <a:xfrm>
            <a:off x="920101" y="3848420"/>
            <a:ext cx="1832412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Genotype: p=0.00013</a:t>
            </a:r>
          </a:p>
          <a:p>
            <a:r>
              <a:rPr lang="en-US" sz="1100" dirty="0"/>
              <a:t>Environment: p=0.00937</a:t>
            </a:r>
            <a:endParaRPr lang="en-US" sz="1100" baseline="300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610D64E-B11B-C502-A9C0-2D2A432F360D}"/>
              </a:ext>
            </a:extLst>
          </p:cNvPr>
          <p:cNvSpPr txBox="1"/>
          <p:nvPr/>
        </p:nvSpPr>
        <p:spPr>
          <a:xfrm>
            <a:off x="3124733" y="3851490"/>
            <a:ext cx="1703681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Genotype: p=3.79x10</a:t>
            </a:r>
            <a:r>
              <a:rPr lang="en-US" sz="1100" baseline="30000" dirty="0"/>
              <a:t>-5</a:t>
            </a:r>
            <a:endParaRPr lang="en-US" sz="1100" dirty="0"/>
          </a:p>
          <a:p>
            <a:r>
              <a:rPr lang="en-US" sz="1100" dirty="0"/>
              <a:t>Environment: p=0.0108</a:t>
            </a:r>
            <a:endParaRPr lang="en-US" sz="1100" baseline="300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0A56553-2926-4AB4-62BA-B565029799A2}"/>
              </a:ext>
            </a:extLst>
          </p:cNvPr>
          <p:cNvSpPr txBox="1"/>
          <p:nvPr/>
        </p:nvSpPr>
        <p:spPr>
          <a:xfrm>
            <a:off x="5362944" y="3829747"/>
            <a:ext cx="1832412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Genotype: p=00181</a:t>
            </a:r>
          </a:p>
          <a:p>
            <a:r>
              <a:rPr lang="en-US" sz="1100" dirty="0"/>
              <a:t>Environment: p=0.00151</a:t>
            </a:r>
            <a:endParaRPr lang="en-US" sz="1100" baseline="30000" dirty="0"/>
          </a:p>
        </p:txBody>
      </p:sp>
    </p:spTree>
    <p:extLst>
      <p:ext uri="{BB962C8B-B14F-4D97-AF65-F5344CB8AC3E}">
        <p14:creationId xmlns:p14="http://schemas.microsoft.com/office/powerpoint/2010/main" val="13226214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C357B4C2-9C2A-BDC2-121B-10EFDF42A40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3642"/>
          <a:stretch/>
        </p:blipFill>
        <p:spPr>
          <a:xfrm>
            <a:off x="448431" y="267649"/>
            <a:ext cx="3155191" cy="364831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6E433CC-0C97-9785-6640-CDB6CE1EF8A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3642"/>
          <a:stretch/>
        </p:blipFill>
        <p:spPr>
          <a:xfrm>
            <a:off x="4106034" y="267649"/>
            <a:ext cx="3155190" cy="3648319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AF6E1C20-752C-FB13-9DD0-FF23CE7FB8DF}"/>
              </a:ext>
            </a:extLst>
          </p:cNvPr>
          <p:cNvSpPr txBox="1"/>
          <p:nvPr/>
        </p:nvSpPr>
        <p:spPr>
          <a:xfrm>
            <a:off x="684185" y="8612718"/>
            <a:ext cx="640403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9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nicle traits quantified for wild-typ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ipponbar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ga5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mutant plants exposed to a 3-month period of intermittent drought or a well-watered control environment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72629C9-AFA1-4261-F377-29CA1657C8C5}"/>
              </a:ext>
            </a:extLst>
          </p:cNvPr>
          <p:cNvGrpSpPr/>
          <p:nvPr/>
        </p:nvGrpSpPr>
        <p:grpSpPr>
          <a:xfrm>
            <a:off x="93954" y="98372"/>
            <a:ext cx="7407001" cy="8514346"/>
            <a:chOff x="97365" y="-557819"/>
            <a:chExt cx="7407001" cy="8514346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ED00911-92A1-E8C1-1AB8-D5A23E8FAE71}"/>
                </a:ext>
              </a:extLst>
            </p:cNvPr>
            <p:cNvSpPr txBox="1"/>
            <p:nvPr/>
          </p:nvSpPr>
          <p:spPr>
            <a:xfrm>
              <a:off x="4547033" y="3388758"/>
              <a:ext cx="2957333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dirty="0"/>
                <a:t>Environment: p=0.00813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0D48F52-4B07-5602-6767-09B1107C27D4}"/>
                </a:ext>
              </a:extLst>
            </p:cNvPr>
            <p:cNvSpPr txBox="1"/>
            <p:nvPr/>
          </p:nvSpPr>
          <p:spPr>
            <a:xfrm>
              <a:off x="957029" y="3120932"/>
              <a:ext cx="1273215" cy="2616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WT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69ADA50-62F0-88F1-9B76-7BF5D52CC648}"/>
                </a:ext>
              </a:extLst>
            </p:cNvPr>
            <p:cNvSpPr txBox="1"/>
            <p:nvPr/>
          </p:nvSpPr>
          <p:spPr>
            <a:xfrm>
              <a:off x="2302067" y="3121920"/>
              <a:ext cx="127321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/>
                <a:t>tga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ED9B9C8-307C-89E0-9100-38DA0E6AF5DD}"/>
                </a:ext>
              </a:extLst>
            </p:cNvPr>
            <p:cNvSpPr txBox="1"/>
            <p:nvPr/>
          </p:nvSpPr>
          <p:spPr>
            <a:xfrm>
              <a:off x="4611420" y="3124766"/>
              <a:ext cx="1273215" cy="2616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WT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AE80B52-5BDA-22A1-B8F9-13B073CA5699}"/>
                </a:ext>
              </a:extLst>
            </p:cNvPr>
            <p:cNvSpPr txBox="1"/>
            <p:nvPr/>
          </p:nvSpPr>
          <p:spPr>
            <a:xfrm>
              <a:off x="5860258" y="3124766"/>
              <a:ext cx="127321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/>
                <a:t>tga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8D3EA1F-3653-A272-D113-34896EDA058A}"/>
                </a:ext>
              </a:extLst>
            </p:cNvPr>
            <p:cNvSpPr txBox="1"/>
            <p:nvPr/>
          </p:nvSpPr>
          <p:spPr>
            <a:xfrm>
              <a:off x="945001" y="3390238"/>
              <a:ext cx="2957333" cy="60016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dirty="0"/>
                <a:t>Genotype: p≤2x10</a:t>
              </a:r>
              <a:r>
                <a:rPr lang="en-US" sz="1100" baseline="30000" dirty="0"/>
                <a:t>-16</a:t>
              </a:r>
              <a:endParaRPr lang="en-US" sz="1100" dirty="0"/>
            </a:p>
            <a:p>
              <a:r>
                <a:rPr lang="en-US" sz="1100" dirty="0"/>
                <a:t>Environment: p=5.55x10</a:t>
              </a:r>
              <a:r>
                <a:rPr lang="en-US" sz="1100" baseline="30000" dirty="0"/>
                <a:t>-13</a:t>
              </a:r>
            </a:p>
            <a:p>
              <a:r>
                <a:rPr lang="en-US" sz="1100" dirty="0"/>
                <a:t>Genotype*Environment: p=0.0587</a:t>
              </a:r>
            </a:p>
          </p:txBody>
        </p:sp>
        <p:pic>
          <p:nvPicPr>
            <p:cNvPr id="5" name="Picture 4" descr="A group of wheat stalks on a black surface&#10;&#10;Description automatically generated">
              <a:extLst>
                <a:ext uri="{FF2B5EF4-FFF2-40B4-BE49-F238E27FC236}">
                  <a16:creationId xmlns:a16="http://schemas.microsoft.com/office/drawing/2014/main" id="{04B97A4E-D77D-8A9C-3F51-AC3E1FDA9A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/>
            <a:stretch/>
          </p:blipFill>
          <p:spPr>
            <a:xfrm rot="16200000">
              <a:off x="524689" y="4061443"/>
              <a:ext cx="1565807" cy="2087741"/>
            </a:xfrm>
            <a:prstGeom prst="rect">
              <a:avLst/>
            </a:prstGeom>
            <a:ln w="19050">
              <a:solidFill>
                <a:srgbClr val="426EEE"/>
              </a:solidFill>
            </a:ln>
          </p:spPr>
        </p:pic>
        <p:pic>
          <p:nvPicPr>
            <p:cNvPr id="11" name="Picture 10" descr="A group of wheat stalks with a measuring tape&#10;&#10;Description automatically generated">
              <a:extLst>
                <a:ext uri="{FF2B5EF4-FFF2-40B4-BE49-F238E27FC236}">
                  <a16:creationId xmlns:a16="http://schemas.microsoft.com/office/drawing/2014/main" id="{128DD028-EDAE-0ACA-5C5D-970A1B6FE8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0335" r="5547" b="6512"/>
            <a:stretch/>
          </p:blipFill>
          <p:spPr>
            <a:xfrm rot="16200000">
              <a:off x="2566232" y="4182823"/>
              <a:ext cx="1565806" cy="1837961"/>
            </a:xfrm>
            <a:prstGeom prst="rect">
              <a:avLst/>
            </a:prstGeom>
            <a:ln w="19050">
              <a:solidFill>
                <a:srgbClr val="EE9572"/>
              </a:solidFill>
            </a:ln>
          </p:spPr>
        </p:pic>
        <p:pic>
          <p:nvPicPr>
            <p:cNvPr id="33" name="Picture 32" descr="A group of wheat stalks on a black surface&#10;&#10;Description automatically generated">
              <a:extLst>
                <a:ext uri="{FF2B5EF4-FFF2-40B4-BE49-F238E27FC236}">
                  <a16:creationId xmlns:a16="http://schemas.microsoft.com/office/drawing/2014/main" id="{2D31965D-2127-DC02-0F9F-5FF91482E7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12055" b="11297"/>
            <a:stretch/>
          </p:blipFill>
          <p:spPr>
            <a:xfrm rot="16200000">
              <a:off x="4364004" y="4301703"/>
              <a:ext cx="1565806" cy="1600200"/>
            </a:xfrm>
            <a:prstGeom prst="rect">
              <a:avLst/>
            </a:prstGeom>
            <a:ln w="19050">
              <a:solidFill>
                <a:srgbClr val="426EEE"/>
              </a:solidFill>
            </a:ln>
          </p:spPr>
        </p:pic>
        <p:pic>
          <p:nvPicPr>
            <p:cNvPr id="35" name="Picture 34" descr="A plant with a measuring tape&#10;&#10;Description automatically generated with medium confidence">
              <a:extLst>
                <a:ext uri="{FF2B5EF4-FFF2-40B4-BE49-F238E27FC236}">
                  <a16:creationId xmlns:a16="http://schemas.microsoft.com/office/drawing/2014/main" id="{59207953-09A8-7371-DD1C-5882895D00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9159" b="22129"/>
            <a:stretch/>
          </p:blipFill>
          <p:spPr>
            <a:xfrm rot="16200000">
              <a:off x="5960065" y="4384535"/>
              <a:ext cx="1565806" cy="1434536"/>
            </a:xfrm>
            <a:prstGeom prst="rect">
              <a:avLst/>
            </a:prstGeom>
            <a:ln w="19050">
              <a:solidFill>
                <a:srgbClr val="EE9572"/>
              </a:solidFill>
            </a:ln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EDFE5DE-65B6-EA02-F0CD-B2488656371D}"/>
                </a:ext>
              </a:extLst>
            </p:cNvPr>
            <p:cNvSpPr txBox="1"/>
            <p:nvPr/>
          </p:nvSpPr>
          <p:spPr>
            <a:xfrm>
              <a:off x="2169756" y="5891230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WT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708488F-A843-F28E-EA9F-519F2CEFEE33}"/>
                </a:ext>
              </a:extLst>
            </p:cNvPr>
            <p:cNvSpPr txBox="1"/>
            <p:nvPr/>
          </p:nvSpPr>
          <p:spPr>
            <a:xfrm>
              <a:off x="5720095" y="5893028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/>
                <a:t>tga5</a:t>
              </a: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C2B48AC6-C35A-D19A-3C77-8B9FDA9EC10F}"/>
                </a:ext>
              </a:extLst>
            </p:cNvPr>
            <p:cNvSpPr/>
            <p:nvPr/>
          </p:nvSpPr>
          <p:spPr>
            <a:xfrm>
              <a:off x="5412790" y="4025447"/>
              <a:ext cx="164892" cy="164891"/>
            </a:xfrm>
            <a:prstGeom prst="rect">
              <a:avLst/>
            </a:prstGeom>
            <a:solidFill>
              <a:srgbClr val="7C9AF4"/>
            </a:solidFill>
            <a:ln>
              <a:solidFill>
                <a:srgbClr val="5178E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57D3B1F-5000-9F67-EEC4-F67D51054F9B}"/>
                </a:ext>
              </a:extLst>
            </p:cNvPr>
            <p:cNvSpPr txBox="1"/>
            <p:nvPr/>
          </p:nvSpPr>
          <p:spPr>
            <a:xfrm>
              <a:off x="5563952" y="3977086"/>
              <a:ext cx="4042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wet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C2801E1-9FD6-8672-5144-8A12A80A5573}"/>
                </a:ext>
              </a:extLst>
            </p:cNvPr>
            <p:cNvSpPr txBox="1"/>
            <p:nvPr/>
          </p:nvSpPr>
          <p:spPr>
            <a:xfrm>
              <a:off x="6665463" y="3973521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ry</a:t>
              </a: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3A42950-E92C-47B2-D4FC-94771191E1C7}"/>
                </a:ext>
              </a:extLst>
            </p:cNvPr>
            <p:cNvSpPr/>
            <p:nvPr/>
          </p:nvSpPr>
          <p:spPr>
            <a:xfrm>
              <a:off x="6559131" y="4021880"/>
              <a:ext cx="164592" cy="164892"/>
            </a:xfrm>
            <a:prstGeom prst="rect">
              <a:avLst/>
            </a:prstGeom>
            <a:solidFill>
              <a:srgbClr val="F3B59D"/>
            </a:solidFill>
            <a:ln>
              <a:solidFill>
                <a:srgbClr val="EF9D7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" name="Picture 2" descr="A group of yellow plants&#10;&#10;Description automatically generated with medium confidence">
              <a:extLst>
                <a:ext uri="{FF2B5EF4-FFF2-40B4-BE49-F238E27FC236}">
                  <a16:creationId xmlns:a16="http://schemas.microsoft.com/office/drawing/2014/main" id="{C10BA6EE-2A10-B2A4-B2EB-32E0DC1B9DE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 rot="16200000">
              <a:off x="597955" y="6139715"/>
              <a:ext cx="1228612" cy="1638150"/>
            </a:xfrm>
            <a:prstGeom prst="rect">
              <a:avLst/>
            </a:prstGeom>
            <a:ln w="19050">
              <a:solidFill>
                <a:srgbClr val="426EEE"/>
              </a:solidFill>
            </a:ln>
          </p:spPr>
        </p:pic>
        <p:pic>
          <p:nvPicPr>
            <p:cNvPr id="10" name="Picture 9" descr="A close-up of several wheat stalks&#10;&#10;Description automatically generated">
              <a:extLst>
                <a:ext uri="{FF2B5EF4-FFF2-40B4-BE49-F238E27FC236}">
                  <a16:creationId xmlns:a16="http://schemas.microsoft.com/office/drawing/2014/main" id="{01186F9B-93D7-68C2-7A35-2BB9AA2DC57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rot="16200000">
              <a:off x="2368245" y="6146937"/>
              <a:ext cx="1228613" cy="1638151"/>
            </a:xfrm>
            <a:prstGeom prst="rect">
              <a:avLst/>
            </a:prstGeom>
            <a:ln w="19050">
              <a:solidFill>
                <a:srgbClr val="EE9572"/>
              </a:solidFill>
            </a:ln>
          </p:spPr>
        </p:pic>
        <p:pic>
          <p:nvPicPr>
            <p:cNvPr id="12" name="Picture 11" descr="A group of wheat plants&#10;&#10;Description automatically generated with medium confidence">
              <a:extLst>
                <a:ext uri="{FF2B5EF4-FFF2-40B4-BE49-F238E27FC236}">
                  <a16:creationId xmlns:a16="http://schemas.microsoft.com/office/drawing/2014/main" id="{A66199C3-412D-AB9F-3303-D0BDF76ACE3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 rot="16200000">
              <a:off x="4112269" y="6150216"/>
              <a:ext cx="1228613" cy="1638150"/>
            </a:xfrm>
            <a:prstGeom prst="rect">
              <a:avLst/>
            </a:prstGeom>
            <a:ln w="19050">
              <a:solidFill>
                <a:srgbClr val="426EEE"/>
              </a:solidFill>
            </a:ln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E6B24DE-B5C0-BD94-37A2-F09FA62146A3}"/>
                </a:ext>
              </a:extLst>
            </p:cNvPr>
            <p:cNvSpPr txBox="1"/>
            <p:nvPr/>
          </p:nvSpPr>
          <p:spPr>
            <a:xfrm>
              <a:off x="1836281" y="7625397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W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1661AC5-39BA-D304-B5BD-52E363EE07BF}"/>
                </a:ext>
              </a:extLst>
            </p:cNvPr>
            <p:cNvSpPr txBox="1"/>
            <p:nvPr/>
          </p:nvSpPr>
          <p:spPr>
            <a:xfrm>
              <a:off x="5352117" y="7648750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/>
                <a:t>tga5</a:t>
              </a:r>
            </a:p>
          </p:txBody>
        </p:sp>
        <p:pic>
          <p:nvPicPr>
            <p:cNvPr id="16" name="Picture 15" descr="A group of wheat stalks&#10;&#10;Description automatically generated with medium confidence">
              <a:extLst>
                <a:ext uri="{FF2B5EF4-FFF2-40B4-BE49-F238E27FC236}">
                  <a16:creationId xmlns:a16="http://schemas.microsoft.com/office/drawing/2014/main" id="{05352AD3-F934-3A6C-D4FB-D7972E88F74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 rot="16200000">
              <a:off x="5882559" y="6152587"/>
              <a:ext cx="1228614" cy="1638152"/>
            </a:xfrm>
            <a:prstGeom prst="rect">
              <a:avLst/>
            </a:prstGeom>
            <a:ln w="19050">
              <a:solidFill>
                <a:srgbClr val="EE9572"/>
              </a:solidFill>
            </a:ln>
          </p:spPr>
        </p:pic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7476209B-444E-F40A-C549-4F2B6DD3B3B3}"/>
                </a:ext>
              </a:extLst>
            </p:cNvPr>
            <p:cNvSpPr/>
            <p:nvPr/>
          </p:nvSpPr>
          <p:spPr>
            <a:xfrm>
              <a:off x="1980537" y="2987713"/>
              <a:ext cx="398818" cy="32099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3096B5B-D0C1-594C-9E37-8105A6192CC5}"/>
                </a:ext>
              </a:extLst>
            </p:cNvPr>
            <p:cNvSpPr txBox="1"/>
            <p:nvPr/>
          </p:nvSpPr>
          <p:spPr>
            <a:xfrm>
              <a:off x="97365" y="-557819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6102F4F-9EC1-F20B-1EE6-8ADB412028BA}"/>
                </a:ext>
              </a:extLst>
            </p:cNvPr>
            <p:cNvSpPr txBox="1"/>
            <p:nvPr/>
          </p:nvSpPr>
          <p:spPr>
            <a:xfrm>
              <a:off x="3777303" y="-557819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B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F7E96B1-0091-0EDC-CF66-81F29DD000E9}"/>
                </a:ext>
              </a:extLst>
            </p:cNvPr>
            <p:cNvSpPr txBox="1"/>
            <p:nvPr/>
          </p:nvSpPr>
          <p:spPr>
            <a:xfrm>
              <a:off x="97365" y="3858921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C</a:t>
              </a:r>
            </a:p>
          </p:txBody>
        </p: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73987CA5-C8E6-A756-6645-F33B37B19099}"/>
              </a:ext>
            </a:extLst>
          </p:cNvPr>
          <p:cNvSpPr/>
          <p:nvPr/>
        </p:nvSpPr>
        <p:spPr>
          <a:xfrm rot="16200000">
            <a:off x="-893367" y="1973207"/>
            <a:ext cx="2658884" cy="3806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chemeClr val="tx1"/>
                </a:solidFill>
              </a:rPr>
              <a:t>Spikelet number per panicle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12E69E0-0919-4110-4802-4F1FAFE11435}"/>
              </a:ext>
            </a:extLst>
          </p:cNvPr>
          <p:cNvSpPr/>
          <p:nvPr/>
        </p:nvSpPr>
        <p:spPr>
          <a:xfrm rot="16200000">
            <a:off x="2985902" y="1901489"/>
            <a:ext cx="2176970" cy="3806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chemeClr val="tx1"/>
                </a:solidFill>
              </a:rPr>
              <a:t>Variation in spikelet number</a:t>
            </a:r>
          </a:p>
        </p:txBody>
      </p:sp>
    </p:spTree>
    <p:extLst>
      <p:ext uri="{BB962C8B-B14F-4D97-AF65-F5344CB8AC3E}">
        <p14:creationId xmlns:p14="http://schemas.microsoft.com/office/powerpoint/2010/main" val="10976698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>
            <a:extLst>
              <a:ext uri="{FF2B5EF4-FFF2-40B4-BE49-F238E27FC236}">
                <a16:creationId xmlns:a16="http://schemas.microsoft.com/office/drawing/2014/main" id="{6364A224-B5CF-3B87-ADCD-E1074C73D47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3920"/>
          <a:stretch/>
        </p:blipFill>
        <p:spPr>
          <a:xfrm>
            <a:off x="3568762" y="4609967"/>
            <a:ext cx="3206312" cy="3696755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645D75A0-36A9-BB59-5726-C6C1C66C12D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3920"/>
          <a:stretch/>
        </p:blipFill>
        <p:spPr>
          <a:xfrm>
            <a:off x="244700" y="4609967"/>
            <a:ext cx="3206313" cy="369675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E09D61D-0BDA-E691-ECF9-5C1265A9C7F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4336"/>
          <a:stretch/>
        </p:blipFill>
        <p:spPr>
          <a:xfrm>
            <a:off x="3569517" y="187702"/>
            <a:ext cx="3206312" cy="368076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39FDCBE-E4CC-49D5-74BE-C4EA163CB0D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4308"/>
          <a:stretch/>
        </p:blipFill>
        <p:spPr>
          <a:xfrm>
            <a:off x="206428" y="186651"/>
            <a:ext cx="3206313" cy="36818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7A23970-5658-9006-3719-2628A52A3DF3}"/>
              </a:ext>
            </a:extLst>
          </p:cNvPr>
          <p:cNvSpPr txBox="1"/>
          <p:nvPr/>
        </p:nvSpPr>
        <p:spPr>
          <a:xfrm>
            <a:off x="531944" y="9048221"/>
            <a:ext cx="640403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0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nicle traits quantified for wild-typ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ipponbar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ga5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mutant plants exposed to a 3-month period of intermittent drought or a well-watered control environment.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00912E4E-2F51-CB37-E7E4-F68763EA534D}"/>
              </a:ext>
            </a:extLst>
          </p:cNvPr>
          <p:cNvGrpSpPr/>
          <p:nvPr/>
        </p:nvGrpSpPr>
        <p:grpSpPr>
          <a:xfrm>
            <a:off x="97365" y="76650"/>
            <a:ext cx="6844256" cy="8920507"/>
            <a:chOff x="97365" y="76650"/>
            <a:chExt cx="6844256" cy="8920507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AC903CB-E45B-1823-F2FB-E6758520D90D}"/>
                </a:ext>
              </a:extLst>
            </p:cNvPr>
            <p:cNvSpPr txBox="1"/>
            <p:nvPr/>
          </p:nvSpPr>
          <p:spPr>
            <a:xfrm>
              <a:off x="4006501" y="3977816"/>
              <a:ext cx="2026036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dirty="0"/>
                <a:t>Environment: p=0.017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0B3C711-A9A0-84BE-0CED-92CF8FBE0F45}"/>
                </a:ext>
              </a:extLst>
            </p:cNvPr>
            <p:cNvSpPr txBox="1"/>
            <p:nvPr/>
          </p:nvSpPr>
          <p:spPr>
            <a:xfrm>
              <a:off x="4049140" y="3792337"/>
              <a:ext cx="1273215" cy="2616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WT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E88A281-267E-C03C-E32A-143E6BCE3916}"/>
                </a:ext>
              </a:extLst>
            </p:cNvPr>
            <p:cNvSpPr txBox="1"/>
            <p:nvPr/>
          </p:nvSpPr>
          <p:spPr>
            <a:xfrm>
              <a:off x="5374752" y="3792336"/>
              <a:ext cx="127321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/>
                <a:t>tga5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FF46509-6CBB-6845-1D17-6C14D62D4E9D}"/>
                </a:ext>
              </a:extLst>
            </p:cNvPr>
            <p:cNvSpPr txBox="1"/>
            <p:nvPr/>
          </p:nvSpPr>
          <p:spPr>
            <a:xfrm>
              <a:off x="4058459" y="8230464"/>
              <a:ext cx="1273215" cy="2616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WT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E72BE91-AE61-262B-F7D1-7CADD9645349}"/>
                </a:ext>
              </a:extLst>
            </p:cNvPr>
            <p:cNvSpPr txBox="1"/>
            <p:nvPr/>
          </p:nvSpPr>
          <p:spPr>
            <a:xfrm>
              <a:off x="5371180" y="8230463"/>
              <a:ext cx="127321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/>
                <a:t>tga5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9B3C40A-7AE6-B7B5-69EF-253AFFADD0C0}"/>
                </a:ext>
              </a:extLst>
            </p:cNvPr>
            <p:cNvSpPr txBox="1"/>
            <p:nvPr/>
          </p:nvSpPr>
          <p:spPr>
            <a:xfrm>
              <a:off x="698219" y="8224277"/>
              <a:ext cx="1273215" cy="2616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WT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F0E26CC-524D-BB4D-29A0-785DBE8541FB}"/>
                </a:ext>
              </a:extLst>
            </p:cNvPr>
            <p:cNvSpPr txBox="1"/>
            <p:nvPr/>
          </p:nvSpPr>
          <p:spPr>
            <a:xfrm>
              <a:off x="2199882" y="8224276"/>
              <a:ext cx="95658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/>
                <a:t>tga5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B2D7BD7-57D0-D4FC-62C1-F98152E4D299}"/>
                </a:ext>
              </a:extLst>
            </p:cNvPr>
            <p:cNvSpPr txBox="1"/>
            <p:nvPr/>
          </p:nvSpPr>
          <p:spPr>
            <a:xfrm>
              <a:off x="595537" y="8482327"/>
              <a:ext cx="2327556" cy="43088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dirty="0"/>
                <a:t>Genotype: p=4.41x10</a:t>
              </a:r>
              <a:r>
                <a:rPr lang="en-US" sz="1100" baseline="30000" dirty="0"/>
                <a:t>-14</a:t>
              </a:r>
              <a:endParaRPr lang="en-US" sz="1100" dirty="0"/>
            </a:p>
            <a:p>
              <a:r>
                <a:rPr lang="en-US" sz="1100" dirty="0"/>
                <a:t>Environment: p=5.62x10</a:t>
              </a:r>
              <a:r>
                <a:rPr lang="en-US" sz="1100" baseline="30000" dirty="0"/>
                <a:t>-9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1B38144-99E0-544A-D674-8A45B185155E}"/>
                </a:ext>
              </a:extLst>
            </p:cNvPr>
            <p:cNvSpPr txBox="1"/>
            <p:nvPr/>
          </p:nvSpPr>
          <p:spPr>
            <a:xfrm>
              <a:off x="685862" y="3712914"/>
              <a:ext cx="1273215" cy="2616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WT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27163EC-4046-E237-E39F-14123BA31D6F}"/>
                </a:ext>
              </a:extLst>
            </p:cNvPr>
            <p:cNvSpPr txBox="1"/>
            <p:nvPr/>
          </p:nvSpPr>
          <p:spPr>
            <a:xfrm>
              <a:off x="1990894" y="3719702"/>
              <a:ext cx="127321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i="1" dirty="0"/>
                <a:t>tga5</a:t>
              </a: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372C3724-94E9-AD1B-92FB-E5C9906136E6}"/>
                </a:ext>
              </a:extLst>
            </p:cNvPr>
            <p:cNvSpPr/>
            <p:nvPr/>
          </p:nvSpPr>
          <p:spPr>
            <a:xfrm>
              <a:off x="5308716" y="8783908"/>
              <a:ext cx="164892" cy="164891"/>
            </a:xfrm>
            <a:prstGeom prst="rect">
              <a:avLst/>
            </a:prstGeom>
            <a:solidFill>
              <a:srgbClr val="7C9AF4"/>
            </a:solidFill>
            <a:ln>
              <a:solidFill>
                <a:srgbClr val="5178E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4A80C60-3FC8-F6B7-F394-A606D2BEE4DF}"/>
                </a:ext>
              </a:extLst>
            </p:cNvPr>
            <p:cNvSpPr txBox="1"/>
            <p:nvPr/>
          </p:nvSpPr>
          <p:spPr>
            <a:xfrm>
              <a:off x="5459878" y="8735547"/>
              <a:ext cx="4042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wet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DF23825-6901-A37E-5972-A18B334DAAD4}"/>
                </a:ext>
              </a:extLst>
            </p:cNvPr>
            <p:cNvSpPr txBox="1"/>
            <p:nvPr/>
          </p:nvSpPr>
          <p:spPr>
            <a:xfrm>
              <a:off x="6561389" y="8731982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ry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933AF12E-3645-15DC-8943-225D2E733E91}"/>
                </a:ext>
              </a:extLst>
            </p:cNvPr>
            <p:cNvSpPr/>
            <p:nvPr/>
          </p:nvSpPr>
          <p:spPr>
            <a:xfrm>
              <a:off x="6455057" y="8780341"/>
              <a:ext cx="164592" cy="164892"/>
            </a:xfrm>
            <a:prstGeom prst="rect">
              <a:avLst/>
            </a:prstGeom>
            <a:solidFill>
              <a:srgbClr val="F3B59D"/>
            </a:solidFill>
            <a:ln>
              <a:solidFill>
                <a:srgbClr val="EF9D7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B060835-1706-E03F-F8A8-27551511EBFA}"/>
                </a:ext>
              </a:extLst>
            </p:cNvPr>
            <p:cNvSpPr txBox="1"/>
            <p:nvPr/>
          </p:nvSpPr>
          <p:spPr>
            <a:xfrm>
              <a:off x="97365" y="7665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A476A03-0916-07E3-F6DA-E725E5DAAF12}"/>
                </a:ext>
              </a:extLst>
            </p:cNvPr>
            <p:cNvSpPr txBox="1"/>
            <p:nvPr/>
          </p:nvSpPr>
          <p:spPr>
            <a:xfrm>
              <a:off x="3189661" y="7665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B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DDF849A-3BE6-5A23-11EE-38777B3460D6}"/>
                </a:ext>
              </a:extLst>
            </p:cNvPr>
            <p:cNvSpPr txBox="1"/>
            <p:nvPr/>
          </p:nvSpPr>
          <p:spPr>
            <a:xfrm>
              <a:off x="97365" y="453570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C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30D2A2B-AF84-56E1-5F74-9460350D665F}"/>
                </a:ext>
              </a:extLst>
            </p:cNvPr>
            <p:cNvSpPr txBox="1"/>
            <p:nvPr/>
          </p:nvSpPr>
          <p:spPr>
            <a:xfrm>
              <a:off x="3189661" y="453570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D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142A422-A1CA-60C9-9E6F-BBE7CD6BAC94}"/>
                </a:ext>
              </a:extLst>
            </p:cNvPr>
            <p:cNvSpPr txBox="1"/>
            <p:nvPr/>
          </p:nvSpPr>
          <p:spPr>
            <a:xfrm rot="16200000">
              <a:off x="2147542" y="6396941"/>
              <a:ext cx="298190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variation in secondary branch number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6906643C-A1C5-D10F-60FF-FD1A3AE5F36B}"/>
              </a:ext>
            </a:extLst>
          </p:cNvPr>
          <p:cNvSpPr txBox="1"/>
          <p:nvPr/>
        </p:nvSpPr>
        <p:spPr>
          <a:xfrm>
            <a:off x="538570" y="3974009"/>
            <a:ext cx="2957333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Genotype: p≤2x10</a:t>
            </a:r>
            <a:r>
              <a:rPr lang="en-US" sz="1100" baseline="30000" dirty="0"/>
              <a:t>-16</a:t>
            </a:r>
            <a:endParaRPr lang="en-US" sz="1100" dirty="0"/>
          </a:p>
          <a:p>
            <a:r>
              <a:rPr lang="en-US" sz="1100" dirty="0"/>
              <a:t>Environment: p=8.94x10</a:t>
            </a:r>
            <a:r>
              <a:rPr lang="en-US" sz="1100" baseline="30000" dirty="0"/>
              <a:t>-9</a:t>
            </a:r>
          </a:p>
          <a:p>
            <a:r>
              <a:rPr lang="en-US" sz="1100" dirty="0"/>
              <a:t>Genotype*Environment: p=0.0328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19BE99D-4D03-B0DD-C38E-1E1BFC4F90D7}"/>
              </a:ext>
            </a:extLst>
          </p:cNvPr>
          <p:cNvSpPr txBox="1"/>
          <p:nvPr/>
        </p:nvSpPr>
        <p:spPr>
          <a:xfrm rot="16200000">
            <a:off x="2246041" y="1991968"/>
            <a:ext cx="277672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/>
              <a:t>variation in primary branch number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1F0769F-2C39-67F0-2417-F92B6D3E7B4E}"/>
              </a:ext>
            </a:extLst>
          </p:cNvPr>
          <p:cNvSpPr txBox="1"/>
          <p:nvPr/>
        </p:nvSpPr>
        <p:spPr>
          <a:xfrm rot="16200000">
            <a:off x="-1195137" y="6396942"/>
            <a:ext cx="297228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/>
              <a:t>secondary branch number per panicl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A277C31-D90C-3E56-1A1A-51D9E17796B0}"/>
              </a:ext>
            </a:extLst>
          </p:cNvPr>
          <p:cNvSpPr txBox="1"/>
          <p:nvPr/>
        </p:nvSpPr>
        <p:spPr>
          <a:xfrm rot="16200000">
            <a:off x="-1092545" y="1986475"/>
            <a:ext cx="276710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/>
              <a:t>primary branch number per panicle</a:t>
            </a:r>
          </a:p>
        </p:txBody>
      </p:sp>
    </p:spTree>
    <p:extLst>
      <p:ext uri="{BB962C8B-B14F-4D97-AF65-F5344CB8AC3E}">
        <p14:creationId xmlns:p14="http://schemas.microsoft.com/office/powerpoint/2010/main" val="345739525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22B5C0A-7BD7-B687-B05F-47A8A61D26B1}"/>
              </a:ext>
            </a:extLst>
          </p:cNvPr>
          <p:cNvSpPr txBox="1"/>
          <p:nvPr/>
        </p:nvSpPr>
        <p:spPr>
          <a:xfrm>
            <a:off x="659443" y="9019593"/>
            <a:ext cx="640403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1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nicle traits quantified for wild-typ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ipponbar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ga5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mutant plants exposed to a 3-month period of intermittent drought or a well-watered control environment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83D2E7A-4ADC-4414-4771-011B78D515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6200" y="652896"/>
            <a:ext cx="3605645" cy="300470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6A217FB-1F6A-9591-EF08-A6D7CC97D5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0555" y="652896"/>
            <a:ext cx="3605645" cy="300470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27E900B-D8AB-4916-0681-2873CF505266}"/>
              </a:ext>
            </a:extLst>
          </p:cNvPr>
          <p:cNvSpPr txBox="1"/>
          <p:nvPr/>
        </p:nvSpPr>
        <p:spPr>
          <a:xfrm>
            <a:off x="4519839" y="3475085"/>
            <a:ext cx="1273215" cy="2616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W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CC75B9B-CDB0-021A-400E-E4326027AD3C}"/>
              </a:ext>
            </a:extLst>
          </p:cNvPr>
          <p:cNvSpPr txBox="1"/>
          <p:nvPr/>
        </p:nvSpPr>
        <p:spPr>
          <a:xfrm>
            <a:off x="6014349" y="3475085"/>
            <a:ext cx="127321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/>
              <a:t>tga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1821DD5-50FC-35A9-1DE7-44C0BFB762F9}"/>
              </a:ext>
            </a:extLst>
          </p:cNvPr>
          <p:cNvSpPr txBox="1"/>
          <p:nvPr/>
        </p:nvSpPr>
        <p:spPr>
          <a:xfrm>
            <a:off x="844236" y="3475085"/>
            <a:ext cx="1273215" cy="26161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W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724165E-AA80-AE0C-C0AF-4DB10FB34959}"/>
              </a:ext>
            </a:extLst>
          </p:cNvPr>
          <p:cNvSpPr txBox="1"/>
          <p:nvPr/>
        </p:nvSpPr>
        <p:spPr>
          <a:xfrm>
            <a:off x="2290789" y="3475085"/>
            <a:ext cx="150577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/>
              <a:t>tga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2FBB9DF-87F1-5715-952F-E3D59ED0E3E9}"/>
              </a:ext>
            </a:extLst>
          </p:cNvPr>
          <p:cNvSpPr txBox="1"/>
          <p:nvPr/>
        </p:nvSpPr>
        <p:spPr>
          <a:xfrm>
            <a:off x="765373" y="3736695"/>
            <a:ext cx="2327556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Genotype: p=8.79x10</a:t>
            </a:r>
            <a:r>
              <a:rPr lang="en-US" sz="1100" baseline="30000" dirty="0"/>
              <a:t>-7</a:t>
            </a:r>
            <a:endParaRPr lang="en-US" sz="1100" dirty="0"/>
          </a:p>
          <a:p>
            <a:r>
              <a:rPr lang="en-US" sz="1100" dirty="0"/>
              <a:t>Environment: p=0.0523</a:t>
            </a:r>
            <a:endParaRPr lang="en-US" sz="1100" baseline="30000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91D5F31-7011-726B-69BD-321B62738E12}"/>
              </a:ext>
            </a:extLst>
          </p:cNvPr>
          <p:cNvSpPr/>
          <p:nvPr/>
        </p:nvSpPr>
        <p:spPr>
          <a:xfrm>
            <a:off x="5654659" y="4201116"/>
            <a:ext cx="164892" cy="164891"/>
          </a:xfrm>
          <a:prstGeom prst="rect">
            <a:avLst/>
          </a:prstGeom>
          <a:solidFill>
            <a:srgbClr val="7C9AF4"/>
          </a:solidFill>
          <a:ln>
            <a:solidFill>
              <a:srgbClr val="5178E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812695A-2236-FB98-1B94-EAEE04B8C7A7}"/>
              </a:ext>
            </a:extLst>
          </p:cNvPr>
          <p:cNvSpPr txBox="1"/>
          <p:nvPr/>
        </p:nvSpPr>
        <p:spPr>
          <a:xfrm>
            <a:off x="5805821" y="4152755"/>
            <a:ext cx="4042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e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59CDD12-A52F-C611-0FBC-3D408F4F39AA}"/>
              </a:ext>
            </a:extLst>
          </p:cNvPr>
          <p:cNvSpPr txBox="1"/>
          <p:nvPr/>
        </p:nvSpPr>
        <p:spPr>
          <a:xfrm>
            <a:off x="6907332" y="4149190"/>
            <a:ext cx="3802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ry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56143DD-E30B-6FDF-E505-D6917B84E6BD}"/>
              </a:ext>
            </a:extLst>
          </p:cNvPr>
          <p:cNvSpPr/>
          <p:nvPr/>
        </p:nvSpPr>
        <p:spPr>
          <a:xfrm>
            <a:off x="6801000" y="4197549"/>
            <a:ext cx="164592" cy="164892"/>
          </a:xfrm>
          <a:prstGeom prst="rect">
            <a:avLst/>
          </a:prstGeom>
          <a:solidFill>
            <a:srgbClr val="F3B59D"/>
          </a:solidFill>
          <a:ln>
            <a:solidFill>
              <a:srgbClr val="EF9D7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C4C89EF-42F4-F8A3-BF27-878E61F7A65E}"/>
              </a:ext>
            </a:extLst>
          </p:cNvPr>
          <p:cNvSpPr txBox="1"/>
          <p:nvPr/>
        </p:nvSpPr>
        <p:spPr>
          <a:xfrm>
            <a:off x="170565" y="36477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DFB8B04-7871-FF9D-3EE3-C28179D21D23}"/>
              </a:ext>
            </a:extLst>
          </p:cNvPr>
          <p:cNvSpPr txBox="1"/>
          <p:nvPr/>
        </p:nvSpPr>
        <p:spPr>
          <a:xfrm>
            <a:off x="3776210" y="36477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DFD26ED-8A09-BCE2-648F-BA35C107044B}"/>
              </a:ext>
            </a:extLst>
          </p:cNvPr>
          <p:cNvSpPr txBox="1"/>
          <p:nvPr/>
        </p:nvSpPr>
        <p:spPr>
          <a:xfrm>
            <a:off x="4473444" y="3736695"/>
            <a:ext cx="232755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Genotype: p=0.0078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90519A8-D0EF-069D-BD31-3025DEE40225}"/>
              </a:ext>
            </a:extLst>
          </p:cNvPr>
          <p:cNvSpPr txBox="1"/>
          <p:nvPr/>
        </p:nvSpPr>
        <p:spPr>
          <a:xfrm rot="16200000">
            <a:off x="-928730" y="2124817"/>
            <a:ext cx="248384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percent unfilled grain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CFF7DAB-D152-8757-65CB-0FCE5AC09AFA}"/>
              </a:ext>
            </a:extLst>
          </p:cNvPr>
          <p:cNvSpPr txBox="1"/>
          <p:nvPr/>
        </p:nvSpPr>
        <p:spPr>
          <a:xfrm rot="16200000">
            <a:off x="2524636" y="2102070"/>
            <a:ext cx="278014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variation in percent unfilled grains</a:t>
            </a:r>
          </a:p>
        </p:txBody>
      </p:sp>
      <p:pic>
        <p:nvPicPr>
          <p:cNvPr id="24" name="Picture 23" descr="A group of wheat on a black surface&#10;&#10;Description automatically generated">
            <a:extLst>
              <a:ext uri="{FF2B5EF4-FFF2-40B4-BE49-F238E27FC236}">
                <a16:creationId xmlns:a16="http://schemas.microsoft.com/office/drawing/2014/main" id="{19ACF06C-285F-2033-9510-92BF80E0B1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31015" y="4579253"/>
            <a:ext cx="2916014" cy="3888019"/>
          </a:xfrm>
          <a:prstGeom prst="rect">
            <a:avLst/>
          </a:prstGeom>
          <a:ln w="19050">
            <a:solidFill>
              <a:srgbClr val="0B1207"/>
            </a:solidFill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8F348CC1-4251-F20B-5943-F1D0ED46A292}"/>
              </a:ext>
            </a:extLst>
          </p:cNvPr>
          <p:cNvSpPr txBox="1"/>
          <p:nvPr/>
        </p:nvSpPr>
        <p:spPr>
          <a:xfrm>
            <a:off x="1885656" y="855997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W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028D7D1-7073-FD7A-565A-A8588BE461C8}"/>
              </a:ext>
            </a:extLst>
          </p:cNvPr>
          <p:cNvSpPr txBox="1"/>
          <p:nvPr/>
        </p:nvSpPr>
        <p:spPr>
          <a:xfrm>
            <a:off x="5526795" y="8542979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/>
              <a:t>tga5</a:t>
            </a:r>
          </a:p>
        </p:txBody>
      </p:sp>
      <p:pic>
        <p:nvPicPr>
          <p:cNvPr id="28" name="Picture 27" descr="A group of wheat on a black surface&#10;&#10;Description automatically generated">
            <a:extLst>
              <a:ext uri="{FF2B5EF4-FFF2-40B4-BE49-F238E27FC236}">
                <a16:creationId xmlns:a16="http://schemas.microsoft.com/office/drawing/2014/main" id="{3C19F44F-8D59-B873-8CA4-AE02936F9C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9443" y="4579253"/>
            <a:ext cx="2916015" cy="3888020"/>
          </a:xfrm>
          <a:prstGeom prst="rect">
            <a:avLst/>
          </a:prstGeom>
          <a:ln w="19050">
            <a:solidFill>
              <a:srgbClr val="0B1207"/>
            </a:solidFill>
          </a:ln>
        </p:spPr>
      </p:pic>
    </p:spTree>
    <p:extLst>
      <p:ext uri="{BB962C8B-B14F-4D97-AF65-F5344CB8AC3E}">
        <p14:creationId xmlns:p14="http://schemas.microsoft.com/office/powerpoint/2010/main" val="30994955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51F1E8D-3C6A-6D30-6F10-208FD0F1FEDC}"/>
              </a:ext>
            </a:extLst>
          </p:cNvPr>
          <p:cNvSpPr txBox="1"/>
          <p:nvPr/>
        </p:nvSpPr>
        <p:spPr>
          <a:xfrm>
            <a:off x="672380" y="459065"/>
            <a:ext cx="642763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Table S5. TGA-motif locations in the three candidate loci. </a:t>
            </a:r>
            <a:r>
              <a:rPr lang="en-US" sz="1400" dirty="0"/>
              <a:t>Transcription start site (TSS) are given with the genomic coordinates as annotated for the Nipponbare IRGSP-1.0 genome on </a:t>
            </a:r>
            <a:r>
              <a:rPr lang="en-US" sz="1400" dirty="0" err="1"/>
              <a:t>EnsemblPlants.org</a:t>
            </a:r>
            <a:r>
              <a:rPr lang="en-US" sz="1400" dirty="0"/>
              <a:t>. Description of TGA motif locations are noted as the base pair distance, upstream (+) or downstream (-), from the TSS.</a:t>
            </a:r>
          </a:p>
        </p:txBody>
      </p:sp>
      <p:graphicFrame>
        <p:nvGraphicFramePr>
          <p:cNvPr id="3" name="Table 3">
            <a:extLst>
              <a:ext uri="{FF2B5EF4-FFF2-40B4-BE49-F238E27FC236}">
                <a16:creationId xmlns:a16="http://schemas.microsoft.com/office/drawing/2014/main" id="{64E425E5-29F9-63E3-2309-200534AADB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4143114"/>
              </p:ext>
            </p:extLst>
          </p:nvPr>
        </p:nvGraphicFramePr>
        <p:xfrm>
          <a:off x="752390" y="1995998"/>
          <a:ext cx="6267614" cy="601825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99537">
                  <a:extLst>
                    <a:ext uri="{9D8B030D-6E8A-4147-A177-3AD203B41FA5}">
                      <a16:colId xmlns:a16="http://schemas.microsoft.com/office/drawing/2014/main" val="3065322158"/>
                    </a:ext>
                  </a:extLst>
                </a:gridCol>
                <a:gridCol w="174467">
                  <a:extLst>
                    <a:ext uri="{9D8B030D-6E8A-4147-A177-3AD203B41FA5}">
                      <a16:colId xmlns:a16="http://schemas.microsoft.com/office/drawing/2014/main" val="3731681997"/>
                    </a:ext>
                  </a:extLst>
                </a:gridCol>
                <a:gridCol w="1451718">
                  <a:extLst>
                    <a:ext uri="{9D8B030D-6E8A-4147-A177-3AD203B41FA5}">
                      <a16:colId xmlns:a16="http://schemas.microsoft.com/office/drawing/2014/main" val="3424949039"/>
                    </a:ext>
                  </a:extLst>
                </a:gridCol>
                <a:gridCol w="1820946">
                  <a:extLst>
                    <a:ext uri="{9D8B030D-6E8A-4147-A177-3AD203B41FA5}">
                      <a16:colId xmlns:a16="http://schemas.microsoft.com/office/drawing/2014/main" val="3276495392"/>
                    </a:ext>
                  </a:extLst>
                </a:gridCol>
                <a:gridCol w="1820946">
                  <a:extLst>
                    <a:ext uri="{9D8B030D-6E8A-4147-A177-3AD203B41FA5}">
                      <a16:colId xmlns:a16="http://schemas.microsoft.com/office/drawing/2014/main" val="1237938517"/>
                    </a:ext>
                  </a:extLst>
                </a:gridCol>
              </a:tblGrid>
              <a:tr h="551377">
                <a:tc>
                  <a:txBody>
                    <a:bodyPr/>
                    <a:lstStyle/>
                    <a:p>
                      <a:pPr algn="ctr"/>
                      <a:r>
                        <a:rPr lang="en-US" sz="1400" b="1" cap="none" spc="0" dirty="0">
                          <a:ln w="0"/>
                          <a:solidFill>
                            <a:schemeClr val="tx1"/>
                          </a:solidFill>
                          <a:effectLst>
                            <a:outerShdw blurRad="38100" dist="19050" dir="2700000" algn="tl" rotWithShape="0">
                              <a:schemeClr val="dk1">
                                <a:alpha val="40000"/>
                              </a:schemeClr>
                            </a:outerShdw>
                          </a:effectLst>
                        </a:rPr>
                        <a:t>Locus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Genomic coordinates </a:t>
                      </a:r>
                    </a:p>
                    <a:p>
                      <a:pPr algn="ctr"/>
                      <a:r>
                        <a:rPr lang="en-US" sz="1400" b="1" dirty="0"/>
                        <a:t>of TSS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TGA-motif distance </a:t>
                      </a:r>
                    </a:p>
                    <a:p>
                      <a:pPr algn="ctr"/>
                      <a:r>
                        <a:rPr lang="en-US" sz="1400" b="1" dirty="0"/>
                        <a:t>from TSS (bp)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Relative </a:t>
                      </a:r>
                    </a:p>
                    <a:p>
                      <a:pPr algn="ctr"/>
                      <a:r>
                        <a:rPr lang="en-US" sz="1400" b="1" dirty="0"/>
                        <a:t>location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16179604"/>
                  </a:ext>
                </a:extLst>
              </a:tr>
              <a:tr h="406672">
                <a:tc>
                  <a:txBody>
                    <a:bodyPr/>
                    <a:lstStyle/>
                    <a:p>
                      <a:pPr algn="ctr"/>
                      <a:r>
                        <a:rPr lang="en-US" sz="1400" b="1" i="1" dirty="0"/>
                        <a:t>OsSEU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1:539932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+899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Upstream T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1131988"/>
                  </a:ext>
                </a:extLst>
              </a:tr>
              <a:tr h="406672">
                <a:tc rowSpan="7" gridSpan="3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7" h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rowSpan="7" hMerge="1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+581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Upstream T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12868334"/>
                  </a:ext>
                </a:extLst>
              </a:tr>
              <a:tr h="406672">
                <a:tc gridSpan="3" vMerge="1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+495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Upstream T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98810699"/>
                  </a:ext>
                </a:extLst>
              </a:tr>
              <a:tr h="406672">
                <a:tc gridSpan="3" vMerge="1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+367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Upstream T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86076093"/>
                  </a:ext>
                </a:extLst>
              </a:tr>
              <a:tr h="406672">
                <a:tc gridSpan="3" vMerge="1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+83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Upstream T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85923596"/>
                  </a:ext>
                </a:extLst>
              </a:tr>
              <a:tr h="406672">
                <a:tc gridSpan="3" vMerge="1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284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gene bod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78692077"/>
                  </a:ext>
                </a:extLst>
              </a:tr>
              <a:tr h="406672">
                <a:tc gridSpan="3" vMerge="1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883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downstream 3’ UTR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77992588"/>
                  </a:ext>
                </a:extLst>
              </a:tr>
              <a:tr h="406672">
                <a:tc gridSpan="3" vMerge="1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982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downstream 3’ UTR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34502284"/>
                  </a:ext>
                </a:extLst>
              </a:tr>
              <a:tr h="406672">
                <a:tc>
                  <a:txBody>
                    <a:bodyPr/>
                    <a:lstStyle/>
                    <a:p>
                      <a:pPr algn="ctr"/>
                      <a:r>
                        <a:rPr lang="en-US" sz="1400" b="1" i="1" dirty="0"/>
                        <a:t>OsSEU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1:541943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+944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Upstream T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408209"/>
                  </a:ext>
                </a:extLst>
              </a:tr>
              <a:tr h="406672">
                <a:tc rowSpan="3" gridSpan="3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rowSpan="3" hMerge="1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+883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Upstream T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74459081"/>
                  </a:ext>
                </a:extLst>
              </a:tr>
              <a:tr h="406672">
                <a:tc gridSpan="3" vMerge="1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+724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Upstream T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19011604"/>
                  </a:ext>
                </a:extLst>
              </a:tr>
              <a:tr h="406672">
                <a:tc gridSpan="3" vMerge="1"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+6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Upstream TS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98226272"/>
                  </a:ext>
                </a:extLst>
              </a:tr>
              <a:tr h="406672"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b="1" i="1" dirty="0"/>
                        <a:t>OsFbox536</a:t>
                      </a:r>
                      <a:endParaRPr lang="en-US" sz="14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14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:2737043</a:t>
                      </a:r>
                      <a:endParaRPr lang="en-US" sz="1400" b="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:2737043</a:t>
                      </a:r>
                      <a:endParaRPr lang="en-US" sz="1400" b="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87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gene bod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bg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661822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089398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28BA2E3-8D5E-EFFE-97BC-060B7C3C31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1148" y="1159709"/>
            <a:ext cx="5807676" cy="350191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9CBB6D7-618B-2BF9-5A9F-6EB4282C2F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1148" y="4910674"/>
            <a:ext cx="5807678" cy="350192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59995A3-8694-E42E-7E38-CB7631BF0EB7}"/>
              </a:ext>
            </a:extLst>
          </p:cNvPr>
          <p:cNvSpPr txBox="1"/>
          <p:nvPr/>
        </p:nvSpPr>
        <p:spPr>
          <a:xfrm>
            <a:off x="663576" y="1151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F958F5F-6F25-CE57-69DF-362CA0FD510F}"/>
              </a:ext>
            </a:extLst>
          </p:cNvPr>
          <p:cNvSpPr txBox="1"/>
          <p:nvPr/>
        </p:nvSpPr>
        <p:spPr>
          <a:xfrm>
            <a:off x="663576" y="115970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9593E96-0CA7-7910-E028-DB17D83D5A7C}"/>
              </a:ext>
            </a:extLst>
          </p:cNvPr>
          <p:cNvSpPr txBox="1"/>
          <p:nvPr/>
        </p:nvSpPr>
        <p:spPr>
          <a:xfrm>
            <a:off x="663576" y="4910674"/>
            <a:ext cx="3513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DF90617-AB7A-7AD5-D0BC-3934F41F11DA}"/>
              </a:ext>
            </a:extLst>
          </p:cNvPr>
          <p:cNvSpPr txBox="1"/>
          <p:nvPr/>
        </p:nvSpPr>
        <p:spPr>
          <a:xfrm>
            <a:off x="991139" y="1504337"/>
            <a:ext cx="954107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/>
              <a:t>Nipponbare </a:t>
            </a:r>
          </a:p>
          <a:p>
            <a:r>
              <a:rPr lang="en-US" sz="1100" dirty="0"/>
              <a:t>referenc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4D63FB3-1F09-9AE7-C40D-C26CDD5963BC}"/>
              </a:ext>
            </a:extLst>
          </p:cNvPr>
          <p:cNvSpPr txBox="1"/>
          <p:nvPr/>
        </p:nvSpPr>
        <p:spPr>
          <a:xfrm>
            <a:off x="1234795" y="1935224"/>
            <a:ext cx="71045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i="1" dirty="0"/>
              <a:t>tga5</a:t>
            </a:r>
            <a:r>
              <a:rPr lang="en-US" sz="1100" dirty="0"/>
              <a:t>_B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39E86DE-E108-A6DA-19F9-3A6C91A0BFBB}"/>
              </a:ext>
            </a:extLst>
          </p:cNvPr>
          <p:cNvSpPr txBox="1"/>
          <p:nvPr/>
        </p:nvSpPr>
        <p:spPr>
          <a:xfrm>
            <a:off x="998863" y="2645813"/>
            <a:ext cx="954107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/>
              <a:t>Nipponbare </a:t>
            </a:r>
          </a:p>
          <a:p>
            <a:r>
              <a:rPr lang="en-US" sz="1100" dirty="0"/>
              <a:t>referenc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E6B785B-B6A4-4CA8-8D59-07A199BCF74A}"/>
              </a:ext>
            </a:extLst>
          </p:cNvPr>
          <p:cNvSpPr txBox="1"/>
          <p:nvPr/>
        </p:nvSpPr>
        <p:spPr>
          <a:xfrm>
            <a:off x="1242519" y="3076700"/>
            <a:ext cx="71045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i="1" dirty="0"/>
              <a:t>tga5</a:t>
            </a:r>
            <a:r>
              <a:rPr lang="en-US" sz="1100" dirty="0"/>
              <a:t>_B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B5FB3CF-80AB-8F42-E072-624E31E9CEA1}"/>
              </a:ext>
            </a:extLst>
          </p:cNvPr>
          <p:cNvSpPr txBox="1"/>
          <p:nvPr/>
        </p:nvSpPr>
        <p:spPr>
          <a:xfrm>
            <a:off x="991139" y="3796864"/>
            <a:ext cx="954107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/>
              <a:t>Nipponbare </a:t>
            </a:r>
          </a:p>
          <a:p>
            <a:r>
              <a:rPr lang="en-US" sz="1100" dirty="0"/>
              <a:t>referenc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5C59AFF-E401-C93F-6E88-28919A5F5EBD}"/>
              </a:ext>
            </a:extLst>
          </p:cNvPr>
          <p:cNvSpPr txBox="1"/>
          <p:nvPr/>
        </p:nvSpPr>
        <p:spPr>
          <a:xfrm>
            <a:off x="1234795" y="4227751"/>
            <a:ext cx="71045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i="1" dirty="0"/>
              <a:t>tga5</a:t>
            </a:r>
            <a:r>
              <a:rPr lang="en-US" sz="1100" dirty="0"/>
              <a:t>_B2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DB16BD12-1573-BBF9-5463-9EBEEA3F8D33}"/>
              </a:ext>
            </a:extLst>
          </p:cNvPr>
          <p:cNvSpPr/>
          <p:nvPr/>
        </p:nvSpPr>
        <p:spPr>
          <a:xfrm>
            <a:off x="5347987" y="1328985"/>
            <a:ext cx="185351" cy="960987"/>
          </a:xfrm>
          <a:prstGeom prst="rect">
            <a:avLst/>
          </a:prstGeom>
          <a:noFill/>
          <a:ln w="28575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9DD1B6F-CB8B-4687-3D43-0F07FD6BBBB8}"/>
              </a:ext>
            </a:extLst>
          </p:cNvPr>
          <p:cNvSpPr txBox="1"/>
          <p:nvPr/>
        </p:nvSpPr>
        <p:spPr>
          <a:xfrm>
            <a:off x="994230" y="5420766"/>
            <a:ext cx="954107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/>
              <a:t>Nipponbare </a:t>
            </a:r>
          </a:p>
          <a:p>
            <a:r>
              <a:rPr lang="en-US" sz="1100" dirty="0"/>
              <a:t>referenc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B208C05-61CC-C00D-CB4B-759849213A98}"/>
              </a:ext>
            </a:extLst>
          </p:cNvPr>
          <p:cNvSpPr txBox="1"/>
          <p:nvPr/>
        </p:nvSpPr>
        <p:spPr>
          <a:xfrm>
            <a:off x="1237886" y="5851652"/>
            <a:ext cx="715084" cy="2960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1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8927EB8-767B-ADC9-978D-B13D910495C3}"/>
              </a:ext>
            </a:extLst>
          </p:cNvPr>
          <p:cNvSpPr txBox="1"/>
          <p:nvPr/>
        </p:nvSpPr>
        <p:spPr>
          <a:xfrm>
            <a:off x="998863" y="6437297"/>
            <a:ext cx="954107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/>
              <a:t>Nipponbare </a:t>
            </a:r>
          </a:p>
          <a:p>
            <a:r>
              <a:rPr lang="en-US" sz="1100" dirty="0"/>
              <a:t>referenc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E44979E-0C00-A605-7596-D1F74C9765A2}"/>
              </a:ext>
            </a:extLst>
          </p:cNvPr>
          <p:cNvSpPr txBox="1"/>
          <p:nvPr/>
        </p:nvSpPr>
        <p:spPr>
          <a:xfrm>
            <a:off x="1242519" y="6868183"/>
            <a:ext cx="715084" cy="2960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1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4E9BE43-760B-215E-3641-D97C9A0EDFD5}"/>
              </a:ext>
            </a:extLst>
          </p:cNvPr>
          <p:cNvSpPr txBox="1"/>
          <p:nvPr/>
        </p:nvSpPr>
        <p:spPr>
          <a:xfrm>
            <a:off x="998863" y="7588636"/>
            <a:ext cx="954107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/>
              <a:t>Nipponbare </a:t>
            </a:r>
          </a:p>
          <a:p>
            <a:r>
              <a:rPr lang="en-US" sz="1100" dirty="0"/>
              <a:t>referenc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83379FE-A022-10EC-878E-50C5678A08B7}"/>
              </a:ext>
            </a:extLst>
          </p:cNvPr>
          <p:cNvSpPr txBox="1"/>
          <p:nvPr/>
        </p:nvSpPr>
        <p:spPr>
          <a:xfrm>
            <a:off x="1242519" y="8019522"/>
            <a:ext cx="715084" cy="2960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100" dirty="0"/>
          </a:p>
        </p:txBody>
      </p:sp>
      <p:sp>
        <p:nvSpPr>
          <p:cNvPr id="28" name="Chevron 27">
            <a:extLst>
              <a:ext uri="{FF2B5EF4-FFF2-40B4-BE49-F238E27FC236}">
                <a16:creationId xmlns:a16="http://schemas.microsoft.com/office/drawing/2014/main" id="{1EEA9099-0FD1-3CA5-4E1F-3DD614CE7912}"/>
              </a:ext>
            </a:extLst>
          </p:cNvPr>
          <p:cNvSpPr/>
          <p:nvPr/>
        </p:nvSpPr>
        <p:spPr>
          <a:xfrm rot="5400000">
            <a:off x="6794159" y="5270586"/>
            <a:ext cx="128255" cy="135195"/>
          </a:xfrm>
          <a:prstGeom prst="chevron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D2D9F2AD-86B4-3156-2A57-502F177AF830}"/>
              </a:ext>
            </a:extLst>
          </p:cNvPr>
          <p:cNvCxnSpPr>
            <a:cxnSpLocks/>
          </p:cNvCxnSpPr>
          <p:nvPr/>
        </p:nvCxnSpPr>
        <p:spPr>
          <a:xfrm>
            <a:off x="1079020" y="648611"/>
            <a:ext cx="5737705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066C72EB-F99E-D213-6961-F2CF95EE27DF}"/>
              </a:ext>
            </a:extLst>
          </p:cNvPr>
          <p:cNvSpPr/>
          <p:nvPr/>
        </p:nvSpPr>
        <p:spPr>
          <a:xfrm>
            <a:off x="2361045" y="508039"/>
            <a:ext cx="64114" cy="27431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69EC183-1CED-77B7-FE49-C0D368EB8E8A}"/>
              </a:ext>
            </a:extLst>
          </p:cNvPr>
          <p:cNvSpPr/>
          <p:nvPr/>
        </p:nvSpPr>
        <p:spPr>
          <a:xfrm>
            <a:off x="6654757" y="516161"/>
            <a:ext cx="320720" cy="27432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82ADA67E-F4ED-E32A-42A0-7D530E4347CC}"/>
              </a:ext>
            </a:extLst>
          </p:cNvPr>
          <p:cNvSpPr/>
          <p:nvPr/>
        </p:nvSpPr>
        <p:spPr>
          <a:xfrm>
            <a:off x="1062896" y="509524"/>
            <a:ext cx="1298148" cy="27432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BCC6626E-33D6-CA47-32E3-E1C17F446FEB}"/>
              </a:ext>
            </a:extLst>
          </p:cNvPr>
          <p:cNvSpPr/>
          <p:nvPr/>
        </p:nvSpPr>
        <p:spPr>
          <a:xfrm>
            <a:off x="6522859" y="516161"/>
            <a:ext cx="131897" cy="274320"/>
          </a:xfrm>
          <a:prstGeom prst="rect">
            <a:avLst/>
          </a:prstGeom>
          <a:solidFill>
            <a:srgbClr val="EE957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F3C9E62D-C951-F86A-10A7-CA0B278B7A2B}"/>
              </a:ext>
            </a:extLst>
          </p:cNvPr>
          <p:cNvSpPr/>
          <p:nvPr/>
        </p:nvSpPr>
        <p:spPr>
          <a:xfrm>
            <a:off x="6179172" y="516161"/>
            <a:ext cx="217797" cy="274320"/>
          </a:xfrm>
          <a:prstGeom prst="rect">
            <a:avLst/>
          </a:prstGeom>
          <a:solidFill>
            <a:srgbClr val="EE957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DEEC3C36-CEC7-2871-3572-1849556CC815}"/>
              </a:ext>
            </a:extLst>
          </p:cNvPr>
          <p:cNvSpPr/>
          <p:nvPr/>
        </p:nvSpPr>
        <p:spPr>
          <a:xfrm>
            <a:off x="3486405" y="508037"/>
            <a:ext cx="75489" cy="27432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2672B060-C8BB-0312-BB71-CB4CE4A4E5D3}"/>
              </a:ext>
            </a:extLst>
          </p:cNvPr>
          <p:cNvSpPr/>
          <p:nvPr/>
        </p:nvSpPr>
        <p:spPr>
          <a:xfrm>
            <a:off x="5638975" y="516161"/>
            <a:ext cx="251168" cy="274320"/>
          </a:xfrm>
          <a:prstGeom prst="rect">
            <a:avLst/>
          </a:prstGeom>
          <a:solidFill>
            <a:srgbClr val="EE957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3EFB33E6-62FB-5848-8539-C8E0D83B6551}"/>
              </a:ext>
            </a:extLst>
          </p:cNvPr>
          <p:cNvSpPr/>
          <p:nvPr/>
        </p:nvSpPr>
        <p:spPr>
          <a:xfrm>
            <a:off x="5346843" y="520530"/>
            <a:ext cx="72463" cy="27432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9DBA0D08-241E-1B62-27B9-E9E7640AE2B9}"/>
              </a:ext>
            </a:extLst>
          </p:cNvPr>
          <p:cNvSpPr/>
          <p:nvPr/>
        </p:nvSpPr>
        <p:spPr>
          <a:xfrm flipH="1">
            <a:off x="5483421" y="516161"/>
            <a:ext cx="45719" cy="27432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8088165F-C2C5-F5DC-D359-1096E65E3424}"/>
              </a:ext>
            </a:extLst>
          </p:cNvPr>
          <p:cNvSpPr/>
          <p:nvPr/>
        </p:nvSpPr>
        <p:spPr>
          <a:xfrm>
            <a:off x="3618410" y="508037"/>
            <a:ext cx="45719" cy="27432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Chevron 51">
            <a:extLst>
              <a:ext uri="{FF2B5EF4-FFF2-40B4-BE49-F238E27FC236}">
                <a16:creationId xmlns:a16="http://schemas.microsoft.com/office/drawing/2014/main" id="{3CD89294-628B-1393-1EB5-886FFF148A66}"/>
              </a:ext>
            </a:extLst>
          </p:cNvPr>
          <p:cNvSpPr/>
          <p:nvPr/>
        </p:nvSpPr>
        <p:spPr>
          <a:xfrm rot="5400000">
            <a:off x="3573180" y="411030"/>
            <a:ext cx="84943" cy="90148"/>
          </a:xfrm>
          <a:prstGeom prst="chevron">
            <a:avLst/>
          </a:prstGeom>
          <a:solidFill>
            <a:srgbClr val="5178E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53" name="Chevron 52">
            <a:extLst>
              <a:ext uri="{FF2B5EF4-FFF2-40B4-BE49-F238E27FC236}">
                <a16:creationId xmlns:a16="http://schemas.microsoft.com/office/drawing/2014/main" id="{F764E605-CFED-BCBB-60F2-A579D64DCA6E}"/>
              </a:ext>
            </a:extLst>
          </p:cNvPr>
          <p:cNvSpPr/>
          <p:nvPr/>
        </p:nvSpPr>
        <p:spPr>
          <a:xfrm rot="5400000">
            <a:off x="5340602" y="411030"/>
            <a:ext cx="84943" cy="90148"/>
          </a:xfrm>
          <a:prstGeom prst="chevron">
            <a:avLst/>
          </a:prstGeom>
          <a:solidFill>
            <a:srgbClr val="5178E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D19CED6E-2FFE-7C35-48FF-F6EB632686F7}"/>
              </a:ext>
            </a:extLst>
          </p:cNvPr>
          <p:cNvCxnSpPr>
            <a:cxnSpLocks/>
          </p:cNvCxnSpPr>
          <p:nvPr/>
        </p:nvCxnSpPr>
        <p:spPr>
          <a:xfrm>
            <a:off x="6804535" y="872889"/>
            <a:ext cx="825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6BA3DA9E-53ED-0320-F9EC-F0AD3F56A0C1}"/>
              </a:ext>
            </a:extLst>
          </p:cNvPr>
          <p:cNvCxnSpPr>
            <a:cxnSpLocks/>
          </p:cNvCxnSpPr>
          <p:nvPr/>
        </p:nvCxnSpPr>
        <p:spPr>
          <a:xfrm>
            <a:off x="6645230" y="514896"/>
            <a:ext cx="0" cy="27432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5D1E39CD-0A3F-DD25-03A4-D3F4FDA49A32}"/>
              </a:ext>
            </a:extLst>
          </p:cNvPr>
          <p:cNvSpPr txBox="1"/>
          <p:nvPr/>
        </p:nvSpPr>
        <p:spPr>
          <a:xfrm>
            <a:off x="3386261" y="229038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gRN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991E29C-7CE7-A622-CD40-62825C9401C5}"/>
              </a:ext>
            </a:extLst>
          </p:cNvPr>
          <p:cNvSpPr txBox="1"/>
          <p:nvPr/>
        </p:nvSpPr>
        <p:spPr>
          <a:xfrm>
            <a:off x="5149676" y="125669"/>
            <a:ext cx="4667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stop </a:t>
            </a:r>
          </a:p>
          <a:p>
            <a:pPr algn="ctr"/>
            <a:r>
              <a:rPr lang="en-US" sz="800" dirty="0"/>
              <a:t>codon</a:t>
            </a:r>
          </a:p>
        </p:txBody>
      </p:sp>
      <p:sp>
        <p:nvSpPr>
          <p:cNvPr id="66" name="Chevron 65">
            <a:extLst>
              <a:ext uri="{FF2B5EF4-FFF2-40B4-BE49-F238E27FC236}">
                <a16:creationId xmlns:a16="http://schemas.microsoft.com/office/drawing/2014/main" id="{C777A055-FBEE-2A8E-B9EA-D06C1ECFAF4F}"/>
              </a:ext>
            </a:extLst>
          </p:cNvPr>
          <p:cNvSpPr/>
          <p:nvPr/>
        </p:nvSpPr>
        <p:spPr>
          <a:xfrm rot="16200000">
            <a:off x="3588693" y="785343"/>
            <a:ext cx="84943" cy="90148"/>
          </a:xfrm>
          <a:prstGeom prst="chevron">
            <a:avLst/>
          </a:prstGeom>
          <a:solidFill>
            <a:srgbClr val="5178E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6242FF02-1AEA-AD5A-39B2-10EDF275A67D}"/>
              </a:ext>
            </a:extLst>
          </p:cNvPr>
          <p:cNvSpPr txBox="1"/>
          <p:nvPr/>
        </p:nvSpPr>
        <p:spPr>
          <a:xfrm>
            <a:off x="3459389" y="828135"/>
            <a:ext cx="4026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bp </a:t>
            </a:r>
          </a:p>
          <a:p>
            <a:r>
              <a:rPr lang="en-US" sz="800" dirty="0"/>
              <a:t>indel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CB4E7FF-F90A-574F-819F-A275DFDBAFAE}"/>
              </a:ext>
            </a:extLst>
          </p:cNvPr>
          <p:cNvSpPr txBox="1"/>
          <p:nvPr/>
        </p:nvSpPr>
        <p:spPr>
          <a:xfrm>
            <a:off x="5613916" y="315652"/>
            <a:ext cx="4764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solidFill>
                  <a:srgbClr val="EE9572"/>
                </a:solidFill>
              </a:rPr>
              <a:t>DOG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25E3C0E-E507-AB06-D474-00D913CD2BF1}"/>
              </a:ext>
            </a:extLst>
          </p:cNvPr>
          <p:cNvSpPr txBox="1"/>
          <p:nvPr/>
        </p:nvSpPr>
        <p:spPr>
          <a:xfrm>
            <a:off x="6567353" y="852741"/>
            <a:ext cx="5020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100 bp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A68BA6E-69BD-367F-CE36-D0C3CFBC30D8}"/>
              </a:ext>
            </a:extLst>
          </p:cNvPr>
          <p:cNvSpPr txBox="1"/>
          <p:nvPr/>
        </p:nvSpPr>
        <p:spPr>
          <a:xfrm>
            <a:off x="555171" y="8116849"/>
            <a:ext cx="655365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Fig. S12. </a:t>
            </a:r>
            <a:r>
              <a:rPr lang="en-US" sz="1400" dirty="0"/>
              <a:t>Rice </a:t>
            </a:r>
            <a:r>
              <a:rPr lang="en-US" sz="1400" i="1" dirty="0"/>
              <a:t>tga5 </a:t>
            </a:r>
            <a:r>
              <a:rPr lang="en-US" sz="1400" dirty="0"/>
              <a:t>loss-of-function mutant plants contain a single base pair insertion resulting in a premature stop codon in exon 4.</a:t>
            </a:r>
          </a:p>
        </p:txBody>
      </p:sp>
    </p:spTree>
    <p:extLst>
      <p:ext uri="{BB962C8B-B14F-4D97-AF65-F5344CB8AC3E}">
        <p14:creationId xmlns:p14="http://schemas.microsoft.com/office/powerpoint/2010/main" val="3390783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7DF7C8A4-E38B-4F8F-F685-169D9B25E978}"/>
              </a:ext>
            </a:extLst>
          </p:cNvPr>
          <p:cNvSpPr txBox="1"/>
          <p:nvPr/>
        </p:nvSpPr>
        <p:spPr>
          <a:xfrm>
            <a:off x="302079" y="9640542"/>
            <a:ext cx="7351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2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requency distributions of means of 11 morphological traits in Indica accessions.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C61E0B07-344B-015D-C511-F3711F2935CA}"/>
              </a:ext>
            </a:extLst>
          </p:cNvPr>
          <p:cNvGrpSpPr/>
          <p:nvPr/>
        </p:nvGrpSpPr>
        <p:grpSpPr>
          <a:xfrm>
            <a:off x="343326" y="48038"/>
            <a:ext cx="7310541" cy="9529753"/>
            <a:chOff x="343326" y="48038"/>
            <a:chExt cx="7310541" cy="952975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7B00937-3A70-0851-0409-01562EB6B5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6154"/>
            <a:stretch/>
          </p:blipFill>
          <p:spPr>
            <a:xfrm>
              <a:off x="2130645" y="3540402"/>
              <a:ext cx="1787319" cy="276598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8DE5110-8FC9-C60F-A25B-9AF75ECD5D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6154"/>
            <a:stretch/>
          </p:blipFill>
          <p:spPr>
            <a:xfrm>
              <a:off x="343326" y="3540402"/>
              <a:ext cx="1787319" cy="2765986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7E40803-FAFE-25CF-9A7E-E902A41ED9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-9023" b="6154"/>
            <a:stretch/>
          </p:blipFill>
          <p:spPr>
            <a:xfrm>
              <a:off x="5705284" y="451347"/>
              <a:ext cx="1948583" cy="276598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B959FDF-4F91-1035-075C-1D0690CE85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6154"/>
            <a:stretch/>
          </p:blipFill>
          <p:spPr>
            <a:xfrm>
              <a:off x="343327" y="451347"/>
              <a:ext cx="1787319" cy="2765986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A7F8A149-A495-0E63-73A5-687EE39ABE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b="6154"/>
            <a:stretch/>
          </p:blipFill>
          <p:spPr>
            <a:xfrm>
              <a:off x="3924327" y="3540402"/>
              <a:ext cx="1787319" cy="2765986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2B926735-A325-61D9-8A5E-FD69AD8A2D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b="6154"/>
            <a:stretch/>
          </p:blipFill>
          <p:spPr>
            <a:xfrm>
              <a:off x="3917965" y="451347"/>
              <a:ext cx="1787319" cy="2765986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FAB4BD71-1CEF-1676-1AFE-6CD773EAB7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b="6154"/>
            <a:stretch/>
          </p:blipFill>
          <p:spPr>
            <a:xfrm>
              <a:off x="2137007" y="6629456"/>
              <a:ext cx="1787320" cy="2765987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5650A24D-D6FC-96A5-4280-3EE0AC3846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b="6154"/>
            <a:stretch/>
          </p:blipFill>
          <p:spPr>
            <a:xfrm>
              <a:off x="2130646" y="451347"/>
              <a:ext cx="1787319" cy="2765986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F93AA4CA-8110-3FE8-5188-A58801F14C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b="6154"/>
            <a:stretch/>
          </p:blipFill>
          <p:spPr>
            <a:xfrm>
              <a:off x="5705284" y="3540402"/>
              <a:ext cx="1787319" cy="2765986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BD89BC05-3DF3-9611-DE61-13B65EC4E5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b="6154"/>
            <a:stretch/>
          </p:blipFill>
          <p:spPr>
            <a:xfrm>
              <a:off x="349688" y="6629457"/>
              <a:ext cx="1787319" cy="2765986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9F7024A6-8B22-5B84-05F4-3C883D5449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b="6154"/>
            <a:stretch/>
          </p:blipFill>
          <p:spPr>
            <a:xfrm>
              <a:off x="3924327" y="6629455"/>
              <a:ext cx="1787319" cy="2765986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84ABDA87-9CD7-08B1-5B71-1C310BEC4B80}"/>
                </a:ext>
              </a:extLst>
            </p:cNvPr>
            <p:cNvSpPr/>
            <p:nvPr/>
          </p:nvSpPr>
          <p:spPr>
            <a:xfrm>
              <a:off x="6987791" y="295161"/>
              <a:ext cx="102409" cy="106948"/>
            </a:xfrm>
            <a:prstGeom prst="rect">
              <a:avLst/>
            </a:prstGeom>
            <a:solidFill>
              <a:srgbClr val="F3B59D"/>
            </a:solidFill>
            <a:ln>
              <a:solidFill>
                <a:srgbClr val="EF9D7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CC84C478-F2C9-2FE4-1634-935A36609702}"/>
                </a:ext>
              </a:extLst>
            </p:cNvPr>
            <p:cNvSpPr/>
            <p:nvPr/>
          </p:nvSpPr>
          <p:spPr>
            <a:xfrm>
              <a:off x="6990959" y="109134"/>
              <a:ext cx="99241" cy="104479"/>
            </a:xfrm>
            <a:prstGeom prst="rect">
              <a:avLst/>
            </a:prstGeom>
            <a:solidFill>
              <a:srgbClr val="7C9AF4"/>
            </a:solidFill>
            <a:ln>
              <a:solidFill>
                <a:srgbClr val="5178E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FCACDD5-3D8D-4029-38BF-073180196E1E}"/>
                </a:ext>
              </a:extLst>
            </p:cNvPr>
            <p:cNvSpPr txBox="1"/>
            <p:nvPr/>
          </p:nvSpPr>
          <p:spPr>
            <a:xfrm>
              <a:off x="7038994" y="48038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et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2B243C2-4DCB-55E7-6796-71C93FBD5A0D}"/>
                </a:ext>
              </a:extLst>
            </p:cNvPr>
            <p:cNvSpPr txBox="1"/>
            <p:nvPr/>
          </p:nvSpPr>
          <p:spPr>
            <a:xfrm>
              <a:off x="7038995" y="240913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ry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3F88250-FA81-8D5B-D19B-2101587FD8FE}"/>
                </a:ext>
              </a:extLst>
            </p:cNvPr>
            <p:cNvSpPr txBox="1"/>
            <p:nvPr/>
          </p:nvSpPr>
          <p:spPr>
            <a:xfrm>
              <a:off x="6142452" y="3155187"/>
              <a:ext cx="1226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anicle maturatio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A994659-1659-8141-594E-12DEE4AE0ECC}"/>
                </a:ext>
              </a:extLst>
            </p:cNvPr>
            <p:cNvSpPr txBox="1"/>
            <p:nvPr/>
          </p:nvSpPr>
          <p:spPr>
            <a:xfrm>
              <a:off x="4418096" y="3157361"/>
              <a:ext cx="11128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hoot dry weight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8D2421F-5BDE-1B01-CFFF-D4FF9B3ADE27}"/>
                </a:ext>
              </a:extLst>
            </p:cNvPr>
            <p:cNvSpPr txBox="1"/>
            <p:nvPr/>
          </p:nvSpPr>
          <p:spPr>
            <a:xfrm>
              <a:off x="2703832" y="3157949"/>
              <a:ext cx="8883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tiller number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AE93CC0-8CF7-7CB1-5DF5-628E6FCF77DC}"/>
                </a:ext>
              </a:extLst>
            </p:cNvPr>
            <p:cNvSpPr txBox="1"/>
            <p:nvPr/>
          </p:nvSpPr>
          <p:spPr>
            <a:xfrm>
              <a:off x="948662" y="3151526"/>
              <a:ext cx="8418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lant height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EE09FE7-ECDB-094A-2FFE-5F0908460DDD}"/>
                </a:ext>
              </a:extLst>
            </p:cNvPr>
            <p:cNvSpPr txBox="1"/>
            <p:nvPr/>
          </p:nvSpPr>
          <p:spPr>
            <a:xfrm>
              <a:off x="892059" y="6241539"/>
              <a:ext cx="10567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anicle number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5D20B8F-90A2-D2DC-A278-7318489DB774}"/>
                </a:ext>
              </a:extLst>
            </p:cNvPr>
            <p:cNvSpPr txBox="1"/>
            <p:nvPr/>
          </p:nvSpPr>
          <p:spPr>
            <a:xfrm>
              <a:off x="2667606" y="6245887"/>
              <a:ext cx="9701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anicle length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1BCA814-73DE-E586-1CB9-25703E3F8D11}"/>
                </a:ext>
              </a:extLst>
            </p:cNvPr>
            <p:cNvSpPr txBox="1"/>
            <p:nvPr/>
          </p:nvSpPr>
          <p:spPr>
            <a:xfrm>
              <a:off x="4437992" y="6251725"/>
              <a:ext cx="1143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achis dry weight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227F63B-B650-6540-441D-9F7F7D515A7C}"/>
                </a:ext>
              </a:extLst>
            </p:cNvPr>
            <p:cNvSpPr txBox="1"/>
            <p:nvPr/>
          </p:nvSpPr>
          <p:spPr>
            <a:xfrm>
              <a:off x="5933158" y="6241539"/>
              <a:ext cx="16466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rimary panicle branching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8C13273-439A-26D1-B1C5-151981E37836}"/>
                </a:ext>
              </a:extLst>
            </p:cNvPr>
            <p:cNvSpPr txBox="1"/>
            <p:nvPr/>
          </p:nvSpPr>
          <p:spPr>
            <a:xfrm>
              <a:off x="500723" y="9331570"/>
              <a:ext cx="18069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econdary panicle branching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8B3BFC3-2D4A-F2B1-DFE3-0276E6A57F2B}"/>
                </a:ext>
              </a:extLst>
            </p:cNvPr>
            <p:cNvSpPr txBox="1"/>
            <p:nvPr/>
          </p:nvSpPr>
          <p:spPr>
            <a:xfrm>
              <a:off x="2644492" y="9331570"/>
              <a:ext cx="1085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pikelet number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644CD8A-E1EC-2F18-C07A-C6B0BC6532EB}"/>
                </a:ext>
              </a:extLst>
            </p:cNvPr>
            <p:cNvSpPr txBox="1"/>
            <p:nvPr/>
          </p:nvSpPr>
          <p:spPr>
            <a:xfrm>
              <a:off x="4402200" y="9331569"/>
              <a:ext cx="11272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00-grain weight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74DA83BB-86BB-7EBA-802C-28FB5FB459DC}"/>
              </a:ext>
            </a:extLst>
          </p:cNvPr>
          <p:cNvSpPr txBox="1"/>
          <p:nvPr/>
        </p:nvSpPr>
        <p:spPr>
          <a:xfrm>
            <a:off x="1686169" y="662957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8007BCF-B444-4DA8-6C89-BC2BBD603018}"/>
              </a:ext>
            </a:extLst>
          </p:cNvPr>
          <p:cNvSpPr txBox="1"/>
          <p:nvPr/>
        </p:nvSpPr>
        <p:spPr>
          <a:xfrm>
            <a:off x="3469824" y="662957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0ADC259-CB5E-64D4-D25F-9C139FA3B950}"/>
              </a:ext>
            </a:extLst>
          </p:cNvPr>
          <p:cNvSpPr txBox="1"/>
          <p:nvPr/>
        </p:nvSpPr>
        <p:spPr>
          <a:xfrm>
            <a:off x="5254998" y="662957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A3E6EDD-3767-942E-AD02-6016D99CF69A}"/>
              </a:ext>
            </a:extLst>
          </p:cNvPr>
          <p:cNvSpPr txBox="1"/>
          <p:nvPr/>
        </p:nvSpPr>
        <p:spPr>
          <a:xfrm>
            <a:off x="7042317" y="662957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63A8D6A-E461-73C2-827E-B75B82B7A1CB}"/>
              </a:ext>
            </a:extLst>
          </p:cNvPr>
          <p:cNvSpPr txBox="1"/>
          <p:nvPr/>
        </p:nvSpPr>
        <p:spPr>
          <a:xfrm>
            <a:off x="1687720" y="375635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2D03C1C-608F-D425-D3D2-699E4A18FB44}"/>
              </a:ext>
            </a:extLst>
          </p:cNvPr>
          <p:cNvSpPr txBox="1"/>
          <p:nvPr/>
        </p:nvSpPr>
        <p:spPr>
          <a:xfrm>
            <a:off x="3468677" y="375635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62A1991-7AE2-3354-AD40-B977404C2DD4}"/>
              </a:ext>
            </a:extLst>
          </p:cNvPr>
          <p:cNvSpPr txBox="1"/>
          <p:nvPr/>
        </p:nvSpPr>
        <p:spPr>
          <a:xfrm>
            <a:off x="5257311" y="375635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434510B-A632-8B11-6581-8A523A0106D6}"/>
              </a:ext>
            </a:extLst>
          </p:cNvPr>
          <p:cNvSpPr txBox="1"/>
          <p:nvPr/>
        </p:nvSpPr>
        <p:spPr>
          <a:xfrm>
            <a:off x="7042795" y="375635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5C392BE-B105-57F6-995D-B66110FCC798}"/>
              </a:ext>
            </a:extLst>
          </p:cNvPr>
          <p:cNvSpPr txBox="1"/>
          <p:nvPr/>
        </p:nvSpPr>
        <p:spPr>
          <a:xfrm>
            <a:off x="1691587" y="6842743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A06DDC2-A658-EE5B-F054-623970D4C70F}"/>
              </a:ext>
            </a:extLst>
          </p:cNvPr>
          <p:cNvSpPr txBox="1"/>
          <p:nvPr/>
        </p:nvSpPr>
        <p:spPr>
          <a:xfrm>
            <a:off x="3468677" y="6842743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0E8E177-6104-BF26-6B68-C817FDEA784E}"/>
              </a:ext>
            </a:extLst>
          </p:cNvPr>
          <p:cNvSpPr txBox="1"/>
          <p:nvPr/>
        </p:nvSpPr>
        <p:spPr>
          <a:xfrm>
            <a:off x="5260732" y="6842743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2058974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>
            <a:extLst>
              <a:ext uri="{FF2B5EF4-FFF2-40B4-BE49-F238E27FC236}">
                <a16:creationId xmlns:a16="http://schemas.microsoft.com/office/drawing/2014/main" id="{8D9E13A2-F500-CF1D-A420-B5289A270EFE}"/>
              </a:ext>
            </a:extLst>
          </p:cNvPr>
          <p:cNvSpPr txBox="1"/>
          <p:nvPr/>
        </p:nvSpPr>
        <p:spPr>
          <a:xfrm>
            <a:off x="302079" y="7934319"/>
            <a:ext cx="716824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3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requency distributions of 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Levene’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tatistic (LS, canalization) for variation in six morphological traits in Indica accessions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23035F9E-EAEA-73C5-6B05-B7510A6A9629}"/>
              </a:ext>
            </a:extLst>
          </p:cNvPr>
          <p:cNvGrpSpPr/>
          <p:nvPr/>
        </p:nvGrpSpPr>
        <p:grpSpPr>
          <a:xfrm>
            <a:off x="284745" y="48038"/>
            <a:ext cx="7150771" cy="7399445"/>
            <a:chOff x="284745" y="48038"/>
            <a:chExt cx="7150771" cy="7399445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8046328E-4414-1424-13DD-AF4ACE9780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4725" b="4720"/>
            <a:stretch/>
          </p:blipFill>
          <p:spPr>
            <a:xfrm>
              <a:off x="284745" y="4205189"/>
              <a:ext cx="2161675" cy="3078076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8DC5A96F-10D0-F1E8-66CA-3019441520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4615" b="4831"/>
            <a:stretch/>
          </p:blipFill>
          <p:spPr>
            <a:xfrm>
              <a:off x="2805363" y="4205188"/>
              <a:ext cx="2161674" cy="3078077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4C739EB5-376B-CB1A-DF5A-873450811E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4614" b="4832"/>
            <a:stretch/>
          </p:blipFill>
          <p:spPr>
            <a:xfrm>
              <a:off x="5273842" y="867394"/>
              <a:ext cx="2161674" cy="3078073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A8E6515F-3B19-2C3A-24BB-12B0015693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4615" b="4831"/>
            <a:stretch/>
          </p:blipFill>
          <p:spPr>
            <a:xfrm>
              <a:off x="2779294" y="867392"/>
              <a:ext cx="2161674" cy="3078076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400D7713-927C-AB2E-8D7B-D165BA06B9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4614" b="4832"/>
            <a:stretch/>
          </p:blipFill>
          <p:spPr>
            <a:xfrm>
              <a:off x="284746" y="867391"/>
              <a:ext cx="2161674" cy="3078076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04472F3E-B467-23D7-3571-804D0DF86A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4614" b="4832"/>
            <a:stretch/>
          </p:blipFill>
          <p:spPr>
            <a:xfrm>
              <a:off x="5273841" y="4205188"/>
              <a:ext cx="2161675" cy="3078073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83985470-57DB-6A6C-79CA-8DD292D7A74D}"/>
                </a:ext>
              </a:extLst>
            </p:cNvPr>
            <p:cNvSpPr/>
            <p:nvPr/>
          </p:nvSpPr>
          <p:spPr>
            <a:xfrm>
              <a:off x="6987791" y="295161"/>
              <a:ext cx="102409" cy="106948"/>
            </a:xfrm>
            <a:prstGeom prst="rect">
              <a:avLst/>
            </a:prstGeom>
            <a:solidFill>
              <a:srgbClr val="F3B59D"/>
            </a:solidFill>
            <a:ln>
              <a:solidFill>
                <a:srgbClr val="EF9D7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9B352273-1FFC-233B-D6F8-0A764903D677}"/>
                </a:ext>
              </a:extLst>
            </p:cNvPr>
            <p:cNvSpPr/>
            <p:nvPr/>
          </p:nvSpPr>
          <p:spPr>
            <a:xfrm>
              <a:off x="6990959" y="109134"/>
              <a:ext cx="99241" cy="104479"/>
            </a:xfrm>
            <a:prstGeom prst="rect">
              <a:avLst/>
            </a:prstGeom>
            <a:solidFill>
              <a:srgbClr val="7C9AF4"/>
            </a:solidFill>
            <a:ln>
              <a:solidFill>
                <a:srgbClr val="5178E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CBC7A05-7725-A8CD-6D3F-CBEAECF025DD}"/>
                </a:ext>
              </a:extLst>
            </p:cNvPr>
            <p:cNvSpPr txBox="1"/>
            <p:nvPr/>
          </p:nvSpPr>
          <p:spPr>
            <a:xfrm>
              <a:off x="7038994" y="48038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et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DF7F3E2-18FF-33EE-9404-347CC545F997}"/>
                </a:ext>
              </a:extLst>
            </p:cNvPr>
            <p:cNvSpPr txBox="1"/>
            <p:nvPr/>
          </p:nvSpPr>
          <p:spPr>
            <a:xfrm>
              <a:off x="7038995" y="240913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ry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ABB6FFB-2E75-DDC1-02EE-650C87A1CF48}"/>
                </a:ext>
              </a:extLst>
            </p:cNvPr>
            <p:cNvSpPr txBox="1"/>
            <p:nvPr/>
          </p:nvSpPr>
          <p:spPr>
            <a:xfrm>
              <a:off x="349088" y="7201262"/>
              <a:ext cx="22990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rimary panicle branching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0A183DA-2F3B-7B1F-6D7E-28BF8FCF5255}"/>
                </a:ext>
              </a:extLst>
            </p:cNvPr>
            <p:cNvSpPr txBox="1"/>
            <p:nvPr/>
          </p:nvSpPr>
          <p:spPr>
            <a:xfrm>
              <a:off x="2779294" y="7201262"/>
              <a:ext cx="24593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secondary panicle branching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EA93690-CDD7-6CC0-2255-8BBE382907EC}"/>
                </a:ext>
              </a:extLst>
            </p:cNvPr>
            <p:cNvSpPr txBox="1"/>
            <p:nvPr/>
          </p:nvSpPr>
          <p:spPr>
            <a:xfrm>
              <a:off x="5603292" y="7201262"/>
              <a:ext cx="17379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spikelet number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283DB09-0053-1DC0-8493-A15DE0E4FB07}"/>
                </a:ext>
              </a:extLst>
            </p:cNvPr>
            <p:cNvSpPr txBox="1"/>
            <p:nvPr/>
          </p:nvSpPr>
          <p:spPr>
            <a:xfrm>
              <a:off x="603651" y="3863467"/>
              <a:ext cx="17652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shoot dry weight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9D7C645-09AF-07F5-733A-FCB24B34253C}"/>
                </a:ext>
              </a:extLst>
            </p:cNvPr>
            <p:cNvSpPr txBox="1"/>
            <p:nvPr/>
          </p:nvSpPr>
          <p:spPr>
            <a:xfrm>
              <a:off x="3094485" y="3863467"/>
              <a:ext cx="17956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rachis dry weight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898FEC4-2B0D-DE4C-7872-0B51A6FE5D14}"/>
                </a:ext>
              </a:extLst>
            </p:cNvPr>
            <p:cNvSpPr txBox="1"/>
            <p:nvPr/>
          </p:nvSpPr>
          <p:spPr>
            <a:xfrm>
              <a:off x="5640274" y="3863467"/>
              <a:ext cx="17091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anicle number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D0BCADC1-A744-6D4F-F5C5-B2F0F7A75D18}"/>
              </a:ext>
            </a:extLst>
          </p:cNvPr>
          <p:cNvSpPr txBox="1"/>
          <p:nvPr/>
        </p:nvSpPr>
        <p:spPr>
          <a:xfrm>
            <a:off x="1365582" y="1866238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D933D1-BCEB-E517-4B46-737F342CB5B5}"/>
              </a:ext>
            </a:extLst>
          </p:cNvPr>
          <p:cNvSpPr txBox="1"/>
          <p:nvPr/>
        </p:nvSpPr>
        <p:spPr>
          <a:xfrm>
            <a:off x="3992327" y="1866238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4A04438-08D6-3EA0-08E1-216E1B4E9C6F}"/>
              </a:ext>
            </a:extLst>
          </p:cNvPr>
          <p:cNvSpPr txBox="1"/>
          <p:nvPr/>
        </p:nvSpPr>
        <p:spPr>
          <a:xfrm>
            <a:off x="6467194" y="1866238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B2A7139-896F-C889-F8BE-5377D5730634}"/>
              </a:ext>
            </a:extLst>
          </p:cNvPr>
          <p:cNvSpPr txBox="1"/>
          <p:nvPr/>
        </p:nvSpPr>
        <p:spPr>
          <a:xfrm>
            <a:off x="1365582" y="543359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278AF6E-021E-90EF-2091-479EA3048D63}"/>
              </a:ext>
            </a:extLst>
          </p:cNvPr>
          <p:cNvSpPr txBox="1"/>
          <p:nvPr/>
        </p:nvSpPr>
        <p:spPr>
          <a:xfrm>
            <a:off x="3988386" y="543359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444A09E-2931-3C11-D563-D4D1F0517A74}"/>
              </a:ext>
            </a:extLst>
          </p:cNvPr>
          <p:cNvSpPr txBox="1"/>
          <p:nvPr/>
        </p:nvSpPr>
        <p:spPr>
          <a:xfrm>
            <a:off x="6471950" y="543359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1751239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44007487-5E2C-277E-12FE-02CCFBA9BAF4}"/>
              </a:ext>
            </a:extLst>
          </p:cNvPr>
          <p:cNvSpPr txBox="1"/>
          <p:nvPr/>
        </p:nvSpPr>
        <p:spPr>
          <a:xfrm>
            <a:off x="50801" y="9650326"/>
            <a:ext cx="7653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4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requency distributions of means of 11 morphological traits in Japonica accessions.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947233A6-6765-369D-57FC-AFEE53DACF34}"/>
              </a:ext>
            </a:extLst>
          </p:cNvPr>
          <p:cNvGrpSpPr/>
          <p:nvPr/>
        </p:nvGrpSpPr>
        <p:grpSpPr>
          <a:xfrm>
            <a:off x="250951" y="48038"/>
            <a:ext cx="7244147" cy="9529753"/>
            <a:chOff x="250951" y="48038"/>
            <a:chExt cx="7244147" cy="952975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A17D50A-ADA8-5E57-64F1-F215F4E8B6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6453"/>
            <a:stretch/>
          </p:blipFill>
          <p:spPr>
            <a:xfrm>
              <a:off x="5612908" y="3546162"/>
              <a:ext cx="1787319" cy="2757169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26C6E56-DDFB-3E4B-5702-642D6C13BD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6453"/>
            <a:stretch/>
          </p:blipFill>
          <p:spPr>
            <a:xfrm>
              <a:off x="250951" y="6649092"/>
              <a:ext cx="1787319" cy="2757169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1400E0CB-BC24-8DFC-8AAC-0B339884B9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6453"/>
            <a:stretch/>
          </p:blipFill>
          <p:spPr>
            <a:xfrm>
              <a:off x="3825589" y="6649092"/>
              <a:ext cx="1787319" cy="2757169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7BC9712-28FC-6BCA-5F7E-EFFBF4A8FA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6453"/>
            <a:stretch/>
          </p:blipFill>
          <p:spPr>
            <a:xfrm>
              <a:off x="2033610" y="3546162"/>
              <a:ext cx="1787319" cy="2757169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A35B53F-A1C8-F7EF-6ADD-59B3286E82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b="6453"/>
            <a:stretch/>
          </p:blipFill>
          <p:spPr>
            <a:xfrm>
              <a:off x="250951" y="3515470"/>
              <a:ext cx="1787319" cy="2757169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56741F71-0C73-2BE2-B90A-AEF2E41F3F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b="6453"/>
            <a:stretch/>
          </p:blipFill>
          <p:spPr>
            <a:xfrm>
              <a:off x="5612908" y="443230"/>
              <a:ext cx="1787319" cy="2757169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4E3537C9-EDCA-28EB-74D0-DC013C5C2A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b="6452"/>
            <a:stretch/>
          </p:blipFill>
          <p:spPr>
            <a:xfrm>
              <a:off x="250951" y="443231"/>
              <a:ext cx="1787319" cy="2757169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DAE9A899-E8BE-0687-330A-2992A8EAA4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b="6453"/>
            <a:stretch/>
          </p:blipFill>
          <p:spPr>
            <a:xfrm>
              <a:off x="3820929" y="3546162"/>
              <a:ext cx="1787319" cy="2757169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772C3C20-089C-526E-20DE-B521B465C7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b="6453"/>
            <a:stretch/>
          </p:blipFill>
          <p:spPr>
            <a:xfrm>
              <a:off x="3825589" y="443231"/>
              <a:ext cx="1787319" cy="2757169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78A1C9A0-0D4E-6080-F65B-E47AF4D141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b="6453"/>
            <a:stretch/>
          </p:blipFill>
          <p:spPr>
            <a:xfrm>
              <a:off x="2033609" y="6649092"/>
              <a:ext cx="1787319" cy="2757169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149BA2EE-BA44-8B32-5183-E0D2AC8B30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b="6453"/>
            <a:stretch/>
          </p:blipFill>
          <p:spPr>
            <a:xfrm>
              <a:off x="2038270" y="443231"/>
              <a:ext cx="1787319" cy="2757169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008B2A5B-4CD7-7FDE-2271-97899F42A893}"/>
                </a:ext>
              </a:extLst>
            </p:cNvPr>
            <p:cNvSpPr/>
            <p:nvPr/>
          </p:nvSpPr>
          <p:spPr>
            <a:xfrm>
              <a:off x="6987791" y="295161"/>
              <a:ext cx="102409" cy="106948"/>
            </a:xfrm>
            <a:prstGeom prst="rect">
              <a:avLst/>
            </a:prstGeom>
            <a:solidFill>
              <a:srgbClr val="F3B59D"/>
            </a:solidFill>
            <a:ln>
              <a:solidFill>
                <a:srgbClr val="EF9D7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BE9E2EC2-AF23-DFE9-07C5-5683ABF20865}"/>
                </a:ext>
              </a:extLst>
            </p:cNvPr>
            <p:cNvSpPr/>
            <p:nvPr/>
          </p:nvSpPr>
          <p:spPr>
            <a:xfrm>
              <a:off x="6990959" y="109134"/>
              <a:ext cx="99241" cy="104479"/>
            </a:xfrm>
            <a:prstGeom prst="rect">
              <a:avLst/>
            </a:prstGeom>
            <a:solidFill>
              <a:srgbClr val="7C9AF4"/>
            </a:solidFill>
            <a:ln>
              <a:solidFill>
                <a:srgbClr val="5178E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26647E5-D5B4-563F-C08D-D4E0A80CAB71}"/>
                </a:ext>
              </a:extLst>
            </p:cNvPr>
            <p:cNvSpPr txBox="1"/>
            <p:nvPr/>
          </p:nvSpPr>
          <p:spPr>
            <a:xfrm>
              <a:off x="7038994" y="48038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et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E409EC4-A517-085A-6809-00ECA59D003D}"/>
                </a:ext>
              </a:extLst>
            </p:cNvPr>
            <p:cNvSpPr txBox="1"/>
            <p:nvPr/>
          </p:nvSpPr>
          <p:spPr>
            <a:xfrm>
              <a:off x="7038995" y="240913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ry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4C3968D-63B6-7B69-4BDC-810DB9A4E796}"/>
                </a:ext>
              </a:extLst>
            </p:cNvPr>
            <p:cNvSpPr txBox="1"/>
            <p:nvPr/>
          </p:nvSpPr>
          <p:spPr>
            <a:xfrm>
              <a:off x="6057787" y="3155187"/>
              <a:ext cx="1226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anicle maturatio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0D737FD-6D12-EED7-A1D8-1B53D4F1AE92}"/>
                </a:ext>
              </a:extLst>
            </p:cNvPr>
            <p:cNvSpPr txBox="1"/>
            <p:nvPr/>
          </p:nvSpPr>
          <p:spPr>
            <a:xfrm>
              <a:off x="4316498" y="3157361"/>
              <a:ext cx="11128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hoot dry weight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C3EBD2C-2A59-3ACF-CFFD-5F2862AC0148}"/>
                </a:ext>
              </a:extLst>
            </p:cNvPr>
            <p:cNvSpPr txBox="1"/>
            <p:nvPr/>
          </p:nvSpPr>
          <p:spPr>
            <a:xfrm>
              <a:off x="2653033" y="3157949"/>
              <a:ext cx="8883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tiller number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D7FB261-4070-999B-02E5-D75B8D41E187}"/>
                </a:ext>
              </a:extLst>
            </p:cNvPr>
            <p:cNvSpPr txBox="1"/>
            <p:nvPr/>
          </p:nvSpPr>
          <p:spPr>
            <a:xfrm>
              <a:off x="897863" y="3151526"/>
              <a:ext cx="8418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lant height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D6241B5-0E16-72B6-7EA3-2FCC1C213959}"/>
                </a:ext>
              </a:extLst>
            </p:cNvPr>
            <p:cNvSpPr txBox="1"/>
            <p:nvPr/>
          </p:nvSpPr>
          <p:spPr>
            <a:xfrm>
              <a:off x="790461" y="6241539"/>
              <a:ext cx="10567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anicle number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E5D8C29-F344-C8EF-DD22-939709C34F7E}"/>
                </a:ext>
              </a:extLst>
            </p:cNvPr>
            <p:cNvSpPr txBox="1"/>
            <p:nvPr/>
          </p:nvSpPr>
          <p:spPr>
            <a:xfrm>
              <a:off x="2599874" y="6245887"/>
              <a:ext cx="9701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anicle length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0CEBA53-3155-35B8-B24B-DC8419EBDDF1}"/>
                </a:ext>
              </a:extLst>
            </p:cNvPr>
            <p:cNvSpPr txBox="1"/>
            <p:nvPr/>
          </p:nvSpPr>
          <p:spPr>
            <a:xfrm>
              <a:off x="4302528" y="6251725"/>
              <a:ext cx="1143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achis dry weight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A45D94E-8953-A814-D4CA-D18ED6CC8F78}"/>
                </a:ext>
              </a:extLst>
            </p:cNvPr>
            <p:cNvSpPr txBox="1"/>
            <p:nvPr/>
          </p:nvSpPr>
          <p:spPr>
            <a:xfrm>
              <a:off x="5848493" y="6241539"/>
              <a:ext cx="16466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rimary panicle branching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E7B6D65-7CBE-1F90-4A21-6555A57307BB}"/>
                </a:ext>
              </a:extLst>
            </p:cNvPr>
            <p:cNvSpPr txBox="1"/>
            <p:nvPr/>
          </p:nvSpPr>
          <p:spPr>
            <a:xfrm>
              <a:off x="382192" y="9331570"/>
              <a:ext cx="18069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econdary panicle branching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541A76E-4BF1-9421-817A-669C1814B0D3}"/>
                </a:ext>
              </a:extLst>
            </p:cNvPr>
            <p:cNvSpPr txBox="1"/>
            <p:nvPr/>
          </p:nvSpPr>
          <p:spPr>
            <a:xfrm>
              <a:off x="2542894" y="9331570"/>
              <a:ext cx="1085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pikelet number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B49F683-9B6C-4236-2FEE-9C70ED7A0EA0}"/>
                </a:ext>
              </a:extLst>
            </p:cNvPr>
            <p:cNvSpPr txBox="1"/>
            <p:nvPr/>
          </p:nvSpPr>
          <p:spPr>
            <a:xfrm>
              <a:off x="4317535" y="9331569"/>
              <a:ext cx="11272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00-grain weight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07B69045-C3EC-0FCB-BD43-3BBDD30A5015}"/>
              </a:ext>
            </a:extLst>
          </p:cNvPr>
          <p:cNvSpPr txBox="1"/>
          <p:nvPr/>
        </p:nvSpPr>
        <p:spPr>
          <a:xfrm>
            <a:off x="1602543" y="652139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DF39DAD-EF5C-BB7F-7179-920327442BFF}"/>
              </a:ext>
            </a:extLst>
          </p:cNvPr>
          <p:cNvSpPr txBox="1"/>
          <p:nvPr/>
        </p:nvSpPr>
        <p:spPr>
          <a:xfrm>
            <a:off x="3385530" y="652139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D2BE1BC-27CA-CEAD-EE10-75476E589428}"/>
              </a:ext>
            </a:extLst>
          </p:cNvPr>
          <p:cNvSpPr txBox="1"/>
          <p:nvPr/>
        </p:nvSpPr>
        <p:spPr>
          <a:xfrm>
            <a:off x="5179545" y="652139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BD6DE60-DEBC-6588-D41D-E1D8673CA7F3}"/>
              </a:ext>
            </a:extLst>
          </p:cNvPr>
          <p:cNvSpPr txBox="1"/>
          <p:nvPr/>
        </p:nvSpPr>
        <p:spPr>
          <a:xfrm>
            <a:off x="6960168" y="652139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701D69C-8ADD-D95D-4FCA-F4BC190DF093}"/>
              </a:ext>
            </a:extLst>
          </p:cNvPr>
          <p:cNvSpPr txBox="1"/>
          <p:nvPr/>
        </p:nvSpPr>
        <p:spPr>
          <a:xfrm>
            <a:off x="1602543" y="376988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D45215C-8194-9D29-6FB2-EF90065DA98B}"/>
              </a:ext>
            </a:extLst>
          </p:cNvPr>
          <p:cNvSpPr txBox="1"/>
          <p:nvPr/>
        </p:nvSpPr>
        <p:spPr>
          <a:xfrm>
            <a:off x="3382732" y="376988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D55D22D-E6C9-27BB-C2A0-21995A4BA559}"/>
              </a:ext>
            </a:extLst>
          </p:cNvPr>
          <p:cNvSpPr txBox="1"/>
          <p:nvPr/>
        </p:nvSpPr>
        <p:spPr>
          <a:xfrm>
            <a:off x="5179545" y="376988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01C2177-23D2-9B36-311E-593BF1B68AE2}"/>
              </a:ext>
            </a:extLst>
          </p:cNvPr>
          <p:cNvSpPr txBox="1"/>
          <p:nvPr/>
        </p:nvSpPr>
        <p:spPr>
          <a:xfrm>
            <a:off x="6960168" y="376988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A35302D-EA10-57FF-C760-D9C51DB4B75B}"/>
              </a:ext>
            </a:extLst>
          </p:cNvPr>
          <p:cNvSpPr txBox="1"/>
          <p:nvPr/>
        </p:nvSpPr>
        <p:spPr>
          <a:xfrm>
            <a:off x="1606763" y="6835318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659346F-7BFF-19C3-8375-F22C5BB6B68B}"/>
              </a:ext>
            </a:extLst>
          </p:cNvPr>
          <p:cNvSpPr txBox="1"/>
          <p:nvPr/>
        </p:nvSpPr>
        <p:spPr>
          <a:xfrm>
            <a:off x="3383999" y="6835318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2567CCF-B431-4F43-1A15-2494851F5144}"/>
              </a:ext>
            </a:extLst>
          </p:cNvPr>
          <p:cNvSpPr txBox="1"/>
          <p:nvPr/>
        </p:nvSpPr>
        <p:spPr>
          <a:xfrm>
            <a:off x="5179545" y="6835318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4719472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6A5114B-B51A-0996-9C2C-A76C41B9BAF6}"/>
              </a:ext>
            </a:extLst>
          </p:cNvPr>
          <p:cNvSpPr txBox="1"/>
          <p:nvPr/>
        </p:nvSpPr>
        <p:spPr>
          <a:xfrm>
            <a:off x="215719" y="9440100"/>
            <a:ext cx="716824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5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requency distributions of 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Levene’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tatistic (LS, canalization) for variation in 11 morphological traits in Japonica accessions.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3E984FFA-4CC0-189A-165E-9E8DCB110962}"/>
              </a:ext>
            </a:extLst>
          </p:cNvPr>
          <p:cNvGrpSpPr/>
          <p:nvPr/>
        </p:nvGrpSpPr>
        <p:grpSpPr>
          <a:xfrm>
            <a:off x="60465" y="48038"/>
            <a:ext cx="7699220" cy="9309622"/>
            <a:chOff x="60465" y="48038"/>
            <a:chExt cx="7699220" cy="930962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2455D35-D46E-9B2E-C871-2E08E3C391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5060"/>
            <a:stretch/>
          </p:blipFill>
          <p:spPr>
            <a:xfrm>
              <a:off x="5710774" y="3459451"/>
              <a:ext cx="1787319" cy="266825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AE02ECA-600F-A26D-5447-78CFC039D1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5061"/>
            <a:stretch/>
          </p:blipFill>
          <p:spPr>
            <a:xfrm>
              <a:off x="176097" y="6449407"/>
              <a:ext cx="1787319" cy="2668256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CF9F3A3D-504B-9D99-B138-C12E65AAE8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4800"/>
            <a:stretch/>
          </p:blipFill>
          <p:spPr>
            <a:xfrm>
              <a:off x="3842012" y="6444553"/>
              <a:ext cx="1782403" cy="2668256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565E3D9-8F30-27F0-D979-0F4B591BB9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5653"/>
            <a:stretch/>
          </p:blipFill>
          <p:spPr>
            <a:xfrm>
              <a:off x="1968334" y="3466447"/>
              <a:ext cx="1782402" cy="2644328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6AFBA66B-4847-05E3-1BFA-B6394B0393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b="5061"/>
            <a:stretch/>
          </p:blipFill>
          <p:spPr>
            <a:xfrm>
              <a:off x="176098" y="3442518"/>
              <a:ext cx="1787319" cy="2668256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BE5C3673-B39D-7778-253A-6B2E8DBD20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b="5061"/>
            <a:stretch/>
          </p:blipFill>
          <p:spPr>
            <a:xfrm>
              <a:off x="5710775" y="464411"/>
              <a:ext cx="1787319" cy="2668256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93A8132C-4AF0-18C6-3694-50B620AC8F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b="5061"/>
            <a:stretch/>
          </p:blipFill>
          <p:spPr>
            <a:xfrm>
              <a:off x="89738" y="464411"/>
              <a:ext cx="1787319" cy="2668256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18D90162-D405-A464-B357-0829EBAD61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b="5653"/>
            <a:stretch/>
          </p:blipFill>
          <p:spPr>
            <a:xfrm>
              <a:off x="3842013" y="3466446"/>
              <a:ext cx="1782402" cy="2644328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301AA8FF-7008-DC87-1179-32B6A1AE5E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b="5061"/>
            <a:stretch/>
          </p:blipFill>
          <p:spPr>
            <a:xfrm>
              <a:off x="3837096" y="464411"/>
              <a:ext cx="1787319" cy="2668256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D0406DB0-AFFE-BC20-EB96-075111AE15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b="4799"/>
            <a:stretch/>
          </p:blipFill>
          <p:spPr>
            <a:xfrm>
              <a:off x="1963416" y="6444553"/>
              <a:ext cx="1782402" cy="2668257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EC94BC1C-CE97-C772-0FC3-EF6495C5A9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b="5061"/>
            <a:stretch/>
          </p:blipFill>
          <p:spPr>
            <a:xfrm>
              <a:off x="1963417" y="464411"/>
              <a:ext cx="1787319" cy="2668256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0FA2C27F-30AA-E3E5-3F81-C52C19F78BE9}"/>
                </a:ext>
              </a:extLst>
            </p:cNvPr>
            <p:cNvSpPr/>
            <p:nvPr/>
          </p:nvSpPr>
          <p:spPr>
            <a:xfrm>
              <a:off x="6852327" y="295161"/>
              <a:ext cx="102409" cy="106948"/>
            </a:xfrm>
            <a:prstGeom prst="rect">
              <a:avLst/>
            </a:prstGeom>
            <a:solidFill>
              <a:srgbClr val="F3B59D"/>
            </a:solidFill>
            <a:ln>
              <a:solidFill>
                <a:srgbClr val="EF9D7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0CCEE15E-2A8C-53EA-FE9B-16ED6CD994F1}"/>
                </a:ext>
              </a:extLst>
            </p:cNvPr>
            <p:cNvSpPr/>
            <p:nvPr/>
          </p:nvSpPr>
          <p:spPr>
            <a:xfrm>
              <a:off x="6855495" y="109134"/>
              <a:ext cx="99241" cy="104479"/>
            </a:xfrm>
            <a:prstGeom prst="rect">
              <a:avLst/>
            </a:prstGeom>
            <a:solidFill>
              <a:srgbClr val="7C9AF4"/>
            </a:solidFill>
            <a:ln>
              <a:solidFill>
                <a:srgbClr val="5178E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63E8EFE-7971-64B4-1D30-FEA5DEDC2D18}"/>
                </a:ext>
              </a:extLst>
            </p:cNvPr>
            <p:cNvSpPr txBox="1"/>
            <p:nvPr/>
          </p:nvSpPr>
          <p:spPr>
            <a:xfrm>
              <a:off x="6903530" y="48038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et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0D18D9C-168E-1678-60FD-75CA75976373}"/>
                </a:ext>
              </a:extLst>
            </p:cNvPr>
            <p:cNvSpPr txBox="1"/>
            <p:nvPr/>
          </p:nvSpPr>
          <p:spPr>
            <a:xfrm>
              <a:off x="6903531" y="240913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ry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4843EB6-58D9-D190-7FA8-65F99BC30DC7}"/>
                </a:ext>
              </a:extLst>
            </p:cNvPr>
            <p:cNvSpPr txBox="1"/>
            <p:nvPr/>
          </p:nvSpPr>
          <p:spPr>
            <a:xfrm>
              <a:off x="5922321" y="3121321"/>
              <a:ext cx="16097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. in panicle maturation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1E4CCA1-2866-4D4D-A6B0-A85715B1807F}"/>
                </a:ext>
              </a:extLst>
            </p:cNvPr>
            <p:cNvSpPr txBox="1"/>
            <p:nvPr/>
          </p:nvSpPr>
          <p:spPr>
            <a:xfrm>
              <a:off x="3960901" y="3123495"/>
              <a:ext cx="17652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shoot dry weight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D5F01A4-F9BC-E1C7-3F23-E0962E20F27D}"/>
                </a:ext>
              </a:extLst>
            </p:cNvPr>
            <p:cNvSpPr txBox="1"/>
            <p:nvPr/>
          </p:nvSpPr>
          <p:spPr>
            <a:xfrm>
              <a:off x="2195834" y="3124083"/>
              <a:ext cx="15408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tiller number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5944554-680B-D331-E20A-18182B84C921}"/>
                </a:ext>
              </a:extLst>
            </p:cNvPr>
            <p:cNvSpPr txBox="1"/>
            <p:nvPr/>
          </p:nvSpPr>
          <p:spPr>
            <a:xfrm>
              <a:off x="356002" y="3117660"/>
              <a:ext cx="14943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lant height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EAEEF46-64DE-4C89-07C8-A953982C9CE7}"/>
                </a:ext>
              </a:extLst>
            </p:cNvPr>
            <p:cNvSpPr txBox="1"/>
            <p:nvPr/>
          </p:nvSpPr>
          <p:spPr>
            <a:xfrm>
              <a:off x="333266" y="6089140"/>
              <a:ext cx="17091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anicle number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3F46A4E-EA14-1B0A-DA73-919D6C7F95BC}"/>
                </a:ext>
              </a:extLst>
            </p:cNvPr>
            <p:cNvSpPr txBox="1"/>
            <p:nvPr/>
          </p:nvSpPr>
          <p:spPr>
            <a:xfrm>
              <a:off x="2159614" y="6093488"/>
              <a:ext cx="16225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anicle length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9B3804C-BEBA-6167-0AA8-D2B072F4DA8A}"/>
                </a:ext>
              </a:extLst>
            </p:cNvPr>
            <p:cNvSpPr txBox="1"/>
            <p:nvPr/>
          </p:nvSpPr>
          <p:spPr>
            <a:xfrm>
              <a:off x="3946934" y="6099326"/>
              <a:ext cx="17956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rachis dry weight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D32EC7E-717F-0D6F-8E82-7A056B5D4397}"/>
                </a:ext>
              </a:extLst>
            </p:cNvPr>
            <p:cNvSpPr txBox="1"/>
            <p:nvPr/>
          </p:nvSpPr>
          <p:spPr>
            <a:xfrm>
              <a:off x="5729962" y="6089140"/>
              <a:ext cx="20297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. in primary panicle branching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C9599D0-7466-410B-77F2-44210129A07A}"/>
                </a:ext>
              </a:extLst>
            </p:cNvPr>
            <p:cNvSpPr txBox="1"/>
            <p:nvPr/>
          </p:nvSpPr>
          <p:spPr>
            <a:xfrm>
              <a:off x="60465" y="9111439"/>
              <a:ext cx="21900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. in secondary panicle branching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16AF119-4F64-507D-B5D2-07940316E2D7}"/>
                </a:ext>
              </a:extLst>
            </p:cNvPr>
            <p:cNvSpPr txBox="1"/>
            <p:nvPr/>
          </p:nvSpPr>
          <p:spPr>
            <a:xfrm>
              <a:off x="2102630" y="9111439"/>
              <a:ext cx="17379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spikelet number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E0CF487-41EA-1458-6CD4-B853999F1DEB}"/>
                </a:ext>
              </a:extLst>
            </p:cNvPr>
            <p:cNvSpPr txBox="1"/>
            <p:nvPr/>
          </p:nvSpPr>
          <p:spPr>
            <a:xfrm>
              <a:off x="3961935" y="9111438"/>
              <a:ext cx="17796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100-grain weight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581B5B0A-AE96-9A5C-F96D-D821F7983B07}"/>
              </a:ext>
            </a:extLst>
          </p:cNvPr>
          <p:cNvSpPr txBox="1"/>
          <p:nvPr/>
        </p:nvSpPr>
        <p:spPr>
          <a:xfrm>
            <a:off x="983397" y="142170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38C1A0C-9923-27C9-B264-420AE0305C68}"/>
              </a:ext>
            </a:extLst>
          </p:cNvPr>
          <p:cNvSpPr txBox="1"/>
          <p:nvPr/>
        </p:nvSpPr>
        <p:spPr>
          <a:xfrm>
            <a:off x="983397" y="448991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06BD873-02D2-8EAB-768A-CF97EA8FA3FD}"/>
              </a:ext>
            </a:extLst>
          </p:cNvPr>
          <p:cNvSpPr txBox="1"/>
          <p:nvPr/>
        </p:nvSpPr>
        <p:spPr>
          <a:xfrm>
            <a:off x="2821219" y="448991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09BBF42-060F-B605-8EE8-7AD6F6163741}"/>
              </a:ext>
            </a:extLst>
          </p:cNvPr>
          <p:cNvSpPr txBox="1"/>
          <p:nvPr/>
        </p:nvSpPr>
        <p:spPr>
          <a:xfrm>
            <a:off x="4851762" y="4488593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E546CD5-F4D4-9956-ACDA-C6A92CE64DD7}"/>
              </a:ext>
            </a:extLst>
          </p:cNvPr>
          <p:cNvSpPr txBox="1"/>
          <p:nvPr/>
        </p:nvSpPr>
        <p:spPr>
          <a:xfrm>
            <a:off x="6594065" y="448667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74D28FF-65CB-373C-BBBF-5408677095AF}"/>
              </a:ext>
            </a:extLst>
          </p:cNvPr>
          <p:cNvSpPr txBox="1"/>
          <p:nvPr/>
        </p:nvSpPr>
        <p:spPr>
          <a:xfrm>
            <a:off x="4851762" y="142170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D48642B-14B1-DC2E-964A-8C4BE3470348}"/>
              </a:ext>
            </a:extLst>
          </p:cNvPr>
          <p:cNvSpPr txBox="1"/>
          <p:nvPr/>
        </p:nvSpPr>
        <p:spPr>
          <a:xfrm>
            <a:off x="6594065" y="142170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0376DFC-27EC-8E94-B6AD-B295E968C04F}"/>
              </a:ext>
            </a:extLst>
          </p:cNvPr>
          <p:cNvSpPr txBox="1"/>
          <p:nvPr/>
        </p:nvSpPr>
        <p:spPr>
          <a:xfrm>
            <a:off x="983397" y="7518399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3FC7EEC-231F-F850-8149-732A9FE5B9DC}"/>
              </a:ext>
            </a:extLst>
          </p:cNvPr>
          <p:cNvSpPr txBox="1"/>
          <p:nvPr/>
        </p:nvSpPr>
        <p:spPr>
          <a:xfrm>
            <a:off x="2829020" y="7518399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33EFB91-2F1C-FB1E-F249-D2E8BC5BB13A}"/>
              </a:ext>
            </a:extLst>
          </p:cNvPr>
          <p:cNvSpPr txBox="1"/>
          <p:nvPr/>
        </p:nvSpPr>
        <p:spPr>
          <a:xfrm>
            <a:off x="4851762" y="7518399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0121801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DC6C7FE-DF60-37C3-9636-C1B723C528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9026125"/>
              </p:ext>
            </p:extLst>
          </p:nvPr>
        </p:nvGraphicFramePr>
        <p:xfrm>
          <a:off x="203199" y="1889332"/>
          <a:ext cx="7399867" cy="520430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2015068">
                  <a:extLst>
                    <a:ext uri="{9D8B030D-6E8A-4147-A177-3AD203B41FA5}">
                      <a16:colId xmlns:a16="http://schemas.microsoft.com/office/drawing/2014/main" val="579231485"/>
                    </a:ext>
                  </a:extLst>
                </a:gridCol>
                <a:gridCol w="1303866">
                  <a:extLst>
                    <a:ext uri="{9D8B030D-6E8A-4147-A177-3AD203B41FA5}">
                      <a16:colId xmlns:a16="http://schemas.microsoft.com/office/drawing/2014/main" val="512505218"/>
                    </a:ext>
                  </a:extLst>
                </a:gridCol>
                <a:gridCol w="1473607">
                  <a:extLst>
                    <a:ext uri="{9D8B030D-6E8A-4147-A177-3AD203B41FA5}">
                      <a16:colId xmlns:a16="http://schemas.microsoft.com/office/drawing/2014/main" val="3670654123"/>
                    </a:ext>
                  </a:extLst>
                </a:gridCol>
                <a:gridCol w="1167993">
                  <a:extLst>
                    <a:ext uri="{9D8B030D-6E8A-4147-A177-3AD203B41FA5}">
                      <a16:colId xmlns:a16="http://schemas.microsoft.com/office/drawing/2014/main" val="35199478"/>
                    </a:ext>
                  </a:extLst>
                </a:gridCol>
                <a:gridCol w="1439333">
                  <a:extLst>
                    <a:ext uri="{9D8B030D-6E8A-4147-A177-3AD203B41FA5}">
                      <a16:colId xmlns:a16="http://schemas.microsoft.com/office/drawing/2014/main" val="3650922562"/>
                    </a:ext>
                  </a:extLst>
                </a:gridCol>
              </a:tblGrid>
              <a:tr h="364982">
                <a:tc>
                  <a:txBody>
                    <a:bodyPr/>
                    <a:lstStyle/>
                    <a:p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aseline="0" dirty="0">
                          <a:solidFill>
                            <a:srgbClr val="5178EE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t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aseline="0" dirty="0">
                          <a:solidFill>
                            <a:srgbClr val="EF9D7D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y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aseline="0" dirty="0">
                          <a:solidFill>
                            <a:srgbClr val="EF9D7D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y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2219995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alizatio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alizatio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3532144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 height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15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042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65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356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5234641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ller number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96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89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7400228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oot dry weight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0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6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8062304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icle maturation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4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58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9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92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4421261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icle number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09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88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2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72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3121417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icle length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1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09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4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9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6043628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chis dry weight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6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34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01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678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3402544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600" b="1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panicle branch number</a:t>
                      </a:r>
                      <a:endParaRPr 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46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0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7060531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ondary panicle branch number</a:t>
                      </a:r>
                      <a:endParaRPr 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5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76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371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5709896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ikelet number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7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01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77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1056215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 grain weight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89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4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31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594969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39CCD2F-94F3-BC51-20F7-720B1E6F8D74}"/>
              </a:ext>
            </a:extLst>
          </p:cNvPr>
          <p:cNvSpPr txBox="1"/>
          <p:nvPr/>
        </p:nvSpPr>
        <p:spPr>
          <a:xfrm>
            <a:off x="456993" y="914119"/>
            <a:ext cx="68584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ithin-environment broad-sens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heritabilitie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(H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for trait means and canalization in the Indica population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B7A499A-FC6C-EDFF-3A6D-F02B7CF35F83}"/>
              </a:ext>
            </a:extLst>
          </p:cNvPr>
          <p:cNvSpPr txBox="1"/>
          <p:nvPr/>
        </p:nvSpPr>
        <p:spPr>
          <a:xfrm>
            <a:off x="456993" y="7268625"/>
            <a:ext cx="326834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u="none" strike="noStrike" dirty="0">
                <a:solidFill>
                  <a:srgbClr val="000000"/>
                </a:solidFill>
                <a:effectLst/>
              </a:rPr>
              <a:t>Significant H</a:t>
            </a:r>
            <a:r>
              <a:rPr lang="en-US" sz="1400" u="none" strike="noStrike" baseline="30000" dirty="0">
                <a:solidFill>
                  <a:srgbClr val="000000"/>
                </a:solidFill>
                <a:effectLst/>
              </a:rPr>
              <a:t>2</a:t>
            </a:r>
            <a:r>
              <a:rPr lang="en-US" sz="1400" u="none" strike="noStrike" dirty="0">
                <a:solidFill>
                  <a:srgbClr val="000000"/>
                </a:solidFill>
                <a:effectLst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ues are</a:t>
            </a:r>
            <a:r>
              <a:rPr lang="en-US" sz="1400" dirty="0">
                <a:solidFill>
                  <a:srgbClr val="000000"/>
                </a:solidFill>
              </a:rPr>
              <a:t> underlined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2728630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6469E86-D1FF-5E88-59E3-79BF442353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7813107"/>
              </p:ext>
            </p:extLst>
          </p:nvPr>
        </p:nvGraphicFramePr>
        <p:xfrm>
          <a:off x="118533" y="1845087"/>
          <a:ext cx="7535334" cy="502142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507067">
                  <a:extLst>
                    <a:ext uri="{9D8B030D-6E8A-4147-A177-3AD203B41FA5}">
                      <a16:colId xmlns:a16="http://schemas.microsoft.com/office/drawing/2014/main" val="579231485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973095149"/>
                    </a:ext>
                  </a:extLst>
                </a:gridCol>
                <a:gridCol w="1100667">
                  <a:extLst>
                    <a:ext uri="{9D8B030D-6E8A-4147-A177-3AD203B41FA5}">
                      <a16:colId xmlns:a16="http://schemas.microsoft.com/office/drawing/2014/main" val="93870705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512505218"/>
                    </a:ext>
                  </a:extLst>
                </a:gridCol>
                <a:gridCol w="1084706">
                  <a:extLst>
                    <a:ext uri="{9D8B030D-6E8A-4147-A177-3AD203B41FA5}">
                      <a16:colId xmlns:a16="http://schemas.microsoft.com/office/drawing/2014/main" val="3670654123"/>
                    </a:ext>
                  </a:extLst>
                </a:gridCol>
                <a:gridCol w="828760">
                  <a:extLst>
                    <a:ext uri="{9D8B030D-6E8A-4147-A177-3AD203B41FA5}">
                      <a16:colId xmlns:a16="http://schemas.microsoft.com/office/drawing/2014/main" val="35199478"/>
                    </a:ext>
                  </a:extLst>
                </a:gridCol>
                <a:gridCol w="1134534">
                  <a:extLst>
                    <a:ext uri="{9D8B030D-6E8A-4147-A177-3AD203B41FA5}">
                      <a16:colId xmlns:a16="http://schemas.microsoft.com/office/drawing/2014/main" val="3650922562"/>
                    </a:ext>
                  </a:extLst>
                </a:gridCol>
              </a:tblGrid>
              <a:tr h="364982">
                <a:tc>
                  <a:txBody>
                    <a:bodyPr/>
                    <a:lstStyle/>
                    <a:p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600" dirty="0" err="1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xE</a:t>
                      </a:r>
                      <a:endParaRPr lang="en-US" sz="1600" baseline="30000" dirty="0">
                        <a:solidFill>
                          <a:schemeClr val="tx1">
                            <a:lumMod val="85000"/>
                            <a:lumOff val="1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aseline="0" dirty="0">
                          <a:solidFill>
                            <a:srgbClr val="5178EE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t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aseline="0" dirty="0">
                          <a:solidFill>
                            <a:srgbClr val="EF9D7D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y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aseline="0" dirty="0">
                          <a:solidFill>
                            <a:srgbClr val="EF9D7D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y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2219995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alizatio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alizatio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alizatio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3532144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 height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884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201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245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2942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808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439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5234641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ller number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745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96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8145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361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46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655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7400228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oot dry weight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7402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851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645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8062304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icle maturation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7795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155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66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8861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848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568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2966381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icle number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584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269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5779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096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3121417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icle length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9046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145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178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608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96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50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6043628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chis dry weight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4786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376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166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3402544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200" b="1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panicle branches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840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919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651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491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6638058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ondary panicle branches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754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Arial" panose="020B0604020202020204" pitchFamily="34" charset="0"/>
                        </a:rPr>
                        <a:t>0.0000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21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19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861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2362001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ikelet number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632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283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820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991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765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1056215"/>
                  </a:ext>
                </a:extLst>
              </a:tr>
              <a:tr h="364982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-grain weight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7227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309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6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0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5224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sng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5239</a:t>
                      </a: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594969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66AB1D7-8E94-3988-8225-EF54E3580A22}"/>
              </a:ext>
            </a:extLst>
          </p:cNvPr>
          <p:cNvSpPr txBox="1"/>
          <p:nvPr/>
        </p:nvSpPr>
        <p:spPr>
          <a:xfrm>
            <a:off x="293912" y="861688"/>
            <a:ext cx="716824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2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road-sens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heritabilitie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(H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for trait means and canalization in the Japonica population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A7C80B3-3E69-14B4-5629-8C34A310EEBC}"/>
              </a:ext>
            </a:extLst>
          </p:cNvPr>
          <p:cNvSpPr txBox="1"/>
          <p:nvPr/>
        </p:nvSpPr>
        <p:spPr>
          <a:xfrm>
            <a:off x="310246" y="6926691"/>
            <a:ext cx="326834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u="none" strike="noStrike" dirty="0">
                <a:solidFill>
                  <a:srgbClr val="000000"/>
                </a:solidFill>
                <a:effectLst/>
              </a:rPr>
              <a:t>Significant H</a:t>
            </a:r>
            <a:r>
              <a:rPr lang="en-US" sz="1400" u="none" strike="noStrike" baseline="30000" dirty="0">
                <a:solidFill>
                  <a:srgbClr val="000000"/>
                </a:solidFill>
                <a:effectLst/>
              </a:rPr>
              <a:t>2</a:t>
            </a:r>
            <a:r>
              <a:rPr lang="en-US" sz="1400" u="none" strike="noStrike" dirty="0">
                <a:solidFill>
                  <a:srgbClr val="000000"/>
                </a:solidFill>
                <a:effectLst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ues are</a:t>
            </a:r>
            <a:r>
              <a:rPr lang="en-US" sz="1400" dirty="0">
                <a:solidFill>
                  <a:srgbClr val="000000"/>
                </a:solidFill>
              </a:rPr>
              <a:t> underlined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71125399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D47C7E92-4099-9E51-7965-F3E9F345FE42}"/>
              </a:ext>
            </a:extLst>
          </p:cNvPr>
          <p:cNvSpPr txBox="1"/>
          <p:nvPr/>
        </p:nvSpPr>
        <p:spPr>
          <a:xfrm>
            <a:off x="410029" y="8777743"/>
            <a:ext cx="716824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6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enotypic correlations between the trait mean and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Levene’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tatistic (LS, canalization) for variation in six morphological traits in Indica accessions.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7505FB7-C87D-EA5F-EFAC-4444626E83A1}"/>
              </a:ext>
            </a:extLst>
          </p:cNvPr>
          <p:cNvGrpSpPr/>
          <p:nvPr/>
        </p:nvGrpSpPr>
        <p:grpSpPr>
          <a:xfrm>
            <a:off x="393011" y="217634"/>
            <a:ext cx="7196508" cy="8033129"/>
            <a:chOff x="393011" y="217634"/>
            <a:chExt cx="7196508" cy="8033129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4B4633BC-39B6-9B0A-FF39-6988DCBB8688}"/>
                </a:ext>
              </a:extLst>
            </p:cNvPr>
            <p:cNvGrpSpPr/>
            <p:nvPr/>
          </p:nvGrpSpPr>
          <p:grpSpPr>
            <a:xfrm>
              <a:off x="639232" y="217634"/>
              <a:ext cx="6950287" cy="7800297"/>
              <a:chOff x="639232" y="217634"/>
              <a:chExt cx="6950287" cy="7800297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6CAFE47C-0BF5-41C7-7F4A-704BB4EC1B9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555" b="4328"/>
              <a:stretch/>
            </p:blipFill>
            <p:spPr>
              <a:xfrm>
                <a:off x="639232" y="4622799"/>
                <a:ext cx="2123017" cy="3381743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17DB98E8-6F9E-DC1C-508E-50107360A6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555" b="4328"/>
              <a:stretch/>
            </p:blipFill>
            <p:spPr>
              <a:xfrm>
                <a:off x="2995082" y="4622801"/>
                <a:ext cx="2123018" cy="3381741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DD9D7BC4-2D6A-0F55-9F02-A73F850755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5744" b="3950"/>
              <a:stretch/>
            </p:blipFill>
            <p:spPr>
              <a:xfrm>
                <a:off x="2891366" y="889001"/>
                <a:ext cx="2118784" cy="3395132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C039D85F-4D7F-8193-0367-5A742B2C1E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6591" b="3950"/>
              <a:stretch/>
            </p:blipFill>
            <p:spPr>
              <a:xfrm>
                <a:off x="5266267" y="889001"/>
                <a:ext cx="2099732" cy="3395132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EC8E1ABF-7F83-AE86-F802-CCF769AFF64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5744" b="3950"/>
              <a:stretch/>
            </p:blipFill>
            <p:spPr>
              <a:xfrm>
                <a:off x="643466" y="889001"/>
                <a:ext cx="2118783" cy="3395132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1A5D1C22-D9C3-3A71-45B2-52C3BB8B6D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6591" b="3950"/>
              <a:stretch/>
            </p:blipFill>
            <p:spPr>
              <a:xfrm>
                <a:off x="5275678" y="4622799"/>
                <a:ext cx="2099732" cy="3395132"/>
              </a:xfrm>
              <a:prstGeom prst="rect">
                <a:avLst/>
              </a:prstGeom>
            </p:spPr>
          </p:pic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5E5A6237-EF9A-B93F-A5A3-85F19692A7F7}"/>
                  </a:ext>
                </a:extLst>
              </p:cNvPr>
              <p:cNvSpPr/>
              <p:nvPr/>
            </p:nvSpPr>
            <p:spPr>
              <a:xfrm>
                <a:off x="7193350" y="464757"/>
                <a:ext cx="102409" cy="106948"/>
              </a:xfrm>
              <a:prstGeom prst="rect">
                <a:avLst/>
              </a:prstGeom>
              <a:solidFill>
                <a:srgbClr val="F3B59D"/>
              </a:solidFill>
              <a:ln>
                <a:solidFill>
                  <a:srgbClr val="EF9D7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" name="Rectangle 2">
                <a:extLst>
                  <a:ext uri="{FF2B5EF4-FFF2-40B4-BE49-F238E27FC236}">
                    <a16:creationId xmlns:a16="http://schemas.microsoft.com/office/drawing/2014/main" id="{EF594DDE-575B-FCA7-50E8-2D854397A3D3}"/>
                  </a:ext>
                </a:extLst>
              </p:cNvPr>
              <p:cNvSpPr/>
              <p:nvPr/>
            </p:nvSpPr>
            <p:spPr>
              <a:xfrm>
                <a:off x="7196518" y="278730"/>
                <a:ext cx="99241" cy="104479"/>
              </a:xfrm>
              <a:prstGeom prst="rect">
                <a:avLst/>
              </a:prstGeom>
              <a:solidFill>
                <a:srgbClr val="7C9AF4"/>
              </a:solidFill>
              <a:ln>
                <a:solidFill>
                  <a:srgbClr val="5178EE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DC63FD2A-0CEE-070F-F2DB-C3B41AEDE798}"/>
                  </a:ext>
                </a:extLst>
              </p:cNvPr>
              <p:cNvSpPr txBox="1"/>
              <p:nvPr/>
            </p:nvSpPr>
            <p:spPr>
              <a:xfrm>
                <a:off x="7244553" y="217634"/>
                <a:ext cx="3449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et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4BD75DE7-591B-6117-677C-5F89F03C853B}"/>
                  </a:ext>
                </a:extLst>
              </p:cNvPr>
              <p:cNvSpPr txBox="1"/>
              <p:nvPr/>
            </p:nvSpPr>
            <p:spPr>
              <a:xfrm>
                <a:off x="7244554" y="410509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ry</a:t>
                </a: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0D43CBF-3AFC-9B23-FB09-70538A8287E5}"/>
                </a:ext>
              </a:extLst>
            </p:cNvPr>
            <p:cNvSpPr txBox="1"/>
            <p:nvPr/>
          </p:nvSpPr>
          <p:spPr>
            <a:xfrm rot="16200000">
              <a:off x="-366491" y="2533258"/>
              <a:ext cx="17652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shoot dry weight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81911D4-1DA9-56CE-191E-520ADDDC48CD}"/>
                </a:ext>
              </a:extLst>
            </p:cNvPr>
            <p:cNvSpPr txBox="1"/>
            <p:nvPr/>
          </p:nvSpPr>
          <p:spPr>
            <a:xfrm>
              <a:off x="1132696" y="4236079"/>
              <a:ext cx="11128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hoot dry weigh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1B5CE1E-027F-5500-B44D-A22E4276B966}"/>
                </a:ext>
              </a:extLst>
            </p:cNvPr>
            <p:cNvSpPr txBox="1"/>
            <p:nvPr/>
          </p:nvSpPr>
          <p:spPr>
            <a:xfrm>
              <a:off x="3584330" y="4236078"/>
              <a:ext cx="10567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anicle number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0647AFF-E07B-E957-66F2-47421777AF98}"/>
                </a:ext>
              </a:extLst>
            </p:cNvPr>
            <p:cNvSpPr txBox="1"/>
            <p:nvPr/>
          </p:nvSpPr>
          <p:spPr>
            <a:xfrm rot="16200000">
              <a:off x="1961664" y="2533260"/>
              <a:ext cx="17091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anicle number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CF58C26-8BAB-2DF1-E531-BE481E986A95}"/>
                </a:ext>
              </a:extLst>
            </p:cNvPr>
            <p:cNvSpPr txBox="1"/>
            <p:nvPr/>
          </p:nvSpPr>
          <p:spPr>
            <a:xfrm rot="16200000">
              <a:off x="4252353" y="2533259"/>
              <a:ext cx="17956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rachis dry weight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3F3E553-D9B4-36E4-72A5-C057BE6E7D09}"/>
                </a:ext>
              </a:extLst>
            </p:cNvPr>
            <p:cNvSpPr txBox="1"/>
            <p:nvPr/>
          </p:nvSpPr>
          <p:spPr>
            <a:xfrm>
              <a:off x="5753913" y="4236078"/>
              <a:ext cx="1143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achis dry weight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74BC9EB-889A-90DB-185E-7D2EF2D89EBD}"/>
                </a:ext>
              </a:extLst>
            </p:cNvPr>
            <p:cNvSpPr txBox="1"/>
            <p:nvPr/>
          </p:nvSpPr>
          <p:spPr>
            <a:xfrm>
              <a:off x="833735" y="8004542"/>
              <a:ext cx="17107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rimary panicle branching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5872647-DB04-FFEC-79C4-E8AC10E5B493}"/>
                </a:ext>
              </a:extLst>
            </p:cNvPr>
            <p:cNvSpPr txBox="1"/>
            <p:nvPr/>
          </p:nvSpPr>
          <p:spPr>
            <a:xfrm rot="16200000">
              <a:off x="-633392" y="6190559"/>
              <a:ext cx="22990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rimary panicle branching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D7AC38C-3D0F-4C14-11B2-7C2FF1A4824F}"/>
                </a:ext>
              </a:extLst>
            </p:cNvPr>
            <p:cNvSpPr txBox="1"/>
            <p:nvPr/>
          </p:nvSpPr>
          <p:spPr>
            <a:xfrm>
              <a:off x="3165954" y="7997353"/>
              <a:ext cx="18069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econdary panicle branching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8CB2168-5DFE-BED8-F311-88A1AD9B1AD3}"/>
                </a:ext>
              </a:extLst>
            </p:cNvPr>
            <p:cNvSpPr txBox="1"/>
            <p:nvPr/>
          </p:nvSpPr>
          <p:spPr>
            <a:xfrm>
              <a:off x="5773356" y="7994394"/>
              <a:ext cx="1085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pikelet number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7D8CD2D-2C03-2083-22D1-52C70D89C559}"/>
                </a:ext>
              </a:extLst>
            </p:cNvPr>
            <p:cNvSpPr txBox="1"/>
            <p:nvPr/>
          </p:nvSpPr>
          <p:spPr>
            <a:xfrm rot="16200000">
              <a:off x="1586562" y="6270709"/>
              <a:ext cx="24593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secondary panicle branching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49352AB-ECBD-65D1-CCEE-A316FC44B698}"/>
                </a:ext>
              </a:extLst>
            </p:cNvPr>
            <p:cNvSpPr txBox="1"/>
            <p:nvPr/>
          </p:nvSpPr>
          <p:spPr>
            <a:xfrm rot="16200000">
              <a:off x="4274169" y="6197254"/>
              <a:ext cx="17379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spikelet numbe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826937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58133A78-6215-B3EC-772B-4572D5C45146}"/>
              </a:ext>
            </a:extLst>
          </p:cNvPr>
          <p:cNvSpPr txBox="1"/>
          <p:nvPr/>
        </p:nvSpPr>
        <p:spPr>
          <a:xfrm>
            <a:off x="302079" y="9298443"/>
            <a:ext cx="716824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7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enotypic correlations between the trait mean and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Levene’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tatistic (LS, canalization) for variation in 11 morphological traits in Japonica accessions.</a:t>
            </a: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AA9D54E0-26DC-5DA1-6455-76EF6AD32285}"/>
              </a:ext>
            </a:extLst>
          </p:cNvPr>
          <p:cNvGrpSpPr/>
          <p:nvPr/>
        </p:nvGrpSpPr>
        <p:grpSpPr>
          <a:xfrm>
            <a:off x="344248" y="139291"/>
            <a:ext cx="7272388" cy="9109931"/>
            <a:chOff x="344248" y="139291"/>
            <a:chExt cx="7272388" cy="9109931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FC1AB3F4-A783-D422-FCB6-F93E43214A1E}"/>
                </a:ext>
              </a:extLst>
            </p:cNvPr>
            <p:cNvGrpSpPr/>
            <p:nvPr/>
          </p:nvGrpSpPr>
          <p:grpSpPr>
            <a:xfrm>
              <a:off x="557001" y="139291"/>
              <a:ext cx="7059635" cy="8927578"/>
              <a:chOff x="557001" y="139291"/>
              <a:chExt cx="7059635" cy="8927578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49FCB79F-B757-A88A-11AD-BB98A38FFA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015" b="3466"/>
              <a:stretch/>
            </p:blipFill>
            <p:spPr>
              <a:xfrm>
                <a:off x="4131639" y="6353767"/>
                <a:ext cx="1697677" cy="2713101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031D829F-4D40-BE31-53B9-B68433B1376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015" b="3466"/>
              <a:stretch/>
            </p:blipFill>
            <p:spPr>
              <a:xfrm>
                <a:off x="2344321" y="3409089"/>
                <a:ext cx="1697676" cy="2713103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CCEA8D50-4428-A786-8273-2928DFB1BEA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5015" b="3466"/>
              <a:stretch/>
            </p:blipFill>
            <p:spPr>
              <a:xfrm>
                <a:off x="5918960" y="464411"/>
                <a:ext cx="1697676" cy="2713102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5FAE03F4-9273-6EFC-9048-297D4122BA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5015" b="3466"/>
              <a:stretch/>
            </p:blipFill>
            <p:spPr>
              <a:xfrm>
                <a:off x="557003" y="3409089"/>
                <a:ext cx="1697676" cy="2713103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CEEF6B48-7CFC-64AB-1607-5BFAB4BD17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5016" b="3466"/>
              <a:stretch/>
            </p:blipFill>
            <p:spPr>
              <a:xfrm>
                <a:off x="557003" y="464411"/>
                <a:ext cx="1697676" cy="2713103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5C72E08F-06A7-296F-5EB7-96F14C84A7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5015" b="3466"/>
              <a:stretch/>
            </p:blipFill>
            <p:spPr>
              <a:xfrm>
                <a:off x="4131639" y="3409089"/>
                <a:ext cx="1697677" cy="2713102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C3BBED3E-16C9-3F0A-8D28-37308B31871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5015" b="3466"/>
              <a:stretch/>
            </p:blipFill>
            <p:spPr>
              <a:xfrm>
                <a:off x="4131642" y="464411"/>
                <a:ext cx="1697675" cy="2713102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15B357E6-E233-29D6-C324-3499CEF105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5015" b="3466"/>
              <a:stretch/>
            </p:blipFill>
            <p:spPr>
              <a:xfrm>
                <a:off x="2344320" y="6353765"/>
                <a:ext cx="1697676" cy="2713103"/>
              </a:xfrm>
              <a:prstGeom prst="rect">
                <a:avLst/>
              </a:prstGeom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1BF04711-D0E3-BF0C-9F0A-C17265E6DA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5016" r="-1" b="3466"/>
              <a:stretch/>
            </p:blipFill>
            <p:spPr>
              <a:xfrm>
                <a:off x="2344323" y="464411"/>
                <a:ext cx="1697676" cy="2713103"/>
              </a:xfrm>
              <a:prstGeom prst="rect">
                <a:avLst/>
              </a:prstGeom>
            </p:spPr>
          </p:pic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299C5450-BE46-FA03-E5A6-F4289873513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5015" b="3466"/>
              <a:stretch/>
            </p:blipFill>
            <p:spPr>
              <a:xfrm>
                <a:off x="5918958" y="3409089"/>
                <a:ext cx="1697677" cy="2713102"/>
              </a:xfrm>
              <a:prstGeom prst="rect">
                <a:avLst/>
              </a:prstGeom>
            </p:spPr>
          </p:pic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560B3B33-672E-FAA3-1FFF-4E3D208A0E2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5015" b="3466"/>
              <a:stretch/>
            </p:blipFill>
            <p:spPr>
              <a:xfrm>
                <a:off x="557001" y="6353766"/>
                <a:ext cx="1697676" cy="2713103"/>
              </a:xfrm>
              <a:prstGeom prst="rect">
                <a:avLst/>
              </a:prstGeom>
            </p:spPr>
          </p:pic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76804CD1-D0E1-D043-8C23-CED29073EE74}"/>
                  </a:ext>
                </a:extLst>
              </p:cNvPr>
              <p:cNvSpPr/>
              <p:nvPr/>
            </p:nvSpPr>
            <p:spPr>
              <a:xfrm>
                <a:off x="7220466" y="386414"/>
                <a:ext cx="102409" cy="106948"/>
              </a:xfrm>
              <a:prstGeom prst="rect">
                <a:avLst/>
              </a:prstGeom>
              <a:solidFill>
                <a:srgbClr val="F3B59D"/>
              </a:solidFill>
              <a:ln>
                <a:solidFill>
                  <a:srgbClr val="EF9D7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" name="Rectangle 2">
                <a:extLst>
                  <a:ext uri="{FF2B5EF4-FFF2-40B4-BE49-F238E27FC236}">
                    <a16:creationId xmlns:a16="http://schemas.microsoft.com/office/drawing/2014/main" id="{BCF74AF4-D9F2-7575-448A-F9F5043C06C1}"/>
                  </a:ext>
                </a:extLst>
              </p:cNvPr>
              <p:cNvSpPr/>
              <p:nvPr/>
            </p:nvSpPr>
            <p:spPr>
              <a:xfrm>
                <a:off x="7223634" y="200387"/>
                <a:ext cx="99241" cy="104479"/>
              </a:xfrm>
              <a:prstGeom prst="rect">
                <a:avLst/>
              </a:prstGeom>
              <a:solidFill>
                <a:srgbClr val="7C9AF4"/>
              </a:solidFill>
              <a:ln>
                <a:solidFill>
                  <a:srgbClr val="5178EE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A78D77BF-6C6F-CA53-767A-FCE877DAA606}"/>
                  </a:ext>
                </a:extLst>
              </p:cNvPr>
              <p:cNvSpPr txBox="1"/>
              <p:nvPr/>
            </p:nvSpPr>
            <p:spPr>
              <a:xfrm>
                <a:off x="7271669" y="139291"/>
                <a:ext cx="3449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et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552BD642-B5F3-ED79-6AE7-071F1409A49B}"/>
                  </a:ext>
                </a:extLst>
              </p:cNvPr>
              <p:cNvSpPr txBox="1"/>
              <p:nvPr/>
            </p:nvSpPr>
            <p:spPr>
              <a:xfrm>
                <a:off x="7271670" y="332166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ry</a:t>
                </a: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36CB4E1-742C-B927-20F0-8D5EF39FCA5E}"/>
                </a:ext>
              </a:extLst>
            </p:cNvPr>
            <p:cNvSpPr txBox="1"/>
            <p:nvPr/>
          </p:nvSpPr>
          <p:spPr>
            <a:xfrm>
              <a:off x="6150325" y="3132399"/>
              <a:ext cx="1226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anicle maturatio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C407AAF-2CDE-116D-CAE6-F259587CA271}"/>
                </a:ext>
              </a:extLst>
            </p:cNvPr>
            <p:cNvSpPr txBox="1"/>
            <p:nvPr/>
          </p:nvSpPr>
          <p:spPr>
            <a:xfrm>
              <a:off x="4438034" y="3132803"/>
              <a:ext cx="11128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hoot dry weigh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29930B5-4ED5-20A6-C9F6-77A1AE682214}"/>
                </a:ext>
              </a:extLst>
            </p:cNvPr>
            <p:cNvSpPr txBox="1"/>
            <p:nvPr/>
          </p:nvSpPr>
          <p:spPr>
            <a:xfrm>
              <a:off x="2774569" y="3132803"/>
              <a:ext cx="8883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tiller number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E3D3EF8-C604-78AE-0B63-3493020CBB2C}"/>
                </a:ext>
              </a:extLst>
            </p:cNvPr>
            <p:cNvSpPr txBox="1"/>
            <p:nvPr/>
          </p:nvSpPr>
          <p:spPr>
            <a:xfrm>
              <a:off x="1008766" y="3132803"/>
              <a:ext cx="8418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lant height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8BC8D9D-75DC-C42C-3621-22DCD36ED7F4}"/>
                </a:ext>
              </a:extLst>
            </p:cNvPr>
            <p:cNvSpPr txBox="1"/>
            <p:nvPr/>
          </p:nvSpPr>
          <p:spPr>
            <a:xfrm>
              <a:off x="901363" y="6067133"/>
              <a:ext cx="10567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anicle number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43B2445-63EC-4AD9-C46A-E5EC86E8EF9E}"/>
                </a:ext>
              </a:extLst>
            </p:cNvPr>
            <p:cNvSpPr txBox="1"/>
            <p:nvPr/>
          </p:nvSpPr>
          <p:spPr>
            <a:xfrm>
              <a:off x="2708091" y="6058323"/>
              <a:ext cx="9701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anicle length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C91763A-1FBD-F086-62F7-1A8F7C3B7911}"/>
                </a:ext>
              </a:extLst>
            </p:cNvPr>
            <p:cNvSpPr txBox="1"/>
            <p:nvPr/>
          </p:nvSpPr>
          <p:spPr>
            <a:xfrm>
              <a:off x="4422806" y="6067133"/>
              <a:ext cx="1143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achis dry weight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B78537D-534D-A16C-84B7-C975210D28AC}"/>
                </a:ext>
              </a:extLst>
            </p:cNvPr>
            <p:cNvSpPr txBox="1"/>
            <p:nvPr/>
          </p:nvSpPr>
          <p:spPr>
            <a:xfrm>
              <a:off x="5944493" y="6067132"/>
              <a:ext cx="16466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rimary panicle branching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11B38C8-4801-2B08-17B0-80C05E586CE4}"/>
                </a:ext>
              </a:extLst>
            </p:cNvPr>
            <p:cNvSpPr txBox="1"/>
            <p:nvPr/>
          </p:nvSpPr>
          <p:spPr>
            <a:xfrm>
              <a:off x="526261" y="9003001"/>
              <a:ext cx="18069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econdary panicle branching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4657312-5D62-BDC1-15B4-976F758A3401}"/>
                </a:ext>
              </a:extLst>
            </p:cNvPr>
            <p:cNvSpPr txBox="1"/>
            <p:nvPr/>
          </p:nvSpPr>
          <p:spPr>
            <a:xfrm>
              <a:off x="2675985" y="9003001"/>
              <a:ext cx="1085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pikelet number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4FA8756-9F2E-ABDB-27DE-A17BAD47FA1C}"/>
                </a:ext>
              </a:extLst>
            </p:cNvPr>
            <p:cNvSpPr txBox="1"/>
            <p:nvPr/>
          </p:nvSpPr>
          <p:spPr>
            <a:xfrm>
              <a:off x="4430821" y="9003001"/>
              <a:ext cx="11272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00-grain weight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A459793-5110-FA57-36A2-039D19134BB6}"/>
                </a:ext>
              </a:extLst>
            </p:cNvPr>
            <p:cNvSpPr txBox="1"/>
            <p:nvPr/>
          </p:nvSpPr>
          <p:spPr>
            <a:xfrm rot="16200000">
              <a:off x="-277603" y="1746549"/>
              <a:ext cx="14943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lant height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81C5619-9ECE-CB0E-E36A-6E974CF304A6}"/>
                </a:ext>
              </a:extLst>
            </p:cNvPr>
            <p:cNvSpPr txBox="1"/>
            <p:nvPr/>
          </p:nvSpPr>
          <p:spPr>
            <a:xfrm rot="16200000">
              <a:off x="1484275" y="1746548"/>
              <a:ext cx="15408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tiller number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BB42C9E-B121-8F4D-C3CC-65C6430D246D}"/>
                </a:ext>
              </a:extLst>
            </p:cNvPr>
            <p:cNvSpPr txBox="1"/>
            <p:nvPr/>
          </p:nvSpPr>
          <p:spPr>
            <a:xfrm rot="16200000">
              <a:off x="3157185" y="1751035"/>
              <a:ext cx="17652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shoot dry weight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E292399-3C25-1015-9E53-59B48250F0E7}"/>
                </a:ext>
              </a:extLst>
            </p:cNvPr>
            <p:cNvSpPr txBox="1"/>
            <p:nvPr/>
          </p:nvSpPr>
          <p:spPr>
            <a:xfrm rot="16200000">
              <a:off x="4889795" y="1746547"/>
              <a:ext cx="18790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anicle maturation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09CD911-6DE4-C38E-AB7F-AB1A06FCD3FA}"/>
                </a:ext>
              </a:extLst>
            </p:cNvPr>
            <p:cNvSpPr txBox="1"/>
            <p:nvPr/>
          </p:nvSpPr>
          <p:spPr>
            <a:xfrm rot="16200000">
              <a:off x="-387199" y="4642530"/>
              <a:ext cx="17091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anicle number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8F52E25-10D2-2817-5783-7A3A5CC0C9AD}"/>
                </a:ext>
              </a:extLst>
            </p:cNvPr>
            <p:cNvSpPr txBox="1"/>
            <p:nvPr/>
          </p:nvSpPr>
          <p:spPr>
            <a:xfrm rot="16200000">
              <a:off x="1443398" y="4642529"/>
              <a:ext cx="16225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anicle length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984468C-3C8A-3431-8EE1-67B1A266248C}"/>
                </a:ext>
              </a:extLst>
            </p:cNvPr>
            <p:cNvSpPr txBox="1"/>
            <p:nvPr/>
          </p:nvSpPr>
          <p:spPr>
            <a:xfrm rot="16200000">
              <a:off x="3141958" y="4642528"/>
              <a:ext cx="17956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rachis dry weight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924D282-91B3-14E2-A563-97B958B0E59F}"/>
                </a:ext>
              </a:extLst>
            </p:cNvPr>
            <p:cNvSpPr txBox="1"/>
            <p:nvPr/>
          </p:nvSpPr>
          <p:spPr>
            <a:xfrm rot="16200000">
              <a:off x="4671869" y="4644727"/>
              <a:ext cx="22990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primary panicle branching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0E95D69-1AFB-EAEE-67E1-5C93EFFB2E26}"/>
                </a:ext>
              </a:extLst>
            </p:cNvPr>
            <p:cNvSpPr txBox="1"/>
            <p:nvPr/>
          </p:nvSpPr>
          <p:spPr>
            <a:xfrm rot="16200000">
              <a:off x="-762305" y="7439486"/>
              <a:ext cx="24593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secondary panicle branching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BAD43C1-406E-550A-C01F-F3F1ABC5BBD2}"/>
                </a:ext>
              </a:extLst>
            </p:cNvPr>
            <p:cNvSpPr txBox="1"/>
            <p:nvPr/>
          </p:nvSpPr>
          <p:spPr>
            <a:xfrm rot="16200000">
              <a:off x="1385690" y="7439485"/>
              <a:ext cx="17379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spikelet number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8CA1581-0D7D-57D8-DADA-DDA14345E012}"/>
                </a:ext>
              </a:extLst>
            </p:cNvPr>
            <p:cNvSpPr txBox="1"/>
            <p:nvPr/>
          </p:nvSpPr>
          <p:spPr>
            <a:xfrm rot="16200000">
              <a:off x="3149973" y="7587206"/>
              <a:ext cx="17796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ariation in 100-grain weigh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9802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Median">
      <a:dk1>
        <a:sysClr val="windowText" lastClr="000000"/>
      </a:dk1>
      <a:lt1>
        <a:sysClr val="window" lastClr="FFFFFF"/>
      </a:lt1>
      <a:dk2>
        <a:srgbClr val="775F55"/>
      </a:dk2>
      <a:lt2>
        <a:srgbClr val="EBDDC3"/>
      </a:lt2>
      <a:accent1>
        <a:srgbClr val="94B6D2"/>
      </a:accent1>
      <a:accent2>
        <a:srgbClr val="DD8047"/>
      </a:accent2>
      <a:accent3>
        <a:srgbClr val="A5AB81"/>
      </a:accent3>
      <a:accent4>
        <a:srgbClr val="D8B25C"/>
      </a:accent4>
      <a:accent5>
        <a:srgbClr val="7BA79D"/>
      </a:accent5>
      <a:accent6>
        <a:srgbClr val="968C8C"/>
      </a:accent6>
      <a:hlink>
        <a:srgbClr val="F7B615"/>
      </a:hlink>
      <a:folHlink>
        <a:srgbClr val="704404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4027</TotalTime>
  <Words>1817</Words>
  <Application>Microsoft Macintosh PowerPoint</Application>
  <PresentationFormat>Custom</PresentationFormat>
  <Paragraphs>871</Paragraphs>
  <Slides>1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19" baseType="lpstr"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yn Dunivant</dc:creator>
  <cp:lastModifiedBy>Simon Cornelis Groen</cp:lastModifiedBy>
  <cp:revision>90</cp:revision>
  <dcterms:created xsi:type="dcterms:W3CDTF">2024-12-23T21:35:45Z</dcterms:created>
  <dcterms:modified xsi:type="dcterms:W3CDTF">2025-06-05T21:23:40Z</dcterms:modified>
</cp:coreProperties>
</file>